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66" r:id="rId5"/>
    <p:sldId id="273" r:id="rId6"/>
    <p:sldId id="267" r:id="rId7"/>
    <p:sldId id="274" r:id="rId8"/>
    <p:sldId id="268" r:id="rId9"/>
    <p:sldId id="275" r:id="rId10"/>
    <p:sldId id="269" r:id="rId11"/>
    <p:sldId id="276" r:id="rId12"/>
    <p:sldId id="270" r:id="rId13"/>
    <p:sldId id="277" r:id="rId14"/>
    <p:sldId id="271" r:id="rId15"/>
    <p:sldId id="272" r:id="rId16"/>
    <p:sldId id="278" r:id="rId1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Final version" id="{07053007-B4DE-4808-83C4-D2E6E0290330}">
          <p14:sldIdLst>
            <p14:sldId id="266"/>
            <p14:sldId id="273"/>
            <p14:sldId id="267"/>
            <p14:sldId id="274"/>
            <p14:sldId id="268"/>
            <p14:sldId id="275"/>
            <p14:sldId id="269"/>
            <p14:sldId id="276"/>
            <p14:sldId id="270"/>
            <p14:sldId id="277"/>
            <p14:sldId id="271"/>
            <p14:sldId id="272"/>
            <p14:sldId id="278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C05D16F-B2F9-4026-9A1E-DCB0B627E319}" v="99" dt="2024-11-06T04:05:31.09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061" autoAdjust="0"/>
    <p:restoredTop sz="92701" autoAdjust="0"/>
  </p:normalViewPr>
  <p:slideViewPr>
    <p:cSldViewPr snapToGrid="0">
      <p:cViewPr varScale="1">
        <p:scale>
          <a:sx n="48" d="100"/>
          <a:sy n="48" d="100"/>
        </p:scale>
        <p:origin x="2508" y="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presProps" Target="presProps.xml"/><Relationship Id="rId3" Type="http://schemas.openxmlformats.org/officeDocument/2006/relationships/customXml" Target="../customXml/item3.xml"/><Relationship Id="rId21" Type="http://schemas.openxmlformats.org/officeDocument/2006/relationships/tableStyles" Target="tableStyle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microsoft.com/office/2015/10/relationships/revisionInfo" Target="revisionInfo.xml"/><Relationship Id="rId10" Type="http://schemas.openxmlformats.org/officeDocument/2006/relationships/slide" Target="slides/slide6.xml"/><Relationship Id="rId19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to, Shigeaki" userId="9738649d-cd64-434d-883a-bc64ce9afd08" providerId="ADAL" clId="{3C05D16F-B2F9-4026-9A1E-DCB0B627E319}"/>
    <pc:docChg chg="undo redo custSel addSld delSld modSld addSection delSection modSection">
      <pc:chgData name="Ito, Shigeaki" userId="9738649d-cd64-434d-883a-bc64ce9afd08" providerId="ADAL" clId="{3C05D16F-B2F9-4026-9A1E-DCB0B627E319}" dt="2024-11-06T04:06:54.419" v="1304" actId="20577"/>
      <pc:docMkLst>
        <pc:docMk/>
      </pc:docMkLst>
      <pc:sldChg chg="addSp delSp modSp del mod">
        <pc:chgData name="Ito, Shigeaki" userId="9738649d-cd64-434d-883a-bc64ce9afd08" providerId="ADAL" clId="{3C05D16F-B2F9-4026-9A1E-DCB0B627E319}" dt="2024-07-18T00:28:10.409" v="894" actId="47"/>
        <pc:sldMkLst>
          <pc:docMk/>
          <pc:sldMk cId="3863971432" sldId="256"/>
        </pc:sldMkLst>
        <pc:spChg chg="add mod ord topLvl">
          <ac:chgData name="Ito, Shigeaki" userId="9738649d-cd64-434d-883a-bc64ce9afd08" providerId="ADAL" clId="{3C05D16F-B2F9-4026-9A1E-DCB0B627E319}" dt="2024-07-18T00:15:48.774" v="695" actId="167"/>
          <ac:spMkLst>
            <pc:docMk/>
            <pc:sldMk cId="3863971432" sldId="256"/>
            <ac:spMk id="2" creationId="{57A00B1C-203A-7DEC-D4E5-D2D1166D61A6}"/>
          </ac:spMkLst>
        </pc:spChg>
        <pc:spChg chg="add mod topLvl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3" creationId="{793DB7B0-7068-D5FB-1571-174D45C45D37}"/>
          </ac:spMkLst>
        </pc:spChg>
        <pc:spChg chg="add mod topLvl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4" creationId="{0A92D932-7D48-BE55-8A21-EED6A8189962}"/>
          </ac:spMkLst>
        </pc:spChg>
        <pc:spChg chg="add mod topLvl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7" creationId="{BEB175C1-21E4-FECB-6B14-BA4D0CA31A74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9" creationId="{27EFCB09-C833-88B0-4B75-0C86EB9AAB96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10" creationId="{D2EB6184-D599-AAC7-DF55-2206357EE3F2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11" creationId="{6157223A-B0E7-C8F5-0477-27E603240A7B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12" creationId="{78B9ED21-4D0C-015C-40F3-95A0F5F0E0F6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13" creationId="{8D691594-40F4-DDB9-853E-D9A2ABD85448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14" creationId="{3CAF6AFE-8581-2967-1962-1C32259C4AD6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16" creationId="{98635180-8CD3-C5D6-588A-EDE5FB5B1B7F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17" creationId="{3B568455-7A36-5654-B64F-E16F81A6E663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18" creationId="{01785C4E-3E55-B296-919E-F1E7D31B1B2C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19" creationId="{E41E20C2-1BFB-36A1-A3F9-72E9CBE0713C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20" creationId="{87D47A4D-4BB4-CACF-C85D-D8F0C059C266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21" creationId="{11DA3F6C-5209-B4A9-2A05-DE001BC720D8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22" creationId="{0348B714-600F-F876-FAD0-14D6C3A9A137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23" creationId="{291999D7-D7BD-979E-F203-5ED206AF9956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24" creationId="{626045F3-1D8F-1562-1AA8-86E195825940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25" creationId="{361A4319-787D-0E93-6914-C691291AFA5C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26" creationId="{F3B63E8F-BBAC-A0AD-8F49-3C912B242A93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27" creationId="{21DEA8BF-3614-85B3-7468-122C63202B36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28" creationId="{F4F15D73-31BF-80DA-21F7-60564EC15F30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29" creationId="{9B5A1CD5-BECB-EE50-9DE2-ED82DE97CB1A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30" creationId="{B2F079DD-3551-EAA7-8FDC-C5FF3C8F7C7C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31" creationId="{C92470EF-F7E3-D327-DDCF-FD9CD44A92F4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32" creationId="{A9690B50-1882-6B75-9BD8-61027276D819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33" creationId="{FC245659-BB5D-6274-0B6C-16C6B596CA00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34" creationId="{9677B809-6643-4D1B-E8DC-D73C20F69F98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35" creationId="{710C405D-6D89-15CB-6CA5-19CA5EDDCBDB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36" creationId="{2F205524-8B31-CECD-81A7-2E228759D75A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37" creationId="{E7E222A6-49FF-0AE8-DB2B-002B3832B901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38" creationId="{93EB8656-5D28-1075-9B1F-FC5B76ED4B0D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39" creationId="{D119CDC6-73D5-79B2-4DAA-DDDC4519FBB1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40" creationId="{B4A8A83A-81FA-BFB2-90B3-ED8196EC35F0}"/>
          </ac:spMkLst>
        </pc:spChg>
        <pc:spChg chg="mo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41" creationId="{0F843B8A-5582-50D0-5353-55F6E95EF34C}"/>
          </ac:spMkLst>
        </pc:spChg>
        <pc:spChg chg="add mod or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42" creationId="{80FA6C93-03AD-AEF3-59CC-7A84624F6BB6}"/>
          </ac:spMkLst>
        </pc:spChg>
        <pc:spChg chg="add mod ord">
          <ac:chgData name="Ito, Shigeaki" userId="9738649d-cd64-434d-883a-bc64ce9afd08" providerId="ADAL" clId="{3C05D16F-B2F9-4026-9A1E-DCB0B627E319}" dt="2024-07-18T00:15:45.947" v="694" actId="165"/>
          <ac:spMkLst>
            <pc:docMk/>
            <pc:sldMk cId="3863971432" sldId="256"/>
            <ac:spMk id="43" creationId="{A2F2E5F8-1E7A-DC06-794C-1E7252770ED3}"/>
          </ac:spMkLst>
        </pc:spChg>
        <pc:grpChg chg="add mod ord topLvl">
          <ac:chgData name="Ito, Shigeaki" userId="9738649d-cd64-434d-883a-bc64ce9afd08" providerId="ADAL" clId="{3C05D16F-B2F9-4026-9A1E-DCB0B627E319}" dt="2024-07-18T00:15:45.947" v="694" actId="165"/>
          <ac:grpSpMkLst>
            <pc:docMk/>
            <pc:sldMk cId="3863971432" sldId="256"/>
            <ac:grpSpMk id="8" creationId="{932F2925-3457-5383-B8C3-7E769933A72C}"/>
          </ac:grpSpMkLst>
        </pc:grpChg>
        <pc:grpChg chg="add mod topLvl">
          <ac:chgData name="Ito, Shigeaki" userId="9738649d-cd64-434d-883a-bc64ce9afd08" providerId="ADAL" clId="{3C05D16F-B2F9-4026-9A1E-DCB0B627E319}" dt="2024-07-18T00:15:45.947" v="694" actId="165"/>
          <ac:grpSpMkLst>
            <pc:docMk/>
            <pc:sldMk cId="3863971432" sldId="256"/>
            <ac:grpSpMk id="15" creationId="{7382B0F2-3E7C-DA0F-C3F9-D5E3E2EC9113}"/>
          </ac:grpSpMkLst>
        </pc:grpChg>
        <pc:grpChg chg="add mod ord topLvl">
          <ac:chgData name="Ito, Shigeaki" userId="9738649d-cd64-434d-883a-bc64ce9afd08" providerId="ADAL" clId="{3C05D16F-B2F9-4026-9A1E-DCB0B627E319}" dt="2024-07-18T00:15:45.947" v="694" actId="165"/>
          <ac:grpSpMkLst>
            <pc:docMk/>
            <pc:sldMk cId="3863971432" sldId="256"/>
            <ac:grpSpMk id="44" creationId="{8118FFDE-42F2-4062-681B-3833E3873DA1}"/>
          </ac:grpSpMkLst>
        </pc:grpChg>
        <pc:grpChg chg="add del mod ord">
          <ac:chgData name="Ito, Shigeaki" userId="9738649d-cd64-434d-883a-bc64ce9afd08" providerId="ADAL" clId="{3C05D16F-B2F9-4026-9A1E-DCB0B627E319}" dt="2024-07-18T00:15:45.947" v="694" actId="165"/>
          <ac:grpSpMkLst>
            <pc:docMk/>
            <pc:sldMk cId="3863971432" sldId="256"/>
            <ac:grpSpMk id="45" creationId="{FB2BD295-75EF-6BE0-89F7-58B45D212F0C}"/>
          </ac:grpSpMkLst>
        </pc:grpChg>
        <pc:picChg chg="del mod ord modCrop">
          <ac:chgData name="Ito, Shigeaki" userId="9738649d-cd64-434d-883a-bc64ce9afd08" providerId="ADAL" clId="{3C05D16F-B2F9-4026-9A1E-DCB0B627E319}" dt="2024-07-18T00:15:05.481" v="677" actId="478"/>
          <ac:picMkLst>
            <pc:docMk/>
            <pc:sldMk cId="3863971432" sldId="256"/>
            <ac:picMk id="5" creationId="{13865894-0166-0C63-1D28-B31D80BC59E1}"/>
          </ac:picMkLst>
        </pc:picChg>
        <pc:picChg chg="add mod ord">
          <ac:chgData name="Ito, Shigeaki" userId="9738649d-cd64-434d-883a-bc64ce9afd08" providerId="ADAL" clId="{3C05D16F-B2F9-4026-9A1E-DCB0B627E319}" dt="2024-07-18T00:16:06.180" v="719" actId="1038"/>
          <ac:picMkLst>
            <pc:docMk/>
            <pc:sldMk cId="3863971432" sldId="256"/>
            <ac:picMk id="47" creationId="{53EEE799-0782-6B65-48FA-72BF47EC6FDE}"/>
          </ac:picMkLst>
        </pc:picChg>
        <pc:cxnChg chg="add mod topLvl">
          <ac:chgData name="Ito, Shigeaki" userId="9738649d-cd64-434d-883a-bc64ce9afd08" providerId="ADAL" clId="{3C05D16F-B2F9-4026-9A1E-DCB0B627E319}" dt="2024-07-18T00:15:45.947" v="694" actId="165"/>
          <ac:cxnSpMkLst>
            <pc:docMk/>
            <pc:sldMk cId="3863971432" sldId="256"/>
            <ac:cxnSpMk id="6" creationId="{006FF18D-3253-87D4-5FDF-0118CFFCA0F4}"/>
          </ac:cxnSpMkLst>
        </pc:cxnChg>
      </pc:sldChg>
      <pc:sldChg chg="addSp modSp del mod">
        <pc:chgData name="Ito, Shigeaki" userId="9738649d-cd64-434d-883a-bc64ce9afd08" providerId="ADAL" clId="{3C05D16F-B2F9-4026-9A1E-DCB0B627E319}" dt="2024-07-18T00:25:49.767" v="858" actId="47"/>
        <pc:sldMkLst>
          <pc:docMk/>
          <pc:sldMk cId="2900185971" sldId="257"/>
        </pc:sldMkLst>
        <pc:spChg chg="add mod">
          <ac:chgData name="Ito, Shigeaki" userId="9738649d-cd64-434d-883a-bc64ce9afd08" providerId="ADAL" clId="{3C05D16F-B2F9-4026-9A1E-DCB0B627E319}" dt="2024-07-02T05:58:25.261" v="359" actId="14100"/>
          <ac:spMkLst>
            <pc:docMk/>
            <pc:sldMk cId="2900185971" sldId="257"/>
            <ac:spMk id="2" creationId="{B5333D1B-D6FC-1665-7C3A-8591555AF9CA}"/>
          </ac:spMkLst>
        </pc:spChg>
        <pc:spChg chg="add mod">
          <ac:chgData name="Ito, Shigeaki" userId="9738649d-cd64-434d-883a-bc64ce9afd08" providerId="ADAL" clId="{3C05D16F-B2F9-4026-9A1E-DCB0B627E319}" dt="2024-07-02T05:56:07.719" v="303" actId="1076"/>
          <ac:spMkLst>
            <pc:docMk/>
            <pc:sldMk cId="2900185971" sldId="257"/>
            <ac:spMk id="3" creationId="{E2090967-EF27-E4E5-DDCB-BB4CDB613C68}"/>
          </ac:spMkLst>
        </pc:spChg>
        <pc:spChg chg="add mod">
          <ac:chgData name="Ito, Shigeaki" userId="9738649d-cd64-434d-883a-bc64ce9afd08" providerId="ADAL" clId="{3C05D16F-B2F9-4026-9A1E-DCB0B627E319}" dt="2024-07-02T05:56:07.719" v="303" actId="1076"/>
          <ac:spMkLst>
            <pc:docMk/>
            <pc:sldMk cId="2900185971" sldId="257"/>
            <ac:spMk id="4" creationId="{3DE5BD88-9911-91A4-7168-D9DD20A190FD}"/>
          </ac:spMkLst>
        </pc:spChg>
        <pc:spChg chg="add mod">
          <ac:chgData name="Ito, Shigeaki" userId="9738649d-cd64-434d-883a-bc64ce9afd08" providerId="ADAL" clId="{3C05D16F-B2F9-4026-9A1E-DCB0B627E319}" dt="2024-07-02T05:56:07.719" v="303" actId="1076"/>
          <ac:spMkLst>
            <pc:docMk/>
            <pc:sldMk cId="2900185971" sldId="257"/>
            <ac:spMk id="7" creationId="{5521D731-C561-0E67-9791-C7D842DBAD20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9" creationId="{076F718F-A6A2-409E-35AD-599FE3AFC16F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10" creationId="{65886F48-113C-BE7E-C3AF-6B118F591B6E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11" creationId="{4A315906-B7CE-D466-9DDB-F277292A398A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12" creationId="{017BB2A0-2580-0924-BA74-7E29AC352818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13" creationId="{965B03ED-34D8-1A1E-3A4C-2013FA6973B9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14" creationId="{814835E1-2E0F-BE1E-3C28-0EA45AE2456B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15" creationId="{4A201BBB-2E85-5F38-5032-784264706DE5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16" creationId="{DEB10141-6E8D-E376-45FA-03F877DE457E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17" creationId="{7B5B5CED-C558-CB08-E787-AD14A38B1BD5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18" creationId="{50393AD2-221A-177E-A0AA-84B8A81B9CAF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19" creationId="{40E3E7F6-F1F3-D299-8B6B-6FDDB64D9AFF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20" creationId="{8F488A0A-5DDB-C2C7-C298-3E097948EAFE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21" creationId="{34130855-A85E-9105-C68A-A077AA138DE3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22" creationId="{38D4A292-796A-B688-F56E-50A4F3C69C84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23" creationId="{03071F6E-C65D-1B2D-673C-5C3F0B9C12FB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24" creationId="{3C701963-7476-799B-BCD6-7824E45BC137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25" creationId="{FA4CC251-9B9E-3AEA-59EA-688096C81A86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26" creationId="{C3A61778-8121-713E-434E-0A60A9FC73AF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27" creationId="{B99E55DA-D40A-4DE7-B4EF-A11A85A7BD0A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28" creationId="{6D06720E-4F07-47B0-43C3-58EFD0AEF7D0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29" creationId="{E4E28FCA-A548-6F16-944B-304A3EFC3CB6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30" creationId="{484454FB-EE37-6CDA-2FDE-8BD79232AF35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31" creationId="{9954F097-A499-9B11-BA0D-E94660FE50F7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32" creationId="{FB07EE8C-EF2C-7C06-075F-E83275D13A1D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33" creationId="{9C4A0A1F-6F16-8A8D-E5FE-189352C1CD41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34" creationId="{A3D6A565-BD18-329A-CDE0-BCB4FD65107E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36" creationId="{A0ADCD88-0923-698C-2C35-B667AAF91FE7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37" creationId="{263AF6DE-D392-9BD9-96F3-4B69ADCDA5E0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39" creationId="{C7C50CCE-6661-C35E-28C2-F0B86E196ED4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40" creationId="{E125925D-F9A1-B5DE-128A-03D1A2A02A19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41" creationId="{330021A4-86F4-542A-6558-519793DFEDE8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42" creationId="{AA894B30-F3B5-E7FC-2F1E-AA955E3EB7EF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43" creationId="{F7ED43A2-5E5B-3316-B3E3-4B1E89A3B72D}"/>
          </ac:spMkLst>
        </pc:spChg>
        <pc:spChg chg="mod">
          <ac:chgData name="Ito, Shigeaki" userId="9738649d-cd64-434d-883a-bc64ce9afd08" providerId="ADAL" clId="{3C05D16F-B2F9-4026-9A1E-DCB0B627E319}" dt="2024-07-02T05:56:06.393" v="302"/>
          <ac:spMkLst>
            <pc:docMk/>
            <pc:sldMk cId="2900185971" sldId="257"/>
            <ac:spMk id="44" creationId="{6D09537D-9A43-1EB6-98A9-135A878E9D36}"/>
          </ac:spMkLst>
        </pc:spChg>
        <pc:grpChg chg="add mod">
          <ac:chgData name="Ito, Shigeaki" userId="9738649d-cd64-434d-883a-bc64ce9afd08" providerId="ADAL" clId="{3C05D16F-B2F9-4026-9A1E-DCB0B627E319}" dt="2024-07-02T05:57:09.094" v="318" actId="1038"/>
          <ac:grpSpMkLst>
            <pc:docMk/>
            <pc:sldMk cId="2900185971" sldId="257"/>
            <ac:grpSpMk id="8" creationId="{FBE474C4-D8B3-367C-4330-A9CD3A4854B9}"/>
          </ac:grpSpMkLst>
        </pc:grpChg>
        <pc:grpChg chg="add mod ord">
          <ac:chgData name="Ito, Shigeaki" userId="9738649d-cd64-434d-883a-bc64ce9afd08" providerId="ADAL" clId="{3C05D16F-B2F9-4026-9A1E-DCB0B627E319}" dt="2024-07-02T05:57:26.514" v="323" actId="1037"/>
          <ac:grpSpMkLst>
            <pc:docMk/>
            <pc:sldMk cId="2900185971" sldId="257"/>
            <ac:grpSpMk id="35" creationId="{53087591-8355-1130-3B16-55FC11086AAC}"/>
          </ac:grpSpMkLst>
        </pc:grpChg>
        <pc:grpChg chg="add mod ord">
          <ac:chgData name="Ito, Shigeaki" userId="9738649d-cd64-434d-883a-bc64ce9afd08" providerId="ADAL" clId="{3C05D16F-B2F9-4026-9A1E-DCB0B627E319}" dt="2024-07-02T05:58:15.067" v="358" actId="1035"/>
          <ac:grpSpMkLst>
            <pc:docMk/>
            <pc:sldMk cId="2900185971" sldId="257"/>
            <ac:grpSpMk id="38" creationId="{8AB5ACFF-FCEA-67B0-44BD-F46F500A1D10}"/>
          </ac:grpSpMkLst>
        </pc:grpChg>
        <pc:picChg chg="mod ord modCrop">
          <ac:chgData name="Ito, Shigeaki" userId="9738649d-cd64-434d-883a-bc64ce9afd08" providerId="ADAL" clId="{3C05D16F-B2F9-4026-9A1E-DCB0B627E319}" dt="2024-07-02T05:57:22.208" v="319" actId="1076"/>
          <ac:picMkLst>
            <pc:docMk/>
            <pc:sldMk cId="2900185971" sldId="257"/>
            <ac:picMk id="5" creationId="{7F82E4CB-4E3C-1711-1A3F-C7D44EB8ECCE}"/>
          </ac:picMkLst>
        </pc:picChg>
        <pc:cxnChg chg="add mod">
          <ac:chgData name="Ito, Shigeaki" userId="9738649d-cd64-434d-883a-bc64ce9afd08" providerId="ADAL" clId="{3C05D16F-B2F9-4026-9A1E-DCB0B627E319}" dt="2024-07-02T05:56:07.719" v="303" actId="1076"/>
          <ac:cxnSpMkLst>
            <pc:docMk/>
            <pc:sldMk cId="2900185971" sldId="257"/>
            <ac:cxnSpMk id="6" creationId="{5F367FD6-C36C-3A8C-F168-5C464341A137}"/>
          </ac:cxnSpMkLst>
        </pc:cxnChg>
      </pc:sldChg>
      <pc:sldChg chg="addSp modSp del mod">
        <pc:chgData name="Ito, Shigeaki" userId="9738649d-cd64-434d-883a-bc64ce9afd08" providerId="ADAL" clId="{3C05D16F-B2F9-4026-9A1E-DCB0B627E319}" dt="2024-07-18T00:25:49.767" v="858" actId="47"/>
        <pc:sldMkLst>
          <pc:docMk/>
          <pc:sldMk cId="1426959066" sldId="258"/>
        </pc:sldMkLst>
        <pc:spChg chg="add mod">
          <ac:chgData name="Ito, Shigeaki" userId="9738649d-cd64-434d-883a-bc64ce9afd08" providerId="ADAL" clId="{3C05D16F-B2F9-4026-9A1E-DCB0B627E319}" dt="2024-07-02T06:13:42.261" v="373" actId="1076"/>
          <ac:spMkLst>
            <pc:docMk/>
            <pc:sldMk cId="1426959066" sldId="258"/>
            <ac:spMk id="2" creationId="{0F60697A-CDE3-CA26-1E1F-3EF0FBA2C214}"/>
          </ac:spMkLst>
        </pc:spChg>
        <pc:spChg chg="add mod">
          <ac:chgData name="Ito, Shigeaki" userId="9738649d-cd64-434d-883a-bc64ce9afd08" providerId="ADAL" clId="{3C05D16F-B2F9-4026-9A1E-DCB0B627E319}" dt="2024-07-02T06:13:42.261" v="373" actId="1076"/>
          <ac:spMkLst>
            <pc:docMk/>
            <pc:sldMk cId="1426959066" sldId="258"/>
            <ac:spMk id="3" creationId="{94C43F1C-E08A-D54D-E77C-478E494ED76A}"/>
          </ac:spMkLst>
        </pc:spChg>
        <pc:spChg chg="add mod">
          <ac:chgData name="Ito, Shigeaki" userId="9738649d-cd64-434d-883a-bc64ce9afd08" providerId="ADAL" clId="{3C05D16F-B2F9-4026-9A1E-DCB0B627E319}" dt="2024-07-02T06:13:42.261" v="373" actId="1076"/>
          <ac:spMkLst>
            <pc:docMk/>
            <pc:sldMk cId="1426959066" sldId="258"/>
            <ac:spMk id="4" creationId="{39F8861F-5822-DD19-6407-3AB34EE20025}"/>
          </ac:spMkLst>
        </pc:spChg>
        <pc:spChg chg="add mod">
          <ac:chgData name="Ito, Shigeaki" userId="9738649d-cd64-434d-883a-bc64ce9afd08" providerId="ADAL" clId="{3C05D16F-B2F9-4026-9A1E-DCB0B627E319}" dt="2024-07-02T06:14:52.221" v="395" actId="1037"/>
          <ac:spMkLst>
            <pc:docMk/>
            <pc:sldMk cId="1426959066" sldId="258"/>
            <ac:spMk id="7" creationId="{C4BE2FA3-EFCA-8576-FE47-885C56CCB4BA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9" creationId="{4B205154-3B59-D8B2-722B-2669CBEF23C3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10" creationId="{BFA8B7E5-48FA-4DCD-A8BD-A882DAA764D0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11" creationId="{42785F28-671B-7C31-7EC2-3AC64476E15D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12" creationId="{DB6D9719-5697-57DE-62AD-45F9ED56E548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13" creationId="{9AC46534-7013-36B9-3017-4986B36CA2BD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14" creationId="{C32A10ED-39FA-E08D-ED78-C23064989DE5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15" creationId="{DCF2B0FE-5BFD-4A2E-23E7-7E77FA5BD608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16" creationId="{8B75F347-9C12-8A41-333D-EBB8926CD47E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17" creationId="{AA54C6C1-28DB-AF9C-3528-55137F14AB98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18" creationId="{5116BC73-F07C-6534-1199-4664961E1B45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19" creationId="{420D1F6D-3564-B3D5-6AF7-6B7FFDB07653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20" creationId="{5B856FF9-D193-132E-4DC5-4AD4CBED7369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21" creationId="{867FFBB6-AD97-575D-2F11-9BFAF680399D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22" creationId="{0437AB46-3820-97EA-AC27-81B6BDFC47A0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23" creationId="{AB33816A-3958-29DC-0472-3FD616E221B2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24" creationId="{D332358B-4E6E-914B-DD19-7307818523C3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25" creationId="{7DB5C76E-11FD-41B7-12EF-49456E820454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26" creationId="{EA0C61B5-92C0-0670-978A-4EDD57E7D5DA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27" creationId="{C6D32179-BA38-26B9-3D27-2D4F3FE28BF7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28" creationId="{17F27D5C-321A-FF55-9F4B-F005141F0EA7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29" creationId="{26B905EB-CD23-FBFB-677C-04C22CFFDBD3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30" creationId="{E28D5BAF-9337-7A6E-486B-41BB5F77AEBE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31" creationId="{3FCEFE29-4B92-D2B0-DE29-7FAB10D0A624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32" creationId="{C196ACDF-9E79-3D72-BECF-71E869E87F08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33" creationId="{3BF1347C-C651-63D4-8EA0-80E0D008D8CF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34" creationId="{83E4995C-FC01-4D8E-FDCF-77D753FCC7C1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36" creationId="{9EF226C8-61EA-FA83-7EDD-673B16E760AD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37" creationId="{21C042A6-C089-1244-30B8-F18AD69961E7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39" creationId="{F0EB964E-1C13-60FF-E250-D82114313956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40" creationId="{BB1C9CF2-284E-ABEB-CC79-C2AA6ED13E0B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41" creationId="{789980E9-FACF-36CD-26DD-B152EDF38523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42" creationId="{D6158891-6A12-59F4-9051-FF033791AA13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43" creationId="{DB52803D-A918-AD41-9F43-38C6A4174267}"/>
          </ac:spMkLst>
        </pc:spChg>
        <pc:spChg chg="mod">
          <ac:chgData name="Ito, Shigeaki" userId="9738649d-cd64-434d-883a-bc64ce9afd08" providerId="ADAL" clId="{3C05D16F-B2F9-4026-9A1E-DCB0B627E319}" dt="2024-07-02T06:13:40.633" v="372"/>
          <ac:spMkLst>
            <pc:docMk/>
            <pc:sldMk cId="1426959066" sldId="258"/>
            <ac:spMk id="44" creationId="{ABDDC327-5535-07F7-A05B-35DAEA315F1C}"/>
          </ac:spMkLst>
        </pc:spChg>
        <pc:grpChg chg="add mod">
          <ac:chgData name="Ito, Shigeaki" userId="9738649d-cd64-434d-883a-bc64ce9afd08" providerId="ADAL" clId="{3C05D16F-B2F9-4026-9A1E-DCB0B627E319}" dt="2024-07-02T06:13:42.261" v="373" actId="1076"/>
          <ac:grpSpMkLst>
            <pc:docMk/>
            <pc:sldMk cId="1426959066" sldId="258"/>
            <ac:grpSpMk id="8" creationId="{F8816CA7-41A2-5459-8EB5-42E80CB4D6C3}"/>
          </ac:grpSpMkLst>
        </pc:grpChg>
        <pc:grpChg chg="add mod ord">
          <ac:chgData name="Ito, Shigeaki" userId="9738649d-cd64-434d-883a-bc64ce9afd08" providerId="ADAL" clId="{3C05D16F-B2F9-4026-9A1E-DCB0B627E319}" dt="2024-07-02T06:14:14.458" v="381" actId="166"/>
          <ac:grpSpMkLst>
            <pc:docMk/>
            <pc:sldMk cId="1426959066" sldId="258"/>
            <ac:grpSpMk id="35" creationId="{6E43CB73-5DDE-96D8-8495-0CA90419B674}"/>
          </ac:grpSpMkLst>
        </pc:grpChg>
        <pc:grpChg chg="add mod ord">
          <ac:chgData name="Ito, Shigeaki" userId="9738649d-cd64-434d-883a-bc64ce9afd08" providerId="ADAL" clId="{3C05D16F-B2F9-4026-9A1E-DCB0B627E319}" dt="2024-07-02T06:14:58.389" v="397" actId="1035"/>
          <ac:grpSpMkLst>
            <pc:docMk/>
            <pc:sldMk cId="1426959066" sldId="258"/>
            <ac:grpSpMk id="38" creationId="{5067DC20-7028-FBE2-FB9D-9EFDA4B16FA0}"/>
          </ac:grpSpMkLst>
        </pc:grpChg>
        <pc:picChg chg="mod ord modCrop">
          <ac:chgData name="Ito, Shigeaki" userId="9738649d-cd64-434d-883a-bc64ce9afd08" providerId="ADAL" clId="{3C05D16F-B2F9-4026-9A1E-DCB0B627E319}" dt="2024-07-02T06:14:39.015" v="389" actId="1035"/>
          <ac:picMkLst>
            <pc:docMk/>
            <pc:sldMk cId="1426959066" sldId="258"/>
            <ac:picMk id="5" creationId="{A9EF7216-0B5E-7A42-880D-8C3E19F99247}"/>
          </ac:picMkLst>
        </pc:picChg>
        <pc:cxnChg chg="add mod">
          <ac:chgData name="Ito, Shigeaki" userId="9738649d-cd64-434d-883a-bc64ce9afd08" providerId="ADAL" clId="{3C05D16F-B2F9-4026-9A1E-DCB0B627E319}" dt="2024-07-02T06:14:52.221" v="395" actId="1037"/>
          <ac:cxnSpMkLst>
            <pc:docMk/>
            <pc:sldMk cId="1426959066" sldId="258"/>
            <ac:cxnSpMk id="6" creationId="{1F7778AE-946A-3992-850B-E8A917364146}"/>
          </ac:cxnSpMkLst>
        </pc:cxnChg>
      </pc:sldChg>
      <pc:sldChg chg="addSp delSp modSp del mod">
        <pc:chgData name="Ito, Shigeaki" userId="9738649d-cd64-434d-883a-bc64ce9afd08" providerId="ADAL" clId="{3C05D16F-B2F9-4026-9A1E-DCB0B627E319}" dt="2024-07-18T00:28:10.409" v="894" actId="47"/>
        <pc:sldMkLst>
          <pc:docMk/>
          <pc:sldMk cId="3858252683" sldId="259"/>
        </pc:sldMkLst>
        <pc:spChg chg="add mod ord">
          <ac:chgData name="Ito, Shigeaki" userId="9738649d-cd64-434d-883a-bc64ce9afd08" providerId="ADAL" clId="{3C05D16F-B2F9-4026-9A1E-DCB0B627E319}" dt="2024-07-18T00:24:24.622" v="838" actId="167"/>
          <ac:spMkLst>
            <pc:docMk/>
            <pc:sldMk cId="3858252683" sldId="259"/>
            <ac:spMk id="2" creationId="{FEDF1310-38BC-6A57-4DB1-E70BB8BC2245}"/>
          </ac:spMkLst>
        </pc:spChg>
        <pc:spChg chg="mod">
          <ac:chgData name="Ito, Shigeaki" userId="9738649d-cd64-434d-883a-bc64ce9afd08" providerId="ADAL" clId="{3C05D16F-B2F9-4026-9A1E-DCB0B627E319}" dt="2024-07-02T06:38:41.567" v="472"/>
          <ac:spMkLst>
            <pc:docMk/>
            <pc:sldMk cId="3858252683" sldId="259"/>
            <ac:spMk id="4" creationId="{F0D72B2D-C5CA-CC2F-A4BF-239BF971B859}"/>
          </ac:spMkLst>
        </pc:spChg>
        <pc:spChg chg="mod">
          <ac:chgData name="Ito, Shigeaki" userId="9738649d-cd64-434d-883a-bc64ce9afd08" providerId="ADAL" clId="{3C05D16F-B2F9-4026-9A1E-DCB0B627E319}" dt="2024-07-02T06:38:41.567" v="472"/>
          <ac:spMkLst>
            <pc:docMk/>
            <pc:sldMk cId="3858252683" sldId="259"/>
            <ac:spMk id="6" creationId="{58CEADAD-D15D-8763-F4FB-BF5429923064}"/>
          </ac:spMkLst>
        </pc:spChg>
        <pc:spChg chg="mod">
          <ac:chgData name="Ito, Shigeaki" userId="9738649d-cd64-434d-883a-bc64ce9afd08" providerId="ADAL" clId="{3C05D16F-B2F9-4026-9A1E-DCB0B627E319}" dt="2024-07-02T06:38:41.567" v="472"/>
          <ac:spMkLst>
            <pc:docMk/>
            <pc:sldMk cId="3858252683" sldId="259"/>
            <ac:spMk id="7" creationId="{57FEE356-44EA-2615-1ACA-FAF01A2BD266}"/>
          </ac:spMkLst>
        </pc:spChg>
        <pc:spChg chg="mod">
          <ac:chgData name="Ito, Shigeaki" userId="9738649d-cd64-434d-883a-bc64ce9afd08" providerId="ADAL" clId="{3C05D16F-B2F9-4026-9A1E-DCB0B627E319}" dt="2024-07-02T06:38:41.567" v="472"/>
          <ac:spMkLst>
            <pc:docMk/>
            <pc:sldMk cId="3858252683" sldId="259"/>
            <ac:spMk id="8" creationId="{452D47E4-1FB3-B63B-20D4-EF98EA48A235}"/>
          </ac:spMkLst>
        </pc:spChg>
        <pc:spChg chg="add mod">
          <ac:chgData name="Ito, Shigeaki" userId="9738649d-cd64-434d-883a-bc64ce9afd08" providerId="ADAL" clId="{3C05D16F-B2F9-4026-9A1E-DCB0B627E319}" dt="2024-07-02T06:38:43.722" v="473" actId="1076"/>
          <ac:spMkLst>
            <pc:docMk/>
            <pc:sldMk cId="3858252683" sldId="259"/>
            <ac:spMk id="9" creationId="{39F16020-3085-84FA-4431-2C9BB7AF8E26}"/>
          </ac:spMkLst>
        </pc:spChg>
        <pc:spChg chg="add mod">
          <ac:chgData name="Ito, Shigeaki" userId="9738649d-cd64-434d-883a-bc64ce9afd08" providerId="ADAL" clId="{3C05D16F-B2F9-4026-9A1E-DCB0B627E319}" dt="2024-07-02T06:38:43.722" v="473" actId="1076"/>
          <ac:spMkLst>
            <pc:docMk/>
            <pc:sldMk cId="3858252683" sldId="259"/>
            <ac:spMk id="10" creationId="{F2B06420-8B95-43D1-DA48-16E81D234AFE}"/>
          </ac:spMkLst>
        </pc:spChg>
        <pc:grpChg chg="add mod">
          <ac:chgData name="Ito, Shigeaki" userId="9738649d-cd64-434d-883a-bc64ce9afd08" providerId="ADAL" clId="{3C05D16F-B2F9-4026-9A1E-DCB0B627E319}" dt="2024-07-02T06:38:43.722" v="473" actId="1076"/>
          <ac:grpSpMkLst>
            <pc:docMk/>
            <pc:sldMk cId="3858252683" sldId="259"/>
            <ac:grpSpMk id="3" creationId="{CFCE2D2B-AA72-E502-117B-141EE3429052}"/>
          </ac:grpSpMkLst>
        </pc:grpChg>
        <pc:picChg chg="del mod modCrop">
          <ac:chgData name="Ito, Shigeaki" userId="9738649d-cd64-434d-883a-bc64ce9afd08" providerId="ADAL" clId="{3C05D16F-B2F9-4026-9A1E-DCB0B627E319}" dt="2024-07-18T00:24:07.152" v="832" actId="478"/>
          <ac:picMkLst>
            <pc:docMk/>
            <pc:sldMk cId="3858252683" sldId="259"/>
            <ac:picMk id="5" creationId="{84EDBD26-D8D1-ED82-B686-BF8DB15B6986}"/>
          </ac:picMkLst>
        </pc:picChg>
        <pc:picChg chg="add mod ord">
          <ac:chgData name="Ito, Shigeaki" userId="9738649d-cd64-434d-883a-bc64ce9afd08" providerId="ADAL" clId="{3C05D16F-B2F9-4026-9A1E-DCB0B627E319}" dt="2024-07-18T00:24:21.493" v="837" actId="167"/>
          <ac:picMkLst>
            <pc:docMk/>
            <pc:sldMk cId="3858252683" sldId="259"/>
            <ac:picMk id="12" creationId="{985D9AB6-F4E0-C35C-CB54-5ABB37953568}"/>
          </ac:picMkLst>
        </pc:picChg>
      </pc:sldChg>
      <pc:sldChg chg="addSp delSp modSp del mod">
        <pc:chgData name="Ito, Shigeaki" userId="9738649d-cd64-434d-883a-bc64ce9afd08" providerId="ADAL" clId="{3C05D16F-B2F9-4026-9A1E-DCB0B627E319}" dt="2024-07-18T00:28:10.409" v="894" actId="47"/>
        <pc:sldMkLst>
          <pc:docMk/>
          <pc:sldMk cId="4270924471" sldId="260"/>
        </pc:sldMkLst>
        <pc:spChg chg="add mod or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2" creationId="{594AAC99-39E7-AC73-3D78-26DA9BEB91D4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3" creationId="{40CDADFF-D965-B66B-3DAF-B1A8E4BA9594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4" creationId="{087D2DAE-F33F-32C2-6929-7382820CCF46}"/>
          </ac:spMkLst>
        </pc:spChg>
        <pc:spChg chg="add mod or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6" creationId="{885FF6DB-E7C6-F20F-BD00-8EAD72A3BD54}"/>
          </ac:spMkLst>
        </pc:spChg>
        <pc:spChg chg="add mod or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7" creationId="{9515E9E9-D6F2-6BE4-4CCC-1EE890346813}"/>
          </ac:spMkLst>
        </pc:spChg>
        <pc:spChg chg="add mod or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8" creationId="{D3EFAFF6-3066-4079-7EBE-E8C64B27A8E2}"/>
          </ac:spMkLst>
        </pc:spChg>
        <pc:spChg chg="add mod or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9" creationId="{41DE1963-2C33-5F22-44A9-F092BDCDE838}"/>
          </ac:spMkLst>
        </pc:spChg>
        <pc:spChg chg="add mod or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10" creationId="{A0FF20D1-D001-2359-2DD1-2964FA4B9F03}"/>
          </ac:spMkLst>
        </pc:spChg>
        <pc:spChg chg="add mod or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11" creationId="{8302E6BE-ABF5-FC54-3B5E-FBF1461098C7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13" creationId="{CEA87B55-5C0E-D3BA-3EF9-363BF74FACB3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14" creationId="{9F092A93-DB7A-0921-1D75-E11A413F4EF2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15" creationId="{F7E3FCEE-2B30-A6F7-EF31-D5EF268BD659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16" creationId="{0DC0A1E5-959E-47B9-115E-666CCA6912A0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17" creationId="{97F561AE-420C-3EA2-F4BA-D4106354CEA6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18" creationId="{C5AD86FA-8959-9762-5974-D6D496150C7C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19" creationId="{91084067-EDA5-2E2B-2ED1-18618AC78D81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20" creationId="{43A85167-770F-275E-1887-E838547CA2E3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21" creationId="{7FDADBDF-032E-B6CF-8652-BC4C0E8D5A18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22" creationId="{B49215DF-53CE-BF54-D71A-5977D0F135BB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23" creationId="{9852ED6C-549D-342F-E684-1B96356583F6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24" creationId="{839F2DA0-0146-D3C6-A6F1-C966FAAACFF7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25" creationId="{F74E62F5-CACE-CC96-D439-A6FC8EDFF9EA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26" creationId="{CF40DA1C-A765-F4D4-A93E-582548E9BACB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27" creationId="{1298AE22-B86F-23EB-5A73-F7FDCBFB20F8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28" creationId="{D47777D0-5A10-AEF5-57F4-A0C672ABFADC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29" creationId="{0A4781F6-DD51-5142-1015-A39460444E34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30" creationId="{01B95ED7-39E6-9A9C-6E98-DD19E17C72C5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31" creationId="{EF97B577-3D36-4F6F-620C-4FEA0ADFC438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32" creationId="{C7D5A19F-B872-043F-B2D1-1C5006837281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33" creationId="{E73E8206-4F64-6952-8BED-5CF38899789A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34" creationId="{D93C6022-5E9E-01BB-D8B7-2783EDE56348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35" creationId="{03372B06-1273-A809-F451-1E04461670D7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36" creationId="{DD82052B-6FBD-B0AF-881D-F67B330E3701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37" creationId="{0F6DFC0B-388A-7B4C-439B-BDDB4B78A7BE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38" creationId="{DC7683C2-BB11-D4FB-587A-652590393A6D}"/>
          </ac:spMkLst>
        </pc:spChg>
        <pc:spChg chg="add mod topLvl">
          <ac:chgData name="Ito, Shigeaki" userId="9738649d-cd64-434d-883a-bc64ce9afd08" providerId="ADAL" clId="{3C05D16F-B2F9-4026-9A1E-DCB0B627E319}" dt="2024-07-02T05:41:01.095" v="186" actId="165"/>
          <ac:spMkLst>
            <pc:docMk/>
            <pc:sldMk cId="4270924471" sldId="260"/>
            <ac:spMk id="39" creationId="{33255C2A-0001-B37C-5C97-7CE463A340EB}"/>
          </ac:spMkLst>
        </pc:spChg>
        <pc:spChg chg="add mod ord topLvl">
          <ac:chgData name="Ito, Shigeaki" userId="9738649d-cd64-434d-883a-bc64ce9afd08" providerId="ADAL" clId="{3C05D16F-B2F9-4026-9A1E-DCB0B627E319}" dt="2024-07-18T00:17:36.287" v="733" actId="164"/>
          <ac:spMkLst>
            <pc:docMk/>
            <pc:sldMk cId="4270924471" sldId="260"/>
            <ac:spMk id="40" creationId="{44815674-4B0F-FF4D-2C29-CEA0ECCA0D8C}"/>
          </ac:spMkLst>
        </pc:spChg>
        <pc:spChg chg="add mod ord topLvl">
          <ac:chgData name="Ito, Shigeaki" userId="9738649d-cd64-434d-883a-bc64ce9afd08" providerId="ADAL" clId="{3C05D16F-B2F9-4026-9A1E-DCB0B627E319}" dt="2024-07-18T00:17:36.287" v="733" actId="164"/>
          <ac:spMkLst>
            <pc:docMk/>
            <pc:sldMk cId="4270924471" sldId="260"/>
            <ac:spMk id="41" creationId="{FA358A48-5F9F-F6BF-83C8-752B35559CC4}"/>
          </ac:spMkLst>
        </pc:spChg>
        <pc:spChg chg="add del mod topLvl">
          <ac:chgData name="Ito, Shigeaki" userId="9738649d-cd64-434d-883a-bc64ce9afd08" providerId="ADAL" clId="{3C05D16F-B2F9-4026-9A1E-DCB0B627E319}" dt="2024-07-02T04:14:25.946" v="182" actId="478"/>
          <ac:spMkLst>
            <pc:docMk/>
            <pc:sldMk cId="4270924471" sldId="260"/>
            <ac:spMk id="42" creationId="{C6096D23-C9E6-A4CC-66C3-88224A5CB251}"/>
          </ac:spMkLst>
        </pc:spChg>
        <pc:grpChg chg="add del mod ord">
          <ac:chgData name="Ito, Shigeaki" userId="9738649d-cd64-434d-883a-bc64ce9afd08" providerId="ADAL" clId="{3C05D16F-B2F9-4026-9A1E-DCB0B627E319}" dt="2024-07-02T02:27:39.600" v="17" actId="165"/>
          <ac:grpSpMkLst>
            <pc:docMk/>
            <pc:sldMk cId="4270924471" sldId="260"/>
            <ac:grpSpMk id="43" creationId="{B276DE39-3DFF-6693-1985-5EA83BA8E738}"/>
          </ac:grpSpMkLst>
        </pc:grpChg>
        <pc:grpChg chg="add mod ord topLvl">
          <ac:chgData name="Ito, Shigeaki" userId="9738649d-cd64-434d-883a-bc64ce9afd08" providerId="ADAL" clId="{3C05D16F-B2F9-4026-9A1E-DCB0B627E319}" dt="2024-07-18T00:19:07.684" v="749" actId="166"/>
          <ac:grpSpMkLst>
            <pc:docMk/>
            <pc:sldMk cId="4270924471" sldId="260"/>
            <ac:grpSpMk id="44" creationId="{EE551D13-C80D-253C-3AE3-F71EFC550475}"/>
          </ac:grpSpMkLst>
        </pc:grpChg>
        <pc:grpChg chg="add mod ord topLvl">
          <ac:chgData name="Ito, Shigeaki" userId="9738649d-cd64-434d-883a-bc64ce9afd08" providerId="ADAL" clId="{3C05D16F-B2F9-4026-9A1E-DCB0B627E319}" dt="2024-07-02T05:41:01.095" v="186" actId="165"/>
          <ac:grpSpMkLst>
            <pc:docMk/>
            <pc:sldMk cId="4270924471" sldId="260"/>
            <ac:grpSpMk id="45" creationId="{CAC5A3B5-E263-B168-4AC4-14B36C71B391}"/>
          </ac:grpSpMkLst>
        </pc:grpChg>
        <pc:grpChg chg="add mod ord">
          <ac:chgData name="Ito, Shigeaki" userId="9738649d-cd64-434d-883a-bc64ce9afd08" providerId="ADAL" clId="{3C05D16F-B2F9-4026-9A1E-DCB0B627E319}" dt="2024-07-18T00:19:01.568" v="748" actId="166"/>
          <ac:grpSpMkLst>
            <pc:docMk/>
            <pc:sldMk cId="4270924471" sldId="260"/>
            <ac:grpSpMk id="46" creationId="{4C217449-4969-6C5A-190A-1D0CCF641D20}"/>
          </ac:grpSpMkLst>
        </pc:grpChg>
        <pc:grpChg chg="add mod">
          <ac:chgData name="Ito, Shigeaki" userId="9738649d-cd64-434d-883a-bc64ce9afd08" providerId="ADAL" clId="{3C05D16F-B2F9-4026-9A1E-DCB0B627E319}" dt="2024-07-02T04:09:36.658" v="121" actId="164"/>
          <ac:grpSpMkLst>
            <pc:docMk/>
            <pc:sldMk cId="4270924471" sldId="260"/>
            <ac:grpSpMk id="46" creationId="{983A70D9-B49B-3E92-6E09-5735AEA6AF43}"/>
          </ac:grpSpMkLst>
        </pc:grpChg>
        <pc:grpChg chg="add del mod">
          <ac:chgData name="Ito, Shigeaki" userId="9738649d-cd64-434d-883a-bc64ce9afd08" providerId="ADAL" clId="{3C05D16F-B2F9-4026-9A1E-DCB0B627E319}" dt="2024-07-02T05:41:01.095" v="186" actId="165"/>
          <ac:grpSpMkLst>
            <pc:docMk/>
            <pc:sldMk cId="4270924471" sldId="260"/>
            <ac:grpSpMk id="47" creationId="{6010B491-7182-3EBA-E84A-E04A3224A7B1}"/>
          </ac:grpSpMkLst>
        </pc:grpChg>
        <pc:picChg chg="del mod ord topLvl modCrop">
          <ac:chgData name="Ito, Shigeaki" userId="9738649d-cd64-434d-883a-bc64ce9afd08" providerId="ADAL" clId="{3C05D16F-B2F9-4026-9A1E-DCB0B627E319}" dt="2024-07-18T00:17:15.600" v="727" actId="478"/>
          <ac:picMkLst>
            <pc:docMk/>
            <pc:sldMk cId="4270924471" sldId="260"/>
            <ac:picMk id="5" creationId="{01FB3739-3B77-DA09-F043-6D9461A70669}"/>
          </ac:picMkLst>
        </pc:picChg>
        <pc:picChg chg="add del mod">
          <ac:chgData name="Ito, Shigeaki" userId="9738649d-cd64-434d-883a-bc64ce9afd08" providerId="ADAL" clId="{3C05D16F-B2F9-4026-9A1E-DCB0B627E319}" dt="2024-07-18T00:18:49.811" v="744" actId="478"/>
          <ac:picMkLst>
            <pc:docMk/>
            <pc:sldMk cId="4270924471" sldId="260"/>
            <ac:picMk id="43" creationId="{F0FEA32C-954D-AAB9-423A-216F9EE18D62}"/>
          </ac:picMkLst>
        </pc:picChg>
        <pc:picChg chg="add mod">
          <ac:chgData name="Ito, Shigeaki" userId="9738649d-cd64-434d-883a-bc64ce9afd08" providerId="ADAL" clId="{3C05D16F-B2F9-4026-9A1E-DCB0B627E319}" dt="2024-07-18T00:19:14.156" v="751" actId="1038"/>
          <ac:picMkLst>
            <pc:docMk/>
            <pc:sldMk cId="4270924471" sldId="260"/>
            <ac:picMk id="48" creationId="{67C212C2-4348-AB0C-0B8C-AC9288065F46}"/>
          </ac:picMkLst>
        </pc:picChg>
        <pc:cxnChg chg="add mod topLvl">
          <ac:chgData name="Ito, Shigeaki" userId="9738649d-cd64-434d-883a-bc64ce9afd08" providerId="ADAL" clId="{3C05D16F-B2F9-4026-9A1E-DCB0B627E319}" dt="2024-07-02T05:41:01.095" v="186" actId="165"/>
          <ac:cxnSpMkLst>
            <pc:docMk/>
            <pc:sldMk cId="4270924471" sldId="260"/>
            <ac:cxnSpMk id="12" creationId="{0B4FC490-EF04-EEBC-8902-231AFF31B3B8}"/>
          </ac:cxnSpMkLst>
        </pc:cxnChg>
      </pc:sldChg>
      <pc:sldChg chg="addSp delSp modSp del mod">
        <pc:chgData name="Ito, Shigeaki" userId="9738649d-cd64-434d-883a-bc64ce9afd08" providerId="ADAL" clId="{3C05D16F-B2F9-4026-9A1E-DCB0B627E319}" dt="2024-07-18T00:28:10.409" v="894" actId="47"/>
        <pc:sldMkLst>
          <pc:docMk/>
          <pc:sldMk cId="3645921658" sldId="261"/>
        </pc:sldMkLst>
        <pc:spChg chg="add mod ord topLvl">
          <ac:chgData name="Ito, Shigeaki" userId="9738649d-cd64-434d-883a-bc64ce9afd08" providerId="ADAL" clId="{3C05D16F-B2F9-4026-9A1E-DCB0B627E319}" dt="2024-07-18T00:14:10.937" v="665" actId="167"/>
          <ac:spMkLst>
            <pc:docMk/>
            <pc:sldMk cId="3645921658" sldId="261"/>
            <ac:spMk id="2" creationId="{03EEA9DB-E883-170F-56BF-C40BE49055A2}"/>
          </ac:spMkLst>
        </pc:spChg>
        <pc:spChg chg="add mod topLvl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3" creationId="{55DB2D12-E2A1-6319-008C-A01FEDA9F6D2}"/>
          </ac:spMkLst>
        </pc:spChg>
        <pc:spChg chg="add mod topLvl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4" creationId="{633A2382-FFF8-501C-B4C7-419C4120ABAE}"/>
          </ac:spMkLst>
        </pc:spChg>
        <pc:spChg chg="add mod topLvl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7" creationId="{E9D6869E-3EB6-B850-1351-5CCABBD985BE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9" creationId="{6F4E7C15-ED61-A562-63DD-049033EC4F0A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10" creationId="{6C941938-6993-EEAA-0775-9854FD8F464C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11" creationId="{FFC5A792-0AE3-A530-C0BB-9DBD639EEAF3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12" creationId="{9C1BD1C2-8546-1C9C-7555-FD81B59E9B9A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13" creationId="{AF93B944-E393-B752-B4BB-88EAE6249983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14" creationId="{27D2A5E8-03B0-D3FC-902D-ADFA19890F52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16" creationId="{2FA49BD7-D6A3-A29C-0814-F504D6B928B5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17" creationId="{CFA3D142-3BCE-11EA-253D-5393C8314F94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18" creationId="{90D3EE22-772D-A425-C595-E4C0613B76C9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19" creationId="{24720F3E-4F71-8732-B04F-C624D41B0697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20" creationId="{45FEB8CB-1863-9F52-95D0-D138777107D5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21" creationId="{994999DE-1683-6BB3-7C12-1829C5A6D930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22" creationId="{0F70E920-9BC0-CFBF-63DB-139CD08733A6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23" creationId="{3DFB258F-184B-083A-C166-E910F48B1CCE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24" creationId="{AF09A46A-C7F4-C385-E512-1CF6C0FED656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25" creationId="{B5B7CE40-B819-F95C-9F35-93882FA5FF4E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26" creationId="{C19443C3-72B3-9221-1E8B-3CAADB684FA3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27" creationId="{00724C05-D3D0-9062-C1A8-8AFC7910B5A1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28" creationId="{495554F0-492F-DECD-5824-1F67B06E157D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29" creationId="{E155B139-F96E-EF9F-1E53-E3603B3D659F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30" creationId="{4A393BB7-AF19-3CB2-635E-FF8F05AE07C9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31" creationId="{333A8E96-35DC-52FA-345B-BF9AAFF3DC45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32" creationId="{9AC66722-0868-B408-21F5-5C5F17239D9A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33" creationId="{A5033AFC-2731-B4FB-817F-489644C2B16F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34" creationId="{D087B890-1829-EEE1-31E5-522F3432E441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35" creationId="{170B4261-E932-6594-4EED-D999DA7FA110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36" creationId="{3D6AFC4C-3A61-E323-0B92-4DA532C58AD3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37" creationId="{BA9CE86A-A191-551E-BD6F-EBFEF530F917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38" creationId="{79C91BE8-79A4-09F1-91F9-28DDC79EC2B8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39" creationId="{8377DEE3-29CD-F2E2-CC3A-CBB83F0FF9BB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40" creationId="{D064E191-EA20-2799-4674-07C5181983C8}"/>
          </ac:spMkLst>
        </pc:spChg>
        <pc:spChg chg="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41" creationId="{66B70BB6-B873-4A04-08BF-5AAB43E4D8BF}"/>
          </ac:spMkLst>
        </pc:spChg>
        <pc:spChg chg="add 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42" creationId="{AD07D2B7-AA91-10AA-EFE0-6A085ED702F6}"/>
          </ac:spMkLst>
        </pc:spChg>
        <pc:spChg chg="add mod">
          <ac:chgData name="Ito, Shigeaki" userId="9738649d-cd64-434d-883a-bc64ce9afd08" providerId="ADAL" clId="{3C05D16F-B2F9-4026-9A1E-DCB0B627E319}" dt="2024-07-02T05:56:02.854" v="301" actId="165"/>
          <ac:spMkLst>
            <pc:docMk/>
            <pc:sldMk cId="3645921658" sldId="261"/>
            <ac:spMk id="43" creationId="{FE6D8490-7515-F706-F92E-2C258707D0C6}"/>
          </ac:spMkLst>
        </pc:spChg>
        <pc:grpChg chg="add mod ord topLvl">
          <ac:chgData name="Ito, Shigeaki" userId="9738649d-cd64-434d-883a-bc64ce9afd08" providerId="ADAL" clId="{3C05D16F-B2F9-4026-9A1E-DCB0B627E319}" dt="2024-07-02T05:56:02.854" v="301" actId="165"/>
          <ac:grpSpMkLst>
            <pc:docMk/>
            <pc:sldMk cId="3645921658" sldId="261"/>
            <ac:grpSpMk id="8" creationId="{17A67933-99D7-F7DF-EAAB-7C110234557B}"/>
          </ac:grpSpMkLst>
        </pc:grpChg>
        <pc:grpChg chg="add mod topLvl">
          <ac:chgData name="Ito, Shigeaki" userId="9738649d-cd64-434d-883a-bc64ce9afd08" providerId="ADAL" clId="{3C05D16F-B2F9-4026-9A1E-DCB0B627E319}" dt="2024-07-02T05:56:02.854" v="301" actId="165"/>
          <ac:grpSpMkLst>
            <pc:docMk/>
            <pc:sldMk cId="3645921658" sldId="261"/>
            <ac:grpSpMk id="15" creationId="{45A0A7EA-5AE6-BA1D-1668-97084D5B19B4}"/>
          </ac:grpSpMkLst>
        </pc:grpChg>
        <pc:grpChg chg="add mod ord topLvl">
          <ac:chgData name="Ito, Shigeaki" userId="9738649d-cd64-434d-883a-bc64ce9afd08" providerId="ADAL" clId="{3C05D16F-B2F9-4026-9A1E-DCB0B627E319}" dt="2024-07-18T00:14:05.724" v="663" actId="166"/>
          <ac:grpSpMkLst>
            <pc:docMk/>
            <pc:sldMk cId="3645921658" sldId="261"/>
            <ac:grpSpMk id="44" creationId="{610AA68D-6171-107A-16E7-DB1A333FE9DE}"/>
          </ac:grpSpMkLst>
        </pc:grpChg>
        <pc:grpChg chg="add del mod">
          <ac:chgData name="Ito, Shigeaki" userId="9738649d-cd64-434d-883a-bc64ce9afd08" providerId="ADAL" clId="{3C05D16F-B2F9-4026-9A1E-DCB0B627E319}" dt="2024-07-02T05:56:02.854" v="301" actId="165"/>
          <ac:grpSpMkLst>
            <pc:docMk/>
            <pc:sldMk cId="3645921658" sldId="261"/>
            <ac:grpSpMk id="45" creationId="{51E26F22-A9C7-A576-13CB-DC3F4C40E8B7}"/>
          </ac:grpSpMkLst>
        </pc:grpChg>
        <pc:picChg chg="del mod ord topLvl modCrop">
          <ac:chgData name="Ito, Shigeaki" userId="9738649d-cd64-434d-883a-bc64ce9afd08" providerId="ADAL" clId="{3C05D16F-B2F9-4026-9A1E-DCB0B627E319}" dt="2024-07-18T00:11:57.643" v="629" actId="478"/>
          <ac:picMkLst>
            <pc:docMk/>
            <pc:sldMk cId="3645921658" sldId="261"/>
            <ac:picMk id="5" creationId="{ECD4E8B1-04AF-A09E-07C8-E64C98E36F88}"/>
          </ac:picMkLst>
        </pc:picChg>
        <pc:picChg chg="add del mod ord modCrop">
          <ac:chgData name="Ito, Shigeaki" userId="9738649d-cd64-434d-883a-bc64ce9afd08" providerId="ADAL" clId="{3C05D16F-B2F9-4026-9A1E-DCB0B627E319}" dt="2024-07-18T00:13:44.665" v="657" actId="478"/>
          <ac:picMkLst>
            <pc:docMk/>
            <pc:sldMk cId="3645921658" sldId="261"/>
            <ac:picMk id="46" creationId="{98D0033D-FADB-6B74-15F6-06A2BA98FB76}"/>
          </ac:picMkLst>
        </pc:picChg>
        <pc:picChg chg="add mod ord">
          <ac:chgData name="Ito, Shigeaki" userId="9738649d-cd64-434d-883a-bc64ce9afd08" providerId="ADAL" clId="{3C05D16F-B2F9-4026-9A1E-DCB0B627E319}" dt="2024-07-18T00:14:16.265" v="672" actId="1037"/>
          <ac:picMkLst>
            <pc:docMk/>
            <pc:sldMk cId="3645921658" sldId="261"/>
            <ac:picMk id="48" creationId="{E2BEC9B9-7BF5-2C6E-B6A6-2445DA2DBA80}"/>
          </ac:picMkLst>
        </pc:picChg>
        <pc:cxnChg chg="add mod topLvl">
          <ac:chgData name="Ito, Shigeaki" userId="9738649d-cd64-434d-883a-bc64ce9afd08" providerId="ADAL" clId="{3C05D16F-B2F9-4026-9A1E-DCB0B627E319}" dt="2024-07-02T05:56:02.854" v="301" actId="165"/>
          <ac:cxnSpMkLst>
            <pc:docMk/>
            <pc:sldMk cId="3645921658" sldId="261"/>
            <ac:cxnSpMk id="6" creationId="{E1006511-9758-64EA-79D1-42F4CE16FE57}"/>
          </ac:cxnSpMkLst>
        </pc:cxnChg>
      </pc:sldChg>
      <pc:sldChg chg="addSp modSp del mod">
        <pc:chgData name="Ito, Shigeaki" userId="9738649d-cd64-434d-883a-bc64ce9afd08" providerId="ADAL" clId="{3C05D16F-B2F9-4026-9A1E-DCB0B627E319}" dt="2024-07-18T00:25:49.767" v="858" actId="47"/>
        <pc:sldMkLst>
          <pc:docMk/>
          <pc:sldMk cId="342497841" sldId="262"/>
        </pc:sldMkLst>
        <pc:spChg chg="add mod ord">
          <ac:chgData name="Ito, Shigeaki" userId="9738649d-cd64-434d-883a-bc64ce9afd08" providerId="ADAL" clId="{3C05D16F-B2F9-4026-9A1E-DCB0B627E319}" dt="2024-07-02T06:40:01.421" v="487" actId="167"/>
          <ac:spMkLst>
            <pc:docMk/>
            <pc:sldMk cId="342497841" sldId="262"/>
            <ac:spMk id="2" creationId="{8EF070A8-46BD-328A-CC7E-8D0F6D148B82}"/>
          </ac:spMkLst>
        </pc:spChg>
        <pc:spChg chg="mod">
          <ac:chgData name="Ito, Shigeaki" userId="9738649d-cd64-434d-883a-bc64ce9afd08" providerId="ADAL" clId="{3C05D16F-B2F9-4026-9A1E-DCB0B627E319}" dt="2024-07-02T06:39:58.466" v="486"/>
          <ac:spMkLst>
            <pc:docMk/>
            <pc:sldMk cId="342497841" sldId="262"/>
            <ac:spMk id="4" creationId="{1C0EA4BF-088F-FD88-7A79-16459E34EBBF}"/>
          </ac:spMkLst>
        </pc:spChg>
        <pc:spChg chg="mod">
          <ac:chgData name="Ito, Shigeaki" userId="9738649d-cd64-434d-883a-bc64ce9afd08" providerId="ADAL" clId="{3C05D16F-B2F9-4026-9A1E-DCB0B627E319}" dt="2024-07-02T06:39:58.466" v="486"/>
          <ac:spMkLst>
            <pc:docMk/>
            <pc:sldMk cId="342497841" sldId="262"/>
            <ac:spMk id="6" creationId="{B4E02548-2857-301B-58B1-5B6D331F1462}"/>
          </ac:spMkLst>
        </pc:spChg>
        <pc:spChg chg="mod">
          <ac:chgData name="Ito, Shigeaki" userId="9738649d-cd64-434d-883a-bc64ce9afd08" providerId="ADAL" clId="{3C05D16F-B2F9-4026-9A1E-DCB0B627E319}" dt="2024-07-02T06:39:58.466" v="486"/>
          <ac:spMkLst>
            <pc:docMk/>
            <pc:sldMk cId="342497841" sldId="262"/>
            <ac:spMk id="7" creationId="{A29D9941-33F5-E1BC-7605-44EBE0AB1FFD}"/>
          </ac:spMkLst>
        </pc:spChg>
        <pc:spChg chg="mod">
          <ac:chgData name="Ito, Shigeaki" userId="9738649d-cd64-434d-883a-bc64ce9afd08" providerId="ADAL" clId="{3C05D16F-B2F9-4026-9A1E-DCB0B627E319}" dt="2024-07-02T06:39:58.466" v="486"/>
          <ac:spMkLst>
            <pc:docMk/>
            <pc:sldMk cId="342497841" sldId="262"/>
            <ac:spMk id="8" creationId="{735FD49C-6CF7-537E-3FA1-C3BC684962F9}"/>
          </ac:spMkLst>
        </pc:spChg>
        <pc:spChg chg="add mod">
          <ac:chgData name="Ito, Shigeaki" userId="9738649d-cd64-434d-883a-bc64ce9afd08" providerId="ADAL" clId="{3C05D16F-B2F9-4026-9A1E-DCB0B627E319}" dt="2024-07-02T06:39:58.466" v="486"/>
          <ac:spMkLst>
            <pc:docMk/>
            <pc:sldMk cId="342497841" sldId="262"/>
            <ac:spMk id="9" creationId="{AB586401-6231-CCD6-A2A5-6B4774B118D8}"/>
          </ac:spMkLst>
        </pc:spChg>
        <pc:spChg chg="add mod">
          <ac:chgData name="Ito, Shigeaki" userId="9738649d-cd64-434d-883a-bc64ce9afd08" providerId="ADAL" clId="{3C05D16F-B2F9-4026-9A1E-DCB0B627E319}" dt="2024-07-02T06:39:58.466" v="486"/>
          <ac:spMkLst>
            <pc:docMk/>
            <pc:sldMk cId="342497841" sldId="262"/>
            <ac:spMk id="10" creationId="{E1B14DE3-C8BF-1066-C774-02695C8E83DA}"/>
          </ac:spMkLst>
        </pc:spChg>
        <pc:grpChg chg="add mod">
          <ac:chgData name="Ito, Shigeaki" userId="9738649d-cd64-434d-883a-bc64ce9afd08" providerId="ADAL" clId="{3C05D16F-B2F9-4026-9A1E-DCB0B627E319}" dt="2024-07-02T06:39:58.466" v="486"/>
          <ac:grpSpMkLst>
            <pc:docMk/>
            <pc:sldMk cId="342497841" sldId="262"/>
            <ac:grpSpMk id="3" creationId="{CB282D52-15E0-68C1-8199-C7B8FCCFDDBA}"/>
          </ac:grpSpMkLst>
        </pc:grpChg>
        <pc:picChg chg="mod modCrop">
          <ac:chgData name="Ito, Shigeaki" userId="9738649d-cd64-434d-883a-bc64ce9afd08" providerId="ADAL" clId="{3C05D16F-B2F9-4026-9A1E-DCB0B627E319}" dt="2024-07-02T06:40:55.219" v="498" actId="14100"/>
          <ac:picMkLst>
            <pc:docMk/>
            <pc:sldMk cId="342497841" sldId="262"/>
            <ac:picMk id="5" creationId="{DD81C41B-3C36-3104-338B-7419AF23C580}"/>
          </ac:picMkLst>
        </pc:picChg>
      </pc:sldChg>
      <pc:sldChg chg="addSp modSp del mod">
        <pc:chgData name="Ito, Shigeaki" userId="9738649d-cd64-434d-883a-bc64ce9afd08" providerId="ADAL" clId="{3C05D16F-B2F9-4026-9A1E-DCB0B627E319}" dt="2024-07-18T00:25:49.767" v="858" actId="47"/>
        <pc:sldMkLst>
          <pc:docMk/>
          <pc:sldMk cId="569088925" sldId="263"/>
        </pc:sldMkLst>
        <pc:spChg chg="add mod ord">
          <ac:chgData name="Ito, Shigeaki" userId="9738649d-cd64-434d-883a-bc64ce9afd08" providerId="ADAL" clId="{3C05D16F-B2F9-4026-9A1E-DCB0B627E319}" dt="2024-07-02T06:41:16.336" v="503" actId="167"/>
          <ac:spMkLst>
            <pc:docMk/>
            <pc:sldMk cId="569088925" sldId="263"/>
            <ac:spMk id="2" creationId="{11B39EE1-2602-4304-6CEB-76BB41E9F7B6}"/>
          </ac:spMkLst>
        </pc:spChg>
        <pc:spChg chg="mod">
          <ac:chgData name="Ito, Shigeaki" userId="9738649d-cd64-434d-883a-bc64ce9afd08" providerId="ADAL" clId="{3C05D16F-B2F9-4026-9A1E-DCB0B627E319}" dt="2024-07-02T06:41:13.641" v="502"/>
          <ac:spMkLst>
            <pc:docMk/>
            <pc:sldMk cId="569088925" sldId="263"/>
            <ac:spMk id="4" creationId="{E06EEA75-727A-9935-6B89-BE70B39F3EDC}"/>
          </ac:spMkLst>
        </pc:spChg>
        <pc:spChg chg="mod">
          <ac:chgData name="Ito, Shigeaki" userId="9738649d-cd64-434d-883a-bc64ce9afd08" providerId="ADAL" clId="{3C05D16F-B2F9-4026-9A1E-DCB0B627E319}" dt="2024-07-02T06:41:13.641" v="502"/>
          <ac:spMkLst>
            <pc:docMk/>
            <pc:sldMk cId="569088925" sldId="263"/>
            <ac:spMk id="6" creationId="{1CD1963F-9BA0-D681-8E1A-A88165FDF579}"/>
          </ac:spMkLst>
        </pc:spChg>
        <pc:spChg chg="mod">
          <ac:chgData name="Ito, Shigeaki" userId="9738649d-cd64-434d-883a-bc64ce9afd08" providerId="ADAL" clId="{3C05D16F-B2F9-4026-9A1E-DCB0B627E319}" dt="2024-07-02T06:41:13.641" v="502"/>
          <ac:spMkLst>
            <pc:docMk/>
            <pc:sldMk cId="569088925" sldId="263"/>
            <ac:spMk id="7" creationId="{FB235795-662A-0A85-C7E4-DF2E071CD2DD}"/>
          </ac:spMkLst>
        </pc:spChg>
        <pc:spChg chg="mod">
          <ac:chgData name="Ito, Shigeaki" userId="9738649d-cd64-434d-883a-bc64ce9afd08" providerId="ADAL" clId="{3C05D16F-B2F9-4026-9A1E-DCB0B627E319}" dt="2024-07-02T06:41:13.641" v="502"/>
          <ac:spMkLst>
            <pc:docMk/>
            <pc:sldMk cId="569088925" sldId="263"/>
            <ac:spMk id="8" creationId="{7D59FA43-B512-50CD-2FDE-997F0ADDB91A}"/>
          </ac:spMkLst>
        </pc:spChg>
        <pc:spChg chg="add mod">
          <ac:chgData name="Ito, Shigeaki" userId="9738649d-cd64-434d-883a-bc64ce9afd08" providerId="ADAL" clId="{3C05D16F-B2F9-4026-9A1E-DCB0B627E319}" dt="2024-07-02T06:41:13.641" v="502"/>
          <ac:spMkLst>
            <pc:docMk/>
            <pc:sldMk cId="569088925" sldId="263"/>
            <ac:spMk id="9" creationId="{994FC849-E72F-E170-AF35-CE5D862201C9}"/>
          </ac:spMkLst>
        </pc:spChg>
        <pc:spChg chg="add mod">
          <ac:chgData name="Ito, Shigeaki" userId="9738649d-cd64-434d-883a-bc64ce9afd08" providerId="ADAL" clId="{3C05D16F-B2F9-4026-9A1E-DCB0B627E319}" dt="2024-07-02T06:41:13.641" v="502"/>
          <ac:spMkLst>
            <pc:docMk/>
            <pc:sldMk cId="569088925" sldId="263"/>
            <ac:spMk id="10" creationId="{56394045-D316-6D56-B9DD-155FC1C8457E}"/>
          </ac:spMkLst>
        </pc:spChg>
        <pc:grpChg chg="add mod">
          <ac:chgData name="Ito, Shigeaki" userId="9738649d-cd64-434d-883a-bc64ce9afd08" providerId="ADAL" clId="{3C05D16F-B2F9-4026-9A1E-DCB0B627E319}" dt="2024-07-02T06:41:13.641" v="502"/>
          <ac:grpSpMkLst>
            <pc:docMk/>
            <pc:sldMk cId="569088925" sldId="263"/>
            <ac:grpSpMk id="3" creationId="{6F082283-4278-E0D3-1B6B-05C0432CF204}"/>
          </ac:grpSpMkLst>
        </pc:grpChg>
        <pc:picChg chg="mod modCrop">
          <ac:chgData name="Ito, Shigeaki" userId="9738649d-cd64-434d-883a-bc64ce9afd08" providerId="ADAL" clId="{3C05D16F-B2F9-4026-9A1E-DCB0B627E319}" dt="2024-07-02T06:42:08.076" v="532" actId="1038"/>
          <ac:picMkLst>
            <pc:docMk/>
            <pc:sldMk cId="569088925" sldId="263"/>
            <ac:picMk id="5" creationId="{526C509E-564D-7A2A-D07B-B0935F1E3451}"/>
          </ac:picMkLst>
        </pc:picChg>
      </pc:sldChg>
      <pc:sldChg chg="addSp delSp modSp del mod">
        <pc:chgData name="Ito, Shigeaki" userId="9738649d-cd64-434d-883a-bc64ce9afd08" providerId="ADAL" clId="{3C05D16F-B2F9-4026-9A1E-DCB0B627E319}" dt="2024-07-18T00:28:10.409" v="894" actId="47"/>
        <pc:sldMkLst>
          <pc:docMk/>
          <pc:sldMk cId="3249687389" sldId="264"/>
        </pc:sldMkLst>
        <pc:spChg chg="add mod">
          <ac:chgData name="Ito, Shigeaki" userId="9738649d-cd64-434d-883a-bc64ce9afd08" providerId="ADAL" clId="{3C05D16F-B2F9-4026-9A1E-DCB0B627E319}" dt="2024-07-02T05:41:37.157" v="203" actId="1076"/>
          <ac:spMkLst>
            <pc:docMk/>
            <pc:sldMk cId="3249687389" sldId="264"/>
            <ac:spMk id="2" creationId="{0710D67A-ED81-D458-2125-23B0C6C8E8CC}"/>
          </ac:spMkLst>
        </pc:spChg>
        <pc:spChg chg="add mod">
          <ac:chgData name="Ito, Shigeaki" userId="9738649d-cd64-434d-883a-bc64ce9afd08" providerId="ADAL" clId="{3C05D16F-B2F9-4026-9A1E-DCB0B627E319}" dt="2024-07-02T05:41:37.157" v="203" actId="1076"/>
          <ac:spMkLst>
            <pc:docMk/>
            <pc:sldMk cId="3249687389" sldId="264"/>
            <ac:spMk id="3" creationId="{D1B51D9E-0311-0BC4-6948-74899D52C691}"/>
          </ac:spMkLst>
        </pc:spChg>
        <pc:spChg chg="add mod">
          <ac:chgData name="Ito, Shigeaki" userId="9738649d-cd64-434d-883a-bc64ce9afd08" providerId="ADAL" clId="{3C05D16F-B2F9-4026-9A1E-DCB0B627E319}" dt="2024-07-02T05:41:37.157" v="203" actId="1076"/>
          <ac:spMkLst>
            <pc:docMk/>
            <pc:sldMk cId="3249687389" sldId="264"/>
            <ac:spMk id="4" creationId="{EB8EEE5E-E531-2246-6ACC-9BED4BDA24C0}"/>
          </ac:spMkLst>
        </pc:spChg>
        <pc:spChg chg="add mod">
          <ac:chgData name="Ito, Shigeaki" userId="9738649d-cd64-434d-883a-bc64ce9afd08" providerId="ADAL" clId="{3C05D16F-B2F9-4026-9A1E-DCB0B627E319}" dt="2024-07-02T05:41:37.157" v="203" actId="1076"/>
          <ac:spMkLst>
            <pc:docMk/>
            <pc:sldMk cId="3249687389" sldId="264"/>
            <ac:spMk id="7" creationId="{C87BAB38-AAA0-08A9-2E0C-D7A46152E59A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9" creationId="{7B2DD98B-F8F2-C317-6404-16B8F0D0ED2B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10" creationId="{C0292007-F934-824C-56D2-6F16A342A44C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11" creationId="{EE578008-B0F3-EB96-1FC0-36223684BBE0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12" creationId="{974EE899-FCB0-3221-9168-682D7C61C203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13" creationId="{9448D207-5584-79B7-5114-64FC9B62946E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14" creationId="{F56625DB-B55F-8CAD-19B2-CF60F059BBEC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16" creationId="{9EB7DC55-15B3-07FF-5DD1-5177CEB3EDA1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17" creationId="{A18F1293-C13B-AB02-9ED9-0F55D60185A2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18" creationId="{7D13CE34-56EE-76D1-75BD-90564ACCFFF1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19" creationId="{49BD59CF-CB77-D367-91D3-068FF447B1D8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20" creationId="{F3AF8108-F670-0CC6-652D-72D42AC515F7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21" creationId="{0963DC78-2B9A-759A-7438-FB0C0B08CC98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22" creationId="{3D9DF881-7243-F390-8A08-EFD0D7F1BAC7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23" creationId="{40A23125-F6A0-76D5-B4D1-25F1AE5D2BBC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24" creationId="{D11D36A7-9559-0A91-B393-A851A01EA238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25" creationId="{B4BD6CDE-BCFF-AC95-C14A-F1E0380A4D4F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26" creationId="{3444A8AA-7AFE-4AC2-C0C4-1C8CD281F165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27" creationId="{A8056EA5-C8F8-F995-5E1F-BD6D011C90A2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28" creationId="{8A706BCC-F8FF-19CC-835F-4587FCCEFC3E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29" creationId="{0137B359-B2C7-CCD0-D5D8-0F3CF7335AC5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30" creationId="{E303DCD7-8906-7073-60D0-C7607CF50D19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31" creationId="{ABB4AA12-984C-0FD9-E32D-BA95BAAC2F3D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32" creationId="{3744DBE5-0F9D-80D3-14AF-33C927B07C3C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33" creationId="{028B43A1-2588-3DF8-E9CD-57E710C86007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34" creationId="{99F98DFC-1C4F-7681-185C-0B263F75F719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35" creationId="{A82FB418-811B-8EB3-DF31-5CFF937F1CBD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36" creationId="{C792D863-4FB2-8C82-5814-8FE0DC1D24F1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37" creationId="{F291E79F-D92F-CCEC-14D2-81261EF03704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38" creationId="{FE499B87-67F9-6B70-0347-24A91093D81C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39" creationId="{1E1C617E-59C5-A9D1-85A4-41AF12DB2698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40" creationId="{ADF11578-E5DE-99DC-C6D8-3E3BA90C9BD0}"/>
          </ac:spMkLst>
        </pc:spChg>
        <pc:spChg chg="mod">
          <ac:chgData name="Ito, Shigeaki" userId="9738649d-cd64-434d-883a-bc64ce9afd08" providerId="ADAL" clId="{3C05D16F-B2F9-4026-9A1E-DCB0B627E319}" dt="2024-07-02T05:41:04.253" v="187"/>
          <ac:spMkLst>
            <pc:docMk/>
            <pc:sldMk cId="3249687389" sldId="264"/>
            <ac:spMk id="41" creationId="{CD16D18E-522C-B7EC-C39B-19C28B8C09ED}"/>
          </ac:spMkLst>
        </pc:spChg>
        <pc:spChg chg="add mod">
          <ac:chgData name="Ito, Shigeaki" userId="9738649d-cd64-434d-883a-bc64ce9afd08" providerId="ADAL" clId="{3C05D16F-B2F9-4026-9A1E-DCB0B627E319}" dt="2024-07-02T05:41:37.157" v="203" actId="1076"/>
          <ac:spMkLst>
            <pc:docMk/>
            <pc:sldMk cId="3249687389" sldId="264"/>
            <ac:spMk id="42" creationId="{9A38F0B7-C7CC-3E15-BD4F-B7ED78FC726D}"/>
          </ac:spMkLst>
        </pc:spChg>
        <pc:spChg chg="add mod">
          <ac:chgData name="Ito, Shigeaki" userId="9738649d-cd64-434d-883a-bc64ce9afd08" providerId="ADAL" clId="{3C05D16F-B2F9-4026-9A1E-DCB0B627E319}" dt="2024-07-02T05:41:37.157" v="203" actId="1076"/>
          <ac:spMkLst>
            <pc:docMk/>
            <pc:sldMk cId="3249687389" sldId="264"/>
            <ac:spMk id="43" creationId="{6DFB10C5-FF72-7F22-E49F-0730A8651CBF}"/>
          </ac:spMkLst>
        </pc:spChg>
        <pc:spChg chg="add mod">
          <ac:chgData name="Ito, Shigeaki" userId="9738649d-cd64-434d-883a-bc64ce9afd08" providerId="ADAL" clId="{3C05D16F-B2F9-4026-9A1E-DCB0B627E319}" dt="2024-07-02T06:24:56.759" v="430" actId="164"/>
          <ac:spMkLst>
            <pc:docMk/>
            <pc:sldMk cId="3249687389" sldId="264"/>
            <ac:spMk id="44" creationId="{A7255C84-1AAC-46D1-12E5-A18F50824D05}"/>
          </ac:spMkLst>
        </pc:spChg>
        <pc:spChg chg="add mod">
          <ac:chgData name="Ito, Shigeaki" userId="9738649d-cd64-434d-883a-bc64ce9afd08" providerId="ADAL" clId="{3C05D16F-B2F9-4026-9A1E-DCB0B627E319}" dt="2024-07-02T06:24:56.759" v="430" actId="164"/>
          <ac:spMkLst>
            <pc:docMk/>
            <pc:sldMk cId="3249687389" sldId="264"/>
            <ac:spMk id="45" creationId="{D09DC583-31A8-61FD-1CF2-5390B9EC9659}"/>
          </ac:spMkLst>
        </pc:spChg>
        <pc:spChg chg="add mod ord">
          <ac:chgData name="Ito, Shigeaki" userId="9738649d-cd64-434d-883a-bc64ce9afd08" providerId="ADAL" clId="{3C05D16F-B2F9-4026-9A1E-DCB0B627E319}" dt="2024-07-18T00:27:37.426" v="883" actId="167"/>
          <ac:spMkLst>
            <pc:docMk/>
            <pc:sldMk cId="3249687389" sldId="264"/>
            <ac:spMk id="47" creationId="{1D1CD8A3-A7B3-4456-0F8E-D9EB6A62159B}"/>
          </ac:spMkLst>
        </pc:spChg>
        <pc:spChg chg="add mod">
          <ac:chgData name="Ito, Shigeaki" userId="9738649d-cd64-434d-883a-bc64ce9afd08" providerId="ADAL" clId="{3C05D16F-B2F9-4026-9A1E-DCB0B627E319}" dt="2024-07-02T06:26:11.425" v="441" actId="164"/>
          <ac:spMkLst>
            <pc:docMk/>
            <pc:sldMk cId="3249687389" sldId="264"/>
            <ac:spMk id="48" creationId="{947A505D-2158-1F2B-FE86-E1EFC418C819}"/>
          </ac:spMkLst>
        </pc:spChg>
        <pc:spChg chg="add mod">
          <ac:chgData name="Ito, Shigeaki" userId="9738649d-cd64-434d-883a-bc64ce9afd08" providerId="ADAL" clId="{3C05D16F-B2F9-4026-9A1E-DCB0B627E319}" dt="2024-07-02T06:26:11.425" v="441" actId="164"/>
          <ac:spMkLst>
            <pc:docMk/>
            <pc:sldMk cId="3249687389" sldId="264"/>
            <ac:spMk id="49" creationId="{42C13C6E-FD9C-8DB8-559C-2BEEC0F3CA4D}"/>
          </ac:spMkLst>
        </pc:spChg>
        <pc:spChg chg="add mod">
          <ac:chgData name="Ito, Shigeaki" userId="9738649d-cd64-434d-883a-bc64ce9afd08" providerId="ADAL" clId="{3C05D16F-B2F9-4026-9A1E-DCB0B627E319}" dt="2024-07-02T06:26:11.425" v="441" actId="164"/>
          <ac:spMkLst>
            <pc:docMk/>
            <pc:sldMk cId="3249687389" sldId="264"/>
            <ac:spMk id="50" creationId="{6FA39C39-AB6D-0544-9F6A-903C1A00BD4F}"/>
          </ac:spMkLst>
        </pc:spChg>
        <pc:spChg chg="add mod">
          <ac:chgData name="Ito, Shigeaki" userId="9738649d-cd64-434d-883a-bc64ce9afd08" providerId="ADAL" clId="{3C05D16F-B2F9-4026-9A1E-DCB0B627E319}" dt="2024-07-02T06:26:11.425" v="441" actId="164"/>
          <ac:spMkLst>
            <pc:docMk/>
            <pc:sldMk cId="3249687389" sldId="264"/>
            <ac:spMk id="51" creationId="{BE382B93-B507-096E-10CC-DE6204C36317}"/>
          </ac:spMkLst>
        </pc:spChg>
        <pc:spChg chg="add mod ord">
          <ac:chgData name="Ito, Shigeaki" userId="9738649d-cd64-434d-883a-bc64ce9afd08" providerId="ADAL" clId="{3C05D16F-B2F9-4026-9A1E-DCB0B627E319}" dt="2024-07-18T00:22:15.695" v="799" actId="166"/>
          <ac:spMkLst>
            <pc:docMk/>
            <pc:sldMk cId="3249687389" sldId="264"/>
            <ac:spMk id="52" creationId="{DAD26F3D-4DF7-6A57-E5D5-B1C8BEB77CAE}"/>
          </ac:spMkLst>
        </pc:spChg>
        <pc:spChg chg="add mod ord">
          <ac:chgData name="Ito, Shigeaki" userId="9738649d-cd64-434d-883a-bc64ce9afd08" providerId="ADAL" clId="{3C05D16F-B2F9-4026-9A1E-DCB0B627E319}" dt="2024-07-18T00:22:15.695" v="799" actId="166"/>
          <ac:spMkLst>
            <pc:docMk/>
            <pc:sldMk cId="3249687389" sldId="264"/>
            <ac:spMk id="53" creationId="{08A206AA-9175-7886-C71A-C25A429C8E3F}"/>
          </ac:spMkLst>
        </pc:spChg>
        <pc:grpChg chg="add mod">
          <ac:chgData name="Ito, Shigeaki" userId="9738649d-cd64-434d-883a-bc64ce9afd08" providerId="ADAL" clId="{3C05D16F-B2F9-4026-9A1E-DCB0B627E319}" dt="2024-07-02T05:41:37.157" v="203" actId="1076"/>
          <ac:grpSpMkLst>
            <pc:docMk/>
            <pc:sldMk cId="3249687389" sldId="264"/>
            <ac:grpSpMk id="8" creationId="{B65EC140-C209-4729-1A15-61C2C61D5D50}"/>
          </ac:grpSpMkLst>
        </pc:grpChg>
        <pc:grpChg chg="add mod">
          <ac:chgData name="Ito, Shigeaki" userId="9738649d-cd64-434d-883a-bc64ce9afd08" providerId="ADAL" clId="{3C05D16F-B2F9-4026-9A1E-DCB0B627E319}" dt="2024-07-02T05:41:37.157" v="203" actId="1076"/>
          <ac:grpSpMkLst>
            <pc:docMk/>
            <pc:sldMk cId="3249687389" sldId="264"/>
            <ac:grpSpMk id="15" creationId="{BC92E81A-BB20-CB3D-C423-4257600FBAC3}"/>
          </ac:grpSpMkLst>
        </pc:grpChg>
        <pc:grpChg chg="add del mod">
          <ac:chgData name="Ito, Shigeaki" userId="9738649d-cd64-434d-883a-bc64ce9afd08" providerId="ADAL" clId="{3C05D16F-B2F9-4026-9A1E-DCB0B627E319}" dt="2024-07-02T06:25:32.594" v="432" actId="478"/>
          <ac:grpSpMkLst>
            <pc:docMk/>
            <pc:sldMk cId="3249687389" sldId="264"/>
            <ac:grpSpMk id="46" creationId="{861B9361-02DB-03F1-4384-52B77678E0BA}"/>
          </ac:grpSpMkLst>
        </pc:grpChg>
        <pc:grpChg chg="add mod ord">
          <ac:chgData name="Ito, Shigeaki" userId="9738649d-cd64-434d-883a-bc64ce9afd08" providerId="ADAL" clId="{3C05D16F-B2F9-4026-9A1E-DCB0B627E319}" dt="2024-07-02T06:26:48.531" v="451" actId="1076"/>
          <ac:grpSpMkLst>
            <pc:docMk/>
            <pc:sldMk cId="3249687389" sldId="264"/>
            <ac:grpSpMk id="54" creationId="{13B5D34A-3252-C364-D41E-4BC958CB3D3B}"/>
          </ac:grpSpMkLst>
        </pc:grpChg>
        <pc:picChg chg="add del mod ord">
          <ac:chgData name="Ito, Shigeaki" userId="9738649d-cd64-434d-883a-bc64ce9afd08" providerId="ADAL" clId="{3C05D16F-B2F9-4026-9A1E-DCB0B627E319}" dt="2024-07-18T00:21:50.429" v="793" actId="478"/>
          <ac:picMkLst>
            <pc:docMk/>
            <pc:sldMk cId="3249687389" sldId="264"/>
            <ac:picMk id="3" creationId="{8267CE0C-5942-6D3B-9C3F-E1817B7E4B78}"/>
          </ac:picMkLst>
        </pc:picChg>
        <pc:picChg chg="del mod ord modCrop">
          <ac:chgData name="Ito, Shigeaki" userId="9738649d-cd64-434d-883a-bc64ce9afd08" providerId="ADAL" clId="{3C05D16F-B2F9-4026-9A1E-DCB0B627E319}" dt="2024-07-18T00:20:26.446" v="763" actId="478"/>
          <ac:picMkLst>
            <pc:docMk/>
            <pc:sldMk cId="3249687389" sldId="264"/>
            <ac:picMk id="5" creationId="{4737A6FF-7A24-3E5C-D2BD-27D54B274073}"/>
          </ac:picMkLst>
        </pc:picChg>
        <pc:picChg chg="add del mod ord modCrop">
          <ac:chgData name="Ito, Shigeaki" userId="9738649d-cd64-434d-883a-bc64ce9afd08" providerId="ADAL" clId="{3C05D16F-B2F9-4026-9A1E-DCB0B627E319}" dt="2024-07-18T00:25:01.179" v="841" actId="478"/>
          <ac:picMkLst>
            <pc:docMk/>
            <pc:sldMk cId="3249687389" sldId="264"/>
            <ac:picMk id="6" creationId="{03980365-5C7E-D179-D66D-033859E1D523}"/>
          </ac:picMkLst>
        </pc:picChg>
        <pc:picChg chg="add del mod ord">
          <ac:chgData name="Ito, Shigeaki" userId="9738649d-cd64-434d-883a-bc64ce9afd08" providerId="ADAL" clId="{3C05D16F-B2F9-4026-9A1E-DCB0B627E319}" dt="2024-07-18T00:26:25.844" v="863" actId="478"/>
          <ac:picMkLst>
            <pc:docMk/>
            <pc:sldMk cId="3249687389" sldId="264"/>
            <ac:picMk id="8" creationId="{B8BE31E8-FFD2-7307-9D5E-8C528B8B77EF}"/>
          </ac:picMkLst>
        </pc:picChg>
        <pc:picChg chg="add del mod ord">
          <ac:chgData name="Ito, Shigeaki" userId="9738649d-cd64-434d-883a-bc64ce9afd08" providerId="ADAL" clId="{3C05D16F-B2F9-4026-9A1E-DCB0B627E319}" dt="2024-07-18T00:27:24.142" v="878" actId="478"/>
          <ac:picMkLst>
            <pc:docMk/>
            <pc:sldMk cId="3249687389" sldId="264"/>
            <ac:picMk id="10" creationId="{421E91EE-A5D9-44AB-D710-AE8F102E8B15}"/>
          </ac:picMkLst>
        </pc:picChg>
        <pc:picChg chg="add mod ord">
          <ac:chgData name="Ito, Shigeaki" userId="9738649d-cd64-434d-883a-bc64ce9afd08" providerId="ADAL" clId="{3C05D16F-B2F9-4026-9A1E-DCB0B627E319}" dt="2024-07-18T00:27:42.628" v="889" actId="1035"/>
          <ac:picMkLst>
            <pc:docMk/>
            <pc:sldMk cId="3249687389" sldId="264"/>
            <ac:picMk id="12" creationId="{87A0A24C-C270-16CB-8457-AE0386FAA43B}"/>
          </ac:picMkLst>
        </pc:picChg>
        <pc:cxnChg chg="add mod">
          <ac:chgData name="Ito, Shigeaki" userId="9738649d-cd64-434d-883a-bc64ce9afd08" providerId="ADAL" clId="{3C05D16F-B2F9-4026-9A1E-DCB0B627E319}" dt="2024-07-02T05:41:37.157" v="203" actId="1076"/>
          <ac:cxnSpMkLst>
            <pc:docMk/>
            <pc:sldMk cId="3249687389" sldId="264"/>
            <ac:cxnSpMk id="6" creationId="{A68C4A76-6103-E456-7970-E96C9C3AFA40}"/>
          </ac:cxnSpMkLst>
        </pc:cxnChg>
      </pc:sldChg>
      <pc:sldChg chg="addSp modSp del mod">
        <pc:chgData name="Ito, Shigeaki" userId="9738649d-cd64-434d-883a-bc64ce9afd08" providerId="ADAL" clId="{3C05D16F-B2F9-4026-9A1E-DCB0B627E319}" dt="2024-07-18T00:28:10.409" v="894" actId="47"/>
        <pc:sldMkLst>
          <pc:docMk/>
          <pc:sldMk cId="3097429122" sldId="265"/>
        </pc:sldMkLst>
        <pc:spChg chg="add mod">
          <ac:chgData name="Ito, Shigeaki" userId="9738649d-cd64-434d-883a-bc64ce9afd08" providerId="ADAL" clId="{3C05D16F-B2F9-4026-9A1E-DCB0B627E319}" dt="2024-07-02T06:37:13.821" v="458" actId="1076"/>
          <ac:spMkLst>
            <pc:docMk/>
            <pc:sldMk cId="3097429122" sldId="265"/>
            <ac:spMk id="2" creationId="{915E4DCE-5192-870D-1A0A-92875E1E0B8F}"/>
          </ac:spMkLst>
        </pc:spChg>
        <pc:spChg chg="mod">
          <ac:chgData name="Ito, Shigeaki" userId="9738649d-cd64-434d-883a-bc64ce9afd08" providerId="ADAL" clId="{3C05D16F-B2F9-4026-9A1E-DCB0B627E319}" dt="2024-07-02T06:37:11.573" v="457"/>
          <ac:spMkLst>
            <pc:docMk/>
            <pc:sldMk cId="3097429122" sldId="265"/>
            <ac:spMk id="4" creationId="{1DE8E33B-6958-9AE9-CA73-3ABBEA153DF8}"/>
          </ac:spMkLst>
        </pc:spChg>
        <pc:spChg chg="mod">
          <ac:chgData name="Ito, Shigeaki" userId="9738649d-cd64-434d-883a-bc64ce9afd08" providerId="ADAL" clId="{3C05D16F-B2F9-4026-9A1E-DCB0B627E319}" dt="2024-07-02T06:37:11.573" v="457"/>
          <ac:spMkLst>
            <pc:docMk/>
            <pc:sldMk cId="3097429122" sldId="265"/>
            <ac:spMk id="6" creationId="{D32A1212-CF02-1758-58EB-8B13DC70AFCF}"/>
          </ac:spMkLst>
        </pc:spChg>
        <pc:spChg chg="mod">
          <ac:chgData name="Ito, Shigeaki" userId="9738649d-cd64-434d-883a-bc64ce9afd08" providerId="ADAL" clId="{3C05D16F-B2F9-4026-9A1E-DCB0B627E319}" dt="2024-07-02T06:37:11.573" v="457"/>
          <ac:spMkLst>
            <pc:docMk/>
            <pc:sldMk cId="3097429122" sldId="265"/>
            <ac:spMk id="7" creationId="{A3356513-36B2-D6C3-2F47-04414C49955B}"/>
          </ac:spMkLst>
        </pc:spChg>
        <pc:spChg chg="mod">
          <ac:chgData name="Ito, Shigeaki" userId="9738649d-cd64-434d-883a-bc64ce9afd08" providerId="ADAL" clId="{3C05D16F-B2F9-4026-9A1E-DCB0B627E319}" dt="2024-07-02T06:37:11.573" v="457"/>
          <ac:spMkLst>
            <pc:docMk/>
            <pc:sldMk cId="3097429122" sldId="265"/>
            <ac:spMk id="8" creationId="{9F1C827C-3653-D96A-0B86-5748832EC003}"/>
          </ac:spMkLst>
        </pc:spChg>
        <pc:spChg chg="add mod ord">
          <ac:chgData name="Ito, Shigeaki" userId="9738649d-cd64-434d-883a-bc64ce9afd08" providerId="ADAL" clId="{3C05D16F-B2F9-4026-9A1E-DCB0B627E319}" dt="2024-07-02T06:37:25.211" v="461" actId="166"/>
          <ac:spMkLst>
            <pc:docMk/>
            <pc:sldMk cId="3097429122" sldId="265"/>
            <ac:spMk id="9" creationId="{4DB716A1-E91C-0C79-B58C-A316759BDB82}"/>
          </ac:spMkLst>
        </pc:spChg>
        <pc:spChg chg="add mod ord">
          <ac:chgData name="Ito, Shigeaki" userId="9738649d-cd64-434d-883a-bc64ce9afd08" providerId="ADAL" clId="{3C05D16F-B2F9-4026-9A1E-DCB0B627E319}" dt="2024-07-02T06:37:25.211" v="461" actId="166"/>
          <ac:spMkLst>
            <pc:docMk/>
            <pc:sldMk cId="3097429122" sldId="265"/>
            <ac:spMk id="10" creationId="{41293E42-6C13-707A-2B33-504E4EA9FC8F}"/>
          </ac:spMkLst>
        </pc:spChg>
        <pc:grpChg chg="add mod ord">
          <ac:chgData name="Ito, Shigeaki" userId="9738649d-cd64-434d-883a-bc64ce9afd08" providerId="ADAL" clId="{3C05D16F-B2F9-4026-9A1E-DCB0B627E319}" dt="2024-07-02T06:37:25.211" v="461" actId="166"/>
          <ac:grpSpMkLst>
            <pc:docMk/>
            <pc:sldMk cId="3097429122" sldId="265"/>
            <ac:grpSpMk id="3" creationId="{D6FB84BC-9776-D051-A5A2-3457B48F9F27}"/>
          </ac:grpSpMkLst>
        </pc:grpChg>
        <pc:picChg chg="mod ord modCrop">
          <ac:chgData name="Ito, Shigeaki" userId="9738649d-cd64-434d-883a-bc64ce9afd08" providerId="ADAL" clId="{3C05D16F-B2F9-4026-9A1E-DCB0B627E319}" dt="2024-07-02T06:38:08.560" v="468" actId="14100"/>
          <ac:picMkLst>
            <pc:docMk/>
            <pc:sldMk cId="3097429122" sldId="265"/>
            <ac:picMk id="5" creationId="{73BB37C3-C592-BAFD-EF7F-E2CFAE7BC973}"/>
          </ac:picMkLst>
        </pc:picChg>
      </pc:sldChg>
      <pc:sldChg chg="addSp delSp modSp new mod">
        <pc:chgData name="Ito, Shigeaki" userId="9738649d-cd64-434d-883a-bc64ce9afd08" providerId="ADAL" clId="{3C05D16F-B2F9-4026-9A1E-DCB0B627E319}" dt="2024-11-06T04:03:37.074" v="1112" actId="20577"/>
        <pc:sldMkLst>
          <pc:docMk/>
          <pc:sldMk cId="1505948072" sldId="266"/>
        </pc:sldMkLst>
        <pc:spChg chg="del">
          <ac:chgData name="Ito, Shigeaki" userId="9738649d-cd64-434d-883a-bc64ce9afd08" providerId="ADAL" clId="{3C05D16F-B2F9-4026-9A1E-DCB0B627E319}" dt="2024-07-02T04:12:22.756" v="178" actId="478"/>
          <ac:spMkLst>
            <pc:docMk/>
            <pc:sldMk cId="1505948072" sldId="266"/>
            <ac:spMk id="2" creationId="{AF51C741-C579-ACD8-DB9B-0DF5892812C1}"/>
          </ac:spMkLst>
        </pc:spChg>
        <pc:spChg chg="del">
          <ac:chgData name="Ito, Shigeaki" userId="9738649d-cd64-434d-883a-bc64ce9afd08" providerId="ADAL" clId="{3C05D16F-B2F9-4026-9A1E-DCB0B627E319}" dt="2024-07-02T04:12:22.756" v="178" actId="478"/>
          <ac:spMkLst>
            <pc:docMk/>
            <pc:sldMk cId="1505948072" sldId="266"/>
            <ac:spMk id="3" creationId="{497E4F8C-C0CF-EE4B-E323-9F184CCFE92F}"/>
          </ac:spMkLst>
        </pc:spChg>
        <pc:spChg chg="add mod">
          <ac:chgData name="Ito, Shigeaki" userId="9738649d-cd64-434d-883a-bc64ce9afd08" providerId="ADAL" clId="{3C05D16F-B2F9-4026-9A1E-DCB0B627E319}" dt="2024-11-06T04:03:37.074" v="1112" actId="20577"/>
          <ac:spMkLst>
            <pc:docMk/>
            <pc:sldMk cId="1505948072" sldId="266"/>
            <ac:spMk id="3" creationId="{8E2B719C-043D-7FD5-77B1-7369FD9E3881}"/>
          </ac:spMkLst>
        </pc:spChg>
        <pc:spChg chg="add 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6" creationId="{69E5FE9D-F805-6038-DBE2-F41962339FD7}"/>
          </ac:spMkLst>
        </pc:spChg>
        <pc:spChg chg="add 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7" creationId="{BAA53C87-FCF0-98DA-11B4-0EA275AF61AE}"/>
          </ac:spMkLst>
        </pc:spChg>
        <pc:spChg chg="add 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8" creationId="{41A72EEB-F4BE-C60F-B75F-D7EAB6F0C88C}"/>
          </ac:spMkLst>
        </pc:spChg>
        <pc:spChg chg="add 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10" creationId="{B3F07AC8-81B5-30CD-DB1F-377F3C996D3F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12" creationId="{86675354-C4B8-87D3-F398-021328D10432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13" creationId="{2EE6E72B-921E-6B2E-1849-BE60D67C6452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14" creationId="{0C6F8060-78AD-8323-EB10-8C5273E3ED92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15" creationId="{7905496B-5906-52C9-F34F-B8C9BF02240A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16" creationId="{7F063748-8848-06ED-4A58-2809A006AEAE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17" creationId="{7B110734-7010-FF00-FD46-9220B0995299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18" creationId="{CD080895-8505-3D88-42E2-22340F868159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19" creationId="{988348A6-A2E3-BCE4-5111-FCA512161DAD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20" creationId="{69B1D05A-2FA3-7E93-B71C-AE70A92625F2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21" creationId="{0963060C-0DF9-3660-D5B4-6839EC96134A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22" creationId="{3EB388A6-BA5D-BC55-B3AC-4A315855A4D0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23" creationId="{6CEBE09C-248A-939A-D3E9-180FDE1E99E7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24" creationId="{C00250E0-6248-0BD6-6B33-2DDCF7617A21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25" creationId="{4FFFE0DC-92DD-85B6-D316-79D66A7E6F53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26" creationId="{F59856E4-9185-5849-EB91-7091BA189212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27" creationId="{6CD6C0EB-AD94-8CB6-925A-4CD2DE1259A1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28" creationId="{14B67502-E582-5985-FA8F-A72ABCF5B8D1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29" creationId="{7B25394F-0605-D01C-5D49-AD40B87186A3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30" creationId="{43972818-2033-7F10-5F71-1C2BB7AA93D6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31" creationId="{91EE60D4-B4ED-2574-9A32-76A0620F6E62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32" creationId="{F000BC8B-B1D2-5C06-C943-E3118C7259DA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33" creationId="{1CB9CAA4-A42A-7DF9-90D6-FF4A826CFD8F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34" creationId="{3F8F8558-1D22-0BC8-36F0-7DE680A31317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35" creationId="{A3E9ECD5-3C17-769D-3EC0-E039144464B7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36" creationId="{34A9CB5D-16B6-8FA5-E2AE-B99A0E472ED1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37" creationId="{9D5D7112-B035-F29E-B303-6CF74E773B35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39" creationId="{B5D7E063-BE23-1D5D-8C35-A8E29FE9B3C4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40" creationId="{8976B037-CE99-200C-CF22-D20AF7994E43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42" creationId="{EA095A26-8595-93F3-092F-5EA4E4348205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43" creationId="{C7263F55-47F1-014A-A3FF-BA45E45E13B1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44" creationId="{37B364C2-1639-3609-5014-156198B409F3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45" creationId="{2B0DD820-C07D-410C-C884-1D45BB2B77E3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46" creationId="{A476C162-F6D7-61BB-E542-09FA72E590FE}"/>
          </ac:spMkLst>
        </pc:spChg>
        <pc:spChg chg="mod">
          <ac:chgData name="Ito, Shigeaki" userId="9738649d-cd64-434d-883a-bc64ce9afd08" providerId="ADAL" clId="{3C05D16F-B2F9-4026-9A1E-DCB0B627E319}" dt="2024-07-02T06:20:42.452" v="403"/>
          <ac:spMkLst>
            <pc:docMk/>
            <pc:sldMk cId="1505948072" sldId="266"/>
            <ac:spMk id="47" creationId="{837273E0-DE9F-43C5-5D8F-7501BFBCFC74}"/>
          </ac:spMkLst>
        </pc:spChg>
        <pc:grpChg chg="add mod">
          <ac:chgData name="Ito, Shigeaki" userId="9738649d-cd64-434d-883a-bc64ce9afd08" providerId="ADAL" clId="{3C05D16F-B2F9-4026-9A1E-DCB0B627E319}" dt="2024-07-02T06:20:42.452" v="403"/>
          <ac:grpSpMkLst>
            <pc:docMk/>
            <pc:sldMk cId="1505948072" sldId="266"/>
            <ac:grpSpMk id="11" creationId="{F9562D0F-A13E-2D94-B8A5-4741946E84E1}"/>
          </ac:grpSpMkLst>
        </pc:grpChg>
        <pc:grpChg chg="add mod">
          <ac:chgData name="Ito, Shigeaki" userId="9738649d-cd64-434d-883a-bc64ce9afd08" providerId="ADAL" clId="{3C05D16F-B2F9-4026-9A1E-DCB0B627E319}" dt="2024-07-02T06:20:42.452" v="403"/>
          <ac:grpSpMkLst>
            <pc:docMk/>
            <pc:sldMk cId="1505948072" sldId="266"/>
            <ac:grpSpMk id="38" creationId="{150C16C4-143C-8528-6309-F19CEE19DBB4}"/>
          </ac:grpSpMkLst>
        </pc:grpChg>
        <pc:grpChg chg="add mod">
          <ac:chgData name="Ito, Shigeaki" userId="9738649d-cd64-434d-883a-bc64ce9afd08" providerId="ADAL" clId="{3C05D16F-B2F9-4026-9A1E-DCB0B627E319}" dt="2024-07-02T06:20:42.452" v="403"/>
          <ac:grpSpMkLst>
            <pc:docMk/>
            <pc:sldMk cId="1505948072" sldId="266"/>
            <ac:grpSpMk id="41" creationId="{FAB57600-FA1A-A383-2458-0CF05B1BAFAA}"/>
          </ac:grpSpMkLst>
        </pc:grpChg>
        <pc:picChg chg="add del mod">
          <ac:chgData name="Ito, Shigeaki" userId="9738649d-cd64-434d-883a-bc64ce9afd08" providerId="ADAL" clId="{3C05D16F-B2F9-4026-9A1E-DCB0B627E319}" dt="2024-07-18T00:19:29.045" v="756" actId="478"/>
          <ac:picMkLst>
            <pc:docMk/>
            <pc:sldMk cId="1505948072" sldId="266"/>
            <ac:picMk id="2" creationId="{EE75A2B5-1030-685C-B756-6D6CB6B8FB05}"/>
          </ac:picMkLst>
        </pc:picChg>
        <pc:picChg chg="add mod">
          <ac:chgData name="Ito, Shigeaki" userId="9738649d-cd64-434d-883a-bc64ce9afd08" providerId="ADAL" clId="{3C05D16F-B2F9-4026-9A1E-DCB0B627E319}" dt="2024-07-18T00:19:28.009" v="755" actId="1076"/>
          <ac:picMkLst>
            <pc:docMk/>
            <pc:sldMk cId="1505948072" sldId="266"/>
            <ac:picMk id="3" creationId="{26EECA5D-24DB-5CB8-1185-0D7C77EFD907}"/>
          </ac:picMkLst>
        </pc:picChg>
        <pc:picChg chg="add del mod">
          <ac:chgData name="Ito, Shigeaki" userId="9738649d-cd64-434d-883a-bc64ce9afd08" providerId="ADAL" clId="{3C05D16F-B2F9-4026-9A1E-DCB0B627E319}" dt="2024-07-02T04:14:17.083" v="181" actId="478"/>
          <ac:picMkLst>
            <pc:docMk/>
            <pc:sldMk cId="1505948072" sldId="266"/>
            <ac:picMk id="4" creationId="{145C7B37-4EB9-5E09-30D0-7F8B2D18AAB4}"/>
          </ac:picMkLst>
        </pc:picChg>
        <pc:picChg chg="add del mod">
          <ac:chgData name="Ito, Shigeaki" userId="9738649d-cd64-434d-883a-bc64ce9afd08" providerId="ADAL" clId="{3C05D16F-B2F9-4026-9A1E-DCB0B627E319}" dt="2024-07-18T00:18:12.721" v="741" actId="478"/>
          <ac:picMkLst>
            <pc:docMk/>
            <pc:sldMk cId="1505948072" sldId="266"/>
            <ac:picMk id="5" creationId="{2E6845C6-C13A-F634-656B-DB6189C1B15C}"/>
          </ac:picMkLst>
        </pc:picChg>
        <pc:cxnChg chg="add mod">
          <ac:chgData name="Ito, Shigeaki" userId="9738649d-cd64-434d-883a-bc64ce9afd08" providerId="ADAL" clId="{3C05D16F-B2F9-4026-9A1E-DCB0B627E319}" dt="2024-07-02T06:20:42.452" v="403"/>
          <ac:cxnSpMkLst>
            <pc:docMk/>
            <pc:sldMk cId="1505948072" sldId="266"/>
            <ac:cxnSpMk id="9" creationId="{FE57D9A6-7F29-F2DB-8599-81C90E3C3A43}"/>
          </ac:cxnSpMkLst>
        </pc:cxnChg>
      </pc:sldChg>
      <pc:sldChg chg="addSp delSp modSp new mod">
        <pc:chgData name="Ito, Shigeaki" userId="9738649d-cd64-434d-883a-bc64ce9afd08" providerId="ADAL" clId="{3C05D16F-B2F9-4026-9A1E-DCB0B627E319}" dt="2024-11-06T04:03:29.011" v="1110" actId="20577"/>
        <pc:sldMkLst>
          <pc:docMk/>
          <pc:sldMk cId="2427404617" sldId="267"/>
        </pc:sldMkLst>
        <pc:spChg chg="del">
          <ac:chgData name="Ito, Shigeaki" userId="9738649d-cd64-434d-883a-bc64ce9afd08" providerId="ADAL" clId="{3C05D16F-B2F9-4026-9A1E-DCB0B627E319}" dt="2024-07-02T05:43:37.309" v="235" actId="478"/>
          <ac:spMkLst>
            <pc:docMk/>
            <pc:sldMk cId="2427404617" sldId="267"/>
            <ac:spMk id="2" creationId="{111D14F4-E90C-3509-0604-7496CAA8FEC8}"/>
          </ac:spMkLst>
        </pc:spChg>
        <pc:spChg chg="add 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2" creationId="{C090238D-1CBC-09EE-1E23-B7370E958093}"/>
          </ac:spMkLst>
        </pc:spChg>
        <pc:spChg chg="add mod">
          <ac:chgData name="Ito, Shigeaki" userId="9738649d-cd64-434d-883a-bc64ce9afd08" providerId="ADAL" clId="{3C05D16F-B2F9-4026-9A1E-DCB0B627E319}" dt="2024-11-06T04:03:29.011" v="1110" actId="20577"/>
          <ac:spMkLst>
            <pc:docMk/>
            <pc:sldMk cId="2427404617" sldId="267"/>
            <ac:spMk id="2" creationId="{FCDFC7BB-D190-EBF2-BDD8-02D6C54BE48A}"/>
          </ac:spMkLst>
        </pc:spChg>
        <pc:spChg chg="add 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3" creationId="{0DE869B4-9775-BF45-C359-8F02047EFFA8}"/>
          </ac:spMkLst>
        </pc:spChg>
        <pc:spChg chg="del">
          <ac:chgData name="Ito, Shigeaki" userId="9738649d-cd64-434d-883a-bc64ce9afd08" providerId="ADAL" clId="{3C05D16F-B2F9-4026-9A1E-DCB0B627E319}" dt="2024-07-02T05:43:37.309" v="235" actId="478"/>
          <ac:spMkLst>
            <pc:docMk/>
            <pc:sldMk cId="2427404617" sldId="267"/>
            <ac:spMk id="3" creationId="{6E7FB910-F9C4-BD50-583B-54D2EC17421E}"/>
          </ac:spMkLst>
        </pc:spChg>
        <pc:spChg chg="add 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5" creationId="{6D30CB14-0AFC-A056-5B31-213FA55CB826}"/>
          </ac:spMkLst>
        </pc:spChg>
        <pc:spChg chg="add 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7" creationId="{79408340-0AD5-72BA-DDC9-375E3C9EF2FA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9" creationId="{48144C6A-7656-3678-B520-D1B1C635FEA3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10" creationId="{1F39917C-EC5D-83B6-EF13-04CF254A591C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11" creationId="{71FEF773-5094-DB85-5957-90974FC03695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12" creationId="{54FC4799-9C66-86D8-DE5B-1504C52387C5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13" creationId="{D8A82D3E-AED9-9582-D252-7742C49DD921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14" creationId="{D413C4EF-FB6C-3E1A-D0D4-4A3DEE13E529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15" creationId="{765B9E41-69A5-2C0D-F45C-92125B3CC9DA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16" creationId="{300C7A4F-F8A5-10F8-AAC9-9F0929E1776C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17" creationId="{512B87FB-8E4A-20DA-33DF-B43A99E455B5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18" creationId="{F6BE5D4E-BA55-B04C-633F-25DCE10DF80C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19" creationId="{5CECB28D-0120-4FFC-119B-F68D3E5142AF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20" creationId="{97CB6343-B3BE-B95B-8B52-B3FCD13F4B5E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21" creationId="{6473AAA5-1EDE-232D-2911-794D06567AA5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22" creationId="{4135E6C4-22F2-A225-7A1B-8569D2651029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23" creationId="{801E31B3-6B72-6FB0-D12E-0C0590A1A0FA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24" creationId="{E387930B-5463-8A68-5A73-EC96869E4A6B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25" creationId="{07B104B6-ADB6-DEAF-22AD-84C4B218E1F0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26" creationId="{B9269C87-9F5D-7238-E26C-2335469348F0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27" creationId="{35F36EF1-5D20-48D0-ED97-89CB8F8BC354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28" creationId="{48682BC1-FD56-4380-AEED-1604B816182B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29" creationId="{6B6BDD93-89EA-E9C5-9F75-7FA566795992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30" creationId="{3977F69F-CFFA-0AF2-AA20-A4C50BBA8E4C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31" creationId="{DD744787-89C1-C2F7-FEE8-3397579F2881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32" creationId="{293133F1-E422-602B-1E0E-A92E6172A3FD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33" creationId="{FC1BEC91-5C82-2B5C-CAB4-735C220DB7B5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34" creationId="{08F08158-FAE5-46D0-D942-DDB242B83269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37" creationId="{E0BC396E-5ACA-5762-7566-9DF437A5B197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38" creationId="{233BA83A-194E-8F88-B030-8EC3151FAECB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40" creationId="{83846F4E-1D84-BCEF-9024-2FA14F6E8C90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41" creationId="{887B70F9-957D-6BDA-C82E-92E12FA41ED4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42" creationId="{13325596-5476-2586-66EC-FB7A58C0154D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43" creationId="{FC564CA4-A0AC-8816-ABF6-16BD44B5BCDD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44" creationId="{FAF10F8C-E67E-9938-BC01-B28CD8CF0D82}"/>
          </ac:spMkLst>
        </pc:spChg>
        <pc:spChg chg="mod">
          <ac:chgData name="Ito, Shigeaki" userId="9738649d-cd64-434d-883a-bc64ce9afd08" providerId="ADAL" clId="{3C05D16F-B2F9-4026-9A1E-DCB0B627E319}" dt="2024-07-18T00:19:33.033" v="758"/>
          <ac:spMkLst>
            <pc:docMk/>
            <pc:sldMk cId="2427404617" sldId="267"/>
            <ac:spMk id="45" creationId="{39893F7C-4313-917F-94F6-2BEE3032A934}"/>
          </ac:spMkLst>
        </pc:spChg>
        <pc:grpChg chg="add mod">
          <ac:chgData name="Ito, Shigeaki" userId="9738649d-cd64-434d-883a-bc64ce9afd08" providerId="ADAL" clId="{3C05D16F-B2F9-4026-9A1E-DCB0B627E319}" dt="2024-07-18T00:19:33.033" v="758"/>
          <ac:grpSpMkLst>
            <pc:docMk/>
            <pc:sldMk cId="2427404617" sldId="267"/>
            <ac:grpSpMk id="8" creationId="{CD6BBF95-A2B5-B1C8-4BBF-E6D8D5FA011C}"/>
          </ac:grpSpMkLst>
        </pc:grpChg>
        <pc:grpChg chg="add mod">
          <ac:chgData name="Ito, Shigeaki" userId="9738649d-cd64-434d-883a-bc64ce9afd08" providerId="ADAL" clId="{3C05D16F-B2F9-4026-9A1E-DCB0B627E319}" dt="2024-07-18T00:19:33.033" v="758"/>
          <ac:grpSpMkLst>
            <pc:docMk/>
            <pc:sldMk cId="2427404617" sldId="267"/>
            <ac:grpSpMk id="36" creationId="{350E04F9-735C-1273-4BFD-3ABEE80F98E0}"/>
          </ac:grpSpMkLst>
        </pc:grpChg>
        <pc:grpChg chg="add mod">
          <ac:chgData name="Ito, Shigeaki" userId="9738649d-cd64-434d-883a-bc64ce9afd08" providerId="ADAL" clId="{3C05D16F-B2F9-4026-9A1E-DCB0B627E319}" dt="2024-07-18T00:19:33.033" v="758"/>
          <ac:grpSpMkLst>
            <pc:docMk/>
            <pc:sldMk cId="2427404617" sldId="267"/>
            <ac:grpSpMk id="39" creationId="{87AC6C5B-AB83-A925-AA08-537043C3F8B2}"/>
          </ac:grpSpMkLst>
        </pc:grpChg>
        <pc:picChg chg="add del mod">
          <ac:chgData name="Ito, Shigeaki" userId="9738649d-cd64-434d-883a-bc64ce9afd08" providerId="ADAL" clId="{3C05D16F-B2F9-4026-9A1E-DCB0B627E319}" dt="2024-07-18T00:19:32.734" v="757" actId="478"/>
          <ac:picMkLst>
            <pc:docMk/>
            <pc:sldMk cId="2427404617" sldId="267"/>
            <ac:picMk id="4" creationId="{BC7012C0-67D6-0E11-29B7-E8A86B7A7A21}"/>
          </ac:picMkLst>
        </pc:picChg>
        <pc:picChg chg="add mod">
          <ac:chgData name="Ito, Shigeaki" userId="9738649d-cd64-434d-883a-bc64ce9afd08" providerId="ADAL" clId="{3C05D16F-B2F9-4026-9A1E-DCB0B627E319}" dt="2024-07-18T00:19:33.033" v="758"/>
          <ac:picMkLst>
            <pc:docMk/>
            <pc:sldMk cId="2427404617" sldId="267"/>
            <ac:picMk id="35" creationId="{9DA495CD-32DA-016A-213A-26A95AB78511}"/>
          </ac:picMkLst>
        </pc:picChg>
        <pc:picChg chg="add mod">
          <ac:chgData name="Ito, Shigeaki" userId="9738649d-cd64-434d-883a-bc64ce9afd08" providerId="ADAL" clId="{3C05D16F-B2F9-4026-9A1E-DCB0B627E319}" dt="2024-11-06T04:02:57.027" v="1101" actId="1076"/>
          <ac:picMkLst>
            <pc:docMk/>
            <pc:sldMk cId="2427404617" sldId="267"/>
            <ac:picMk id="46" creationId="{5BB09E00-A550-D1B8-30CA-10877410F479}"/>
          </ac:picMkLst>
        </pc:picChg>
        <pc:cxnChg chg="add mod">
          <ac:chgData name="Ito, Shigeaki" userId="9738649d-cd64-434d-883a-bc64ce9afd08" providerId="ADAL" clId="{3C05D16F-B2F9-4026-9A1E-DCB0B627E319}" dt="2024-07-18T00:19:33.033" v="758"/>
          <ac:cxnSpMkLst>
            <pc:docMk/>
            <pc:sldMk cId="2427404617" sldId="267"/>
            <ac:cxnSpMk id="6" creationId="{6AD71097-1F1A-B9C3-EA83-C52F2FD09B30}"/>
          </ac:cxnSpMkLst>
        </pc:cxnChg>
      </pc:sldChg>
      <pc:sldChg chg="addSp delSp modSp new mod">
        <pc:chgData name="Ito, Shigeaki" userId="9738649d-cd64-434d-883a-bc64ce9afd08" providerId="ADAL" clId="{3C05D16F-B2F9-4026-9A1E-DCB0B627E319}" dt="2024-11-06T04:04:30.123" v="1154" actId="20577"/>
        <pc:sldMkLst>
          <pc:docMk/>
          <pc:sldMk cId="2373478912" sldId="268"/>
        </pc:sldMkLst>
        <pc:spChg chg="del">
          <ac:chgData name="Ito, Shigeaki" userId="9738649d-cd64-434d-883a-bc64ce9afd08" providerId="ADAL" clId="{3C05D16F-B2F9-4026-9A1E-DCB0B627E319}" dt="2024-07-02T05:52:23.308" v="300" actId="478"/>
          <ac:spMkLst>
            <pc:docMk/>
            <pc:sldMk cId="2373478912" sldId="268"/>
            <ac:spMk id="2" creationId="{2B52AAC9-EE80-9BFB-4493-D3DBA5C275FC}"/>
          </ac:spMkLst>
        </pc:spChg>
        <pc:spChg chg="del">
          <ac:chgData name="Ito, Shigeaki" userId="9738649d-cd64-434d-883a-bc64ce9afd08" providerId="ADAL" clId="{3C05D16F-B2F9-4026-9A1E-DCB0B627E319}" dt="2024-07-02T05:50:06.603" v="283" actId="478"/>
          <ac:spMkLst>
            <pc:docMk/>
            <pc:sldMk cId="2373478912" sldId="268"/>
            <ac:spMk id="3" creationId="{01E905A2-C125-9600-269B-5BF7C66EC4C2}"/>
          </ac:spMkLst>
        </pc:spChg>
        <pc:spChg chg="add mod">
          <ac:chgData name="Ito, Shigeaki" userId="9738649d-cd64-434d-883a-bc64ce9afd08" providerId="ADAL" clId="{3C05D16F-B2F9-4026-9A1E-DCB0B627E319}" dt="2024-11-06T04:04:30.123" v="1154" actId="20577"/>
          <ac:spMkLst>
            <pc:docMk/>
            <pc:sldMk cId="2373478912" sldId="268"/>
            <ac:spMk id="3" creationId="{AAC7ADA7-354B-7D51-C803-DD9F789D7F54}"/>
          </ac:spMkLst>
        </pc:spChg>
        <pc:picChg chg="add mod">
          <ac:chgData name="Ito, Shigeaki" userId="9738649d-cd64-434d-883a-bc64ce9afd08" providerId="ADAL" clId="{3C05D16F-B2F9-4026-9A1E-DCB0B627E319}" dt="2024-07-18T00:13:10.844" v="654" actId="1076"/>
          <ac:picMkLst>
            <pc:docMk/>
            <pc:sldMk cId="2373478912" sldId="268"/>
            <ac:picMk id="2" creationId="{6636267D-412B-8324-DCF8-C832684F35B3}"/>
          </ac:picMkLst>
        </pc:picChg>
        <pc:picChg chg="add del mod">
          <ac:chgData name="Ito, Shigeaki" userId="9738649d-cd64-434d-883a-bc64ce9afd08" providerId="ADAL" clId="{3C05D16F-B2F9-4026-9A1E-DCB0B627E319}" dt="2024-07-02T05:52:08.511" v="295" actId="478"/>
          <ac:picMkLst>
            <pc:docMk/>
            <pc:sldMk cId="2373478912" sldId="268"/>
            <ac:picMk id="4" creationId="{5CAC9C83-27C5-40BF-84CA-04ADD10C6ADF}"/>
          </ac:picMkLst>
        </pc:picChg>
        <pc:picChg chg="add del mod">
          <ac:chgData name="Ito, Shigeaki" userId="9738649d-cd64-434d-883a-bc64ce9afd08" providerId="ADAL" clId="{3C05D16F-B2F9-4026-9A1E-DCB0B627E319}" dt="2024-07-18T00:13:07.026" v="652" actId="478"/>
          <ac:picMkLst>
            <pc:docMk/>
            <pc:sldMk cId="2373478912" sldId="268"/>
            <ac:picMk id="5" creationId="{38C8410B-B3D0-C986-D432-567C8B8FCFC7}"/>
          </ac:picMkLst>
        </pc:picChg>
      </pc:sldChg>
      <pc:sldChg chg="addSp delSp modSp new mod">
        <pc:chgData name="Ito, Shigeaki" userId="9738649d-cd64-434d-883a-bc64ce9afd08" providerId="ADAL" clId="{3C05D16F-B2F9-4026-9A1E-DCB0B627E319}" dt="2024-11-06T04:05:36.424" v="1174"/>
        <pc:sldMkLst>
          <pc:docMk/>
          <pc:sldMk cId="2255666082" sldId="269"/>
        </pc:sldMkLst>
        <pc:spChg chg="add mod">
          <ac:chgData name="Ito, Shigeaki" userId="9738649d-cd64-434d-883a-bc64ce9afd08" providerId="ADAL" clId="{3C05D16F-B2F9-4026-9A1E-DCB0B627E319}" dt="2024-11-06T04:05:36.424" v="1174"/>
          <ac:spMkLst>
            <pc:docMk/>
            <pc:sldMk cId="2255666082" sldId="269"/>
            <ac:spMk id="2" creationId="{400EDC83-8240-6272-7B86-A2D60EB9FD3C}"/>
          </ac:spMkLst>
        </pc:spChg>
        <pc:spChg chg="add 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2" creationId="{B8D3786C-BCC8-CE4C-959B-51A6FED99E19}"/>
          </ac:spMkLst>
        </pc:spChg>
        <pc:spChg chg="add del">
          <ac:chgData name="Ito, Shigeaki" userId="9738649d-cd64-434d-883a-bc64ce9afd08" providerId="ADAL" clId="{3C05D16F-B2F9-4026-9A1E-DCB0B627E319}" dt="2024-07-02T05:58:46.055" v="367" actId="478"/>
          <ac:spMkLst>
            <pc:docMk/>
            <pc:sldMk cId="2255666082" sldId="269"/>
            <ac:spMk id="2" creationId="{BBBEF0FA-D49F-BF7A-1EAB-E5E9C75B55D8}"/>
          </ac:spMkLst>
        </pc:spChg>
        <pc:spChg chg="add del">
          <ac:chgData name="Ito, Shigeaki" userId="9738649d-cd64-434d-883a-bc64ce9afd08" providerId="ADAL" clId="{3C05D16F-B2F9-4026-9A1E-DCB0B627E319}" dt="2024-07-02T05:58:42.130" v="366" actId="478"/>
          <ac:spMkLst>
            <pc:docMk/>
            <pc:sldMk cId="2255666082" sldId="269"/>
            <ac:spMk id="3" creationId="{F1AEBF43-1673-E195-C727-E149890AB276}"/>
          </ac:spMkLst>
        </pc:spChg>
        <pc:spChg chg="add 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4" creationId="{8C815081-D742-E648-2DFA-F28409C6C91D}"/>
          </ac:spMkLst>
        </pc:spChg>
        <pc:spChg chg="add 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4" creationId="{F0614E49-B230-B58B-B903-EB46719F43F1}"/>
          </ac:spMkLst>
        </pc:spChg>
        <pc:spChg chg="add 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5" creationId="{4A1B7844-CB7D-6EC0-A14A-A9984D85BC1C}"/>
          </ac:spMkLst>
        </pc:spChg>
        <pc:spChg chg="add 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5" creationId="{D6251947-1D06-F42A-372F-D672616799B6}"/>
          </ac:spMkLst>
        </pc:spChg>
        <pc:spChg chg="add 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6" creationId="{F71379AE-C09E-1B4F-849C-99E6757829B3}"/>
          </ac:spMkLst>
        </pc:spChg>
        <pc:spChg chg="add 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7" creationId="{ABCC74EE-6D96-56A5-7511-EF0FDFC4FAF3}"/>
          </ac:spMkLst>
        </pc:spChg>
        <pc:spChg chg="add 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8" creationId="{078124B7-9AD3-DF3B-AF34-8D11CD995954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9" creationId="{29F893CD-5092-ACFD-1C78-4DC262341D98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10" creationId="{0E3FE6D5-14C0-E93A-76FB-334313953BB9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10" creationId="{B0D3FC70-27DF-D9FB-DA0B-AC9C7DB2FB2D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11" creationId="{5900DD81-DAF0-9865-2C3D-B0F337FFA340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11" creationId="{9FF2024F-6327-9521-344D-9270920E9A41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12" creationId="{CD507A65-3949-B285-6472-63CCCDB522C8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12" creationId="{DD0C8E24-C08B-79F9-0F68-52A09932FCDF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13" creationId="{450090F0-BA08-3358-BEE3-22A9221D3A8D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13" creationId="{BEFA1F82-F9BB-41ED-6877-CF03F89A4FF0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14" creationId="{40B0924C-1A45-0D51-EBE6-05375B39C2E7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14" creationId="{B882B432-CF16-6CA9-8240-B34DEFAA6FF6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15" creationId="{A909D8C6-334C-EDD1-0634-AE8221D120EC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15" creationId="{C75C240B-9FF8-843E-1FB7-5AF35E9FF192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16" creationId="{D3195A21-298B-478B-73DB-7FBDD6A8DF15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16" creationId="{DAE8C20C-C698-D898-0932-2BE8874AAFD0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17" creationId="{6584E9C8-1EDD-38BE-CFCF-EE2172B7AA6A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17" creationId="{D9958155-234A-718E-17AF-A790E56FA001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18" creationId="{0A30937A-EC77-89F8-6246-3B4CC8924975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18" creationId="{C79FB7A0-C5BE-8B86-C085-37E5B1FFACD4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19" creationId="{2E8D0D5C-AD44-1208-B9A1-AC884CBBE538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19" creationId="{D1E93979-0D3B-8414-1FC4-C14C8884D13D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20" creationId="{B94C1E05-7563-B257-ED5B-A97585AFD21D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20" creationId="{F101FCDE-724D-18AF-14B2-049F416E0EEE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21" creationId="{2EA6C392-56DC-EC9F-797A-E7F94968594F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21" creationId="{FB665B4C-5FF6-5DD1-9B72-01998247A69C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22" creationId="{5C3AF0EF-4590-1D9A-A6E4-1D10C4BAFD7A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22" creationId="{5C4BF17F-C2BD-28E6-3C29-862382A5A991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23" creationId="{69434A96-6CD9-842A-8E87-4F3A3107AB7B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23" creationId="{89C96FCE-00F1-FB93-D5AD-916D0B8E891D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24" creationId="{14A00132-9A48-C09C-C927-A8AB9C559F6A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24" creationId="{F9180771-D2A9-2254-59B9-67A710297BA3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25" creationId="{924CA60D-942E-9984-C775-6837822F9B9B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25" creationId="{B8412D3C-CE6E-4456-0BB9-2E14C9A15175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26" creationId="{394BF7C0-5524-AB4A-03A3-A834DD26C39B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26" creationId="{7E12A680-2E9E-9D1B-4D78-FEBAE9057E10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27" creationId="{7F881A06-4F7D-FBD3-B409-6549B954AA62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27" creationId="{B38EC2A4-FDB8-77AD-D249-FA1C2C8FBF2F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28" creationId="{588D8B9A-8666-4125-F4B6-EDB47F2EA0EF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28" creationId="{B528BE6B-8D7A-F7EC-E1A1-8E9E12D591D7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29" creationId="{4B9C6543-A1AE-E03B-665F-088B9ADEE526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29" creationId="{A6E29D51-A958-4D50-8339-45519F5686D1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30" creationId="{0AD99046-C1D1-A358-C656-4EB26181C5B4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30" creationId="{C6662BDC-B187-397A-5817-C8D9967737C1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31" creationId="{97CB7000-263A-E3E8-B3AE-19BD882BFF13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31" creationId="{DC11C6B9-01B5-A55B-A840-A9AB10FFE988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32" creationId="{09BB20E0-B2F4-47C1-447C-290492D2F005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32" creationId="{EF4F3289-7F64-31F4-91E1-B2BFE2044B6A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33" creationId="{0638A547-6DC9-64E2-8287-934BDB405146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33" creationId="{A10E597D-4536-C4FF-10E8-EE8DB0CFB0C7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34" creationId="{2BD62ACA-3799-8210-1B0D-A26B5EC13EF9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34" creationId="{EA2FF873-94F1-96B6-41DF-E9F9AD60929A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35" creationId="{4A33AAA1-6536-3683-3E0B-182E1BD08773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36" creationId="{AF4BFA42-67E2-4CEE-2EC7-9B9E36F4FF7D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37" creationId="{F328338B-86DC-6477-C437-95980C7E050B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38" creationId="{3C4D0D2E-FF80-0EC9-21AE-C706D65A83F3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38" creationId="{9AACA195-BD0C-ED6E-EFD1-D97667CD3133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39" creationId="{1DE75333-41A4-F50C-FEB4-D69D176C822E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39" creationId="{6B869CBA-98BA-D5C5-A11E-A575EAF11E70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40" creationId="{3031E6F6-0A95-9DCF-02BC-9E7F06448FB4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40" creationId="{F8EA4001-51B0-656D-13D5-6C26C7F8307F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41" creationId="{5410BFD2-7D20-9F85-5E58-4B303203BD73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41" creationId="{ECF6EA6F-E97B-F239-EEC3-7A6DFA1B15A3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42" creationId="{ABAA3252-18E1-9AA6-F9B5-357F635D747D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43" creationId="{020B807B-435C-F61F-0ABC-2FE685BCB966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43" creationId="{45A83528-1F01-F513-A61F-10D3C403E884}"/>
          </ac:spMkLst>
        </pc:spChg>
        <pc:spChg chg="mod">
          <ac:chgData name="Ito, Shigeaki" userId="9738649d-cd64-434d-883a-bc64ce9afd08" providerId="ADAL" clId="{3C05D16F-B2F9-4026-9A1E-DCB0B627E319}" dt="2024-07-18T00:14:30.354" v="674"/>
          <ac:spMkLst>
            <pc:docMk/>
            <pc:sldMk cId="2255666082" sldId="269"/>
            <ac:spMk id="44" creationId="{17EB5091-2287-E3EA-7DD6-C6B8F14C968E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45" creationId="{ABB093AC-9507-A9FA-8DCA-FBF8D398C2DB}"/>
          </ac:spMkLst>
        </pc:spChg>
        <pc:spChg chg="mod">
          <ac:chgData name="Ito, Shigeaki" userId="9738649d-cd64-434d-883a-bc64ce9afd08" providerId="ADAL" clId="{3C05D16F-B2F9-4026-9A1E-DCB0B627E319}" dt="2024-07-02T05:58:30.193" v="361"/>
          <ac:spMkLst>
            <pc:docMk/>
            <pc:sldMk cId="2255666082" sldId="269"/>
            <ac:spMk id="46" creationId="{B8DBF758-02AA-FA2C-F1B5-C53FCFEC02D3}"/>
          </ac:spMkLst>
        </pc:spChg>
        <pc:grpChg chg="add mod">
          <ac:chgData name="Ito, Shigeaki" userId="9738649d-cd64-434d-883a-bc64ce9afd08" providerId="ADAL" clId="{3C05D16F-B2F9-4026-9A1E-DCB0B627E319}" dt="2024-07-18T00:14:30.354" v="674"/>
          <ac:grpSpMkLst>
            <pc:docMk/>
            <pc:sldMk cId="2255666082" sldId="269"/>
            <ac:grpSpMk id="8" creationId="{6B5A8293-541F-9E6B-14A2-5879CCB27AA7}"/>
          </ac:grpSpMkLst>
        </pc:grpChg>
        <pc:grpChg chg="add mod">
          <ac:chgData name="Ito, Shigeaki" userId="9738649d-cd64-434d-883a-bc64ce9afd08" providerId="ADAL" clId="{3C05D16F-B2F9-4026-9A1E-DCB0B627E319}" dt="2024-07-02T05:58:30.193" v="361"/>
          <ac:grpSpMkLst>
            <pc:docMk/>
            <pc:sldMk cId="2255666082" sldId="269"/>
            <ac:grpSpMk id="9" creationId="{868562CA-29F9-C6A4-D213-1F635A0D504D}"/>
          </ac:grpSpMkLst>
        </pc:grpChg>
        <pc:grpChg chg="add mod">
          <ac:chgData name="Ito, Shigeaki" userId="9738649d-cd64-434d-883a-bc64ce9afd08" providerId="ADAL" clId="{3C05D16F-B2F9-4026-9A1E-DCB0B627E319}" dt="2024-07-18T00:14:30.354" v="674"/>
          <ac:grpSpMkLst>
            <pc:docMk/>
            <pc:sldMk cId="2255666082" sldId="269"/>
            <ac:grpSpMk id="35" creationId="{38A8A54C-1DCE-39B8-FFA3-D275169A6FA2}"/>
          </ac:grpSpMkLst>
        </pc:grpChg>
        <pc:grpChg chg="add mod">
          <ac:chgData name="Ito, Shigeaki" userId="9738649d-cd64-434d-883a-bc64ce9afd08" providerId="ADAL" clId="{3C05D16F-B2F9-4026-9A1E-DCB0B627E319}" dt="2024-07-02T05:58:30.193" v="361"/>
          <ac:grpSpMkLst>
            <pc:docMk/>
            <pc:sldMk cId="2255666082" sldId="269"/>
            <ac:grpSpMk id="37" creationId="{33A1EDED-1064-F9B8-AFD7-135420E7AA7B}"/>
          </ac:grpSpMkLst>
        </pc:grpChg>
        <pc:grpChg chg="add mod">
          <ac:chgData name="Ito, Shigeaki" userId="9738649d-cd64-434d-883a-bc64ce9afd08" providerId="ADAL" clId="{3C05D16F-B2F9-4026-9A1E-DCB0B627E319}" dt="2024-07-18T00:14:30.354" v="674"/>
          <ac:grpSpMkLst>
            <pc:docMk/>
            <pc:sldMk cId="2255666082" sldId="269"/>
            <ac:grpSpMk id="42" creationId="{0CE5A1A5-B7A4-17E0-49A1-9EC3F3F6D4A9}"/>
          </ac:grpSpMkLst>
        </pc:grpChg>
        <pc:grpChg chg="add mod">
          <ac:chgData name="Ito, Shigeaki" userId="9738649d-cd64-434d-883a-bc64ce9afd08" providerId="ADAL" clId="{3C05D16F-B2F9-4026-9A1E-DCB0B627E319}" dt="2024-07-02T05:58:30.193" v="361"/>
          <ac:grpSpMkLst>
            <pc:docMk/>
            <pc:sldMk cId="2255666082" sldId="269"/>
            <ac:grpSpMk id="44" creationId="{B27E8F49-D596-BB58-C0E3-6C96A9FAE5E2}"/>
          </ac:grpSpMkLst>
        </pc:grpChg>
        <pc:picChg chg="add mod">
          <ac:chgData name="Ito, Shigeaki" userId="9738649d-cd64-434d-883a-bc64ce9afd08" providerId="ADAL" clId="{3C05D16F-B2F9-4026-9A1E-DCB0B627E319}" dt="2024-07-18T00:14:30.354" v="674"/>
          <ac:picMkLst>
            <pc:docMk/>
            <pc:sldMk cId="2255666082" sldId="269"/>
            <ac:picMk id="3" creationId="{58D1F64F-70E6-5F99-0E64-6397C81602F7}"/>
          </ac:picMkLst>
        </pc:picChg>
        <pc:picChg chg="add mod">
          <ac:chgData name="Ito, Shigeaki" userId="9738649d-cd64-434d-883a-bc64ce9afd08" providerId="ADAL" clId="{3C05D16F-B2F9-4026-9A1E-DCB0B627E319}" dt="2024-07-02T05:58:30.193" v="361"/>
          <ac:picMkLst>
            <pc:docMk/>
            <pc:sldMk cId="2255666082" sldId="269"/>
            <ac:picMk id="36" creationId="{2DBD873B-6E1F-33C6-99BF-34DD34B86606}"/>
          </ac:picMkLst>
        </pc:picChg>
        <pc:picChg chg="add mod">
          <ac:chgData name="Ito, Shigeaki" userId="9738649d-cd64-434d-883a-bc64ce9afd08" providerId="ADAL" clId="{3C05D16F-B2F9-4026-9A1E-DCB0B627E319}" dt="2024-07-18T00:14:35.223" v="676" actId="1076"/>
          <ac:picMkLst>
            <pc:docMk/>
            <pc:sldMk cId="2255666082" sldId="269"/>
            <ac:picMk id="45" creationId="{772BF419-68BF-CF2A-8207-CD18B38198C3}"/>
          </ac:picMkLst>
        </pc:picChg>
        <pc:picChg chg="add del mod">
          <ac:chgData name="Ito, Shigeaki" userId="9738649d-cd64-434d-883a-bc64ce9afd08" providerId="ADAL" clId="{3C05D16F-B2F9-4026-9A1E-DCB0B627E319}" dt="2024-07-18T00:14:30.040" v="673" actId="478"/>
          <ac:picMkLst>
            <pc:docMk/>
            <pc:sldMk cId="2255666082" sldId="269"/>
            <ac:picMk id="47" creationId="{A8B1FE2C-DCB5-8EB4-A200-4FF526FA263A}"/>
          </ac:picMkLst>
        </pc:picChg>
        <pc:cxnChg chg="add mod">
          <ac:chgData name="Ito, Shigeaki" userId="9738649d-cd64-434d-883a-bc64ce9afd08" providerId="ADAL" clId="{3C05D16F-B2F9-4026-9A1E-DCB0B627E319}" dt="2024-07-18T00:14:30.354" v="674"/>
          <ac:cxnSpMkLst>
            <pc:docMk/>
            <pc:sldMk cId="2255666082" sldId="269"/>
            <ac:cxnSpMk id="6" creationId="{CC8DD762-D317-1DF8-101D-C134C9A9F822}"/>
          </ac:cxnSpMkLst>
        </pc:cxnChg>
        <pc:cxnChg chg="add mod">
          <ac:chgData name="Ito, Shigeaki" userId="9738649d-cd64-434d-883a-bc64ce9afd08" providerId="ADAL" clId="{3C05D16F-B2F9-4026-9A1E-DCB0B627E319}" dt="2024-07-02T05:58:30.193" v="361"/>
          <ac:cxnSpMkLst>
            <pc:docMk/>
            <pc:sldMk cId="2255666082" sldId="269"/>
            <ac:cxnSpMk id="7" creationId="{44281388-E5F5-09A4-C6CF-B08D699C7722}"/>
          </ac:cxnSpMkLst>
        </pc:cxnChg>
      </pc:sldChg>
      <pc:sldChg chg="addSp delSp modSp new mod">
        <pc:chgData name="Ito, Shigeaki" userId="9738649d-cd64-434d-883a-bc64ce9afd08" providerId="ADAL" clId="{3C05D16F-B2F9-4026-9A1E-DCB0B627E319}" dt="2024-11-06T04:06:36.335" v="1286" actId="6549"/>
        <pc:sldMkLst>
          <pc:docMk/>
          <pc:sldMk cId="2395875036" sldId="270"/>
        </pc:sldMkLst>
        <pc:spChg chg="add mod">
          <ac:chgData name="Ito, Shigeaki" userId="9738649d-cd64-434d-883a-bc64ce9afd08" providerId="ADAL" clId="{3C05D16F-B2F9-4026-9A1E-DCB0B627E319}" dt="2024-11-06T04:06:36.335" v="1286" actId="6549"/>
          <ac:spMkLst>
            <pc:docMk/>
            <pc:sldMk cId="2395875036" sldId="270"/>
            <ac:spMk id="2" creationId="{88C45FDA-5FE9-5E5C-3A0F-921FE9EC3A2B}"/>
          </ac:spMkLst>
        </pc:spChg>
        <pc:spChg chg="del">
          <ac:chgData name="Ito, Shigeaki" userId="9738649d-cd64-434d-883a-bc64ce9afd08" providerId="ADAL" clId="{3C05D16F-B2F9-4026-9A1E-DCB0B627E319}" dt="2024-07-18T00:16:23.954" v="721" actId="478"/>
          <ac:spMkLst>
            <pc:docMk/>
            <pc:sldMk cId="2395875036" sldId="270"/>
            <ac:spMk id="2" creationId="{CD2141E6-C7C3-D153-5E98-8A7339B16206}"/>
          </ac:spMkLst>
        </pc:spChg>
        <pc:spChg chg="del">
          <ac:chgData name="Ito, Shigeaki" userId="9738649d-cd64-434d-883a-bc64ce9afd08" providerId="ADAL" clId="{3C05D16F-B2F9-4026-9A1E-DCB0B627E319}" dt="2024-07-18T00:16:23.954" v="721" actId="478"/>
          <ac:spMkLst>
            <pc:docMk/>
            <pc:sldMk cId="2395875036" sldId="270"/>
            <ac:spMk id="3" creationId="{C6379E79-DC33-A561-A880-711612E4917C}"/>
          </ac:spMkLst>
        </pc:spChg>
        <pc:spChg chg="add 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4" creationId="{87E34477-7276-515E-61E0-A17C7A7A6792}"/>
          </ac:spMkLst>
        </pc:spChg>
        <pc:spChg chg="add 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5" creationId="{39FCCFDC-D4BC-FE44-6616-126F07F19C72}"/>
          </ac:spMkLst>
        </pc:spChg>
        <pc:spChg chg="add 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6" creationId="{8DBEC72D-483C-D8C3-F1FA-B2475BC70C6E}"/>
          </ac:spMkLst>
        </pc:spChg>
        <pc:spChg chg="add 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8" creationId="{3EC4DA03-3747-DC13-2057-964B74F94ECA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10" creationId="{B24AE70E-60FA-6302-C638-50E9FF264B09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11" creationId="{4414D5DA-7D86-5130-9B62-0249D8516B16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12" creationId="{DF66F5FE-5840-0438-C77A-AECE66D200FA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13" creationId="{152E2648-06FC-1C68-835A-969DD9CD35F9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14" creationId="{2CD20897-7D37-AD95-D73F-895845D2D98C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15" creationId="{E49A893A-76F6-3FD6-4773-7C4F5AC6954F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16" creationId="{B8FF1E52-023B-CCD2-23D9-D1D9928845F4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17" creationId="{70697029-D858-2FD3-D3D2-E45C5EB67E34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18" creationId="{3AA24D33-6317-8D71-CC90-2E661C40E21E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19" creationId="{E3442774-706F-AC7D-B258-C5BB705B8E0F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20" creationId="{646360B0-F175-2FFB-7BB8-C1C019990AA9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21" creationId="{61F98E00-C5F4-D351-CB93-E94743C12F22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22" creationId="{D6A91AE7-7D10-346C-4B55-29E989A2BF63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23" creationId="{A51E2C6C-B9F0-59BE-7F97-57693121FD4F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24" creationId="{780DFC4B-C9F3-2EB0-9403-24A06D8806C2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25" creationId="{B683EAF1-2EF8-B89F-A235-935C23BAF66F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26" creationId="{F9CCA060-FB39-2189-D2C1-91E5426DAC74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27" creationId="{F3DD1CE6-C57B-1E3F-FEEC-DD476A5359DD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28" creationId="{6C9E58D9-B2BF-F0BD-2ABE-E2EE5FDCAD2B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29" creationId="{E7C563CD-9403-8F22-5838-AAD4BEAF7E2D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30" creationId="{6C479BB3-CB88-CE1B-6E82-AAD4924EE019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31" creationId="{DD58569A-C54B-CB26-1C90-B6C6B5135455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32" creationId="{7A71A5AC-A85B-AF10-882A-813A29724893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33" creationId="{3639FA8B-36E7-E641-903A-57C6AB2F67E4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34" creationId="{E09FA85F-7B94-C1F9-3C5A-EA39A1B76771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35" creationId="{9A265A0B-84CB-E230-8D0B-5FF17A135BDD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38" creationId="{8AEF8DF8-1ACF-EE26-3A4E-768C6B7E8345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39" creationId="{446F3E6B-0569-E532-A204-37A305216E47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41" creationId="{AEFF7B9A-02E2-A71C-50F8-BFD8F21B0F5A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42" creationId="{316C8A7D-A828-9252-44F5-05B3B5FB6D7A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43" creationId="{4D19F098-3A10-5326-74A1-DCCF777C30F8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44" creationId="{9A9B10E3-BE3A-64AE-F571-43D7E8A4AB7C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45" creationId="{2CB75DDC-6217-8452-DD65-2992D8C9E07C}"/>
          </ac:spMkLst>
        </pc:spChg>
        <pc:spChg chg="mod">
          <ac:chgData name="Ito, Shigeaki" userId="9738649d-cd64-434d-883a-bc64ce9afd08" providerId="ADAL" clId="{3C05D16F-B2F9-4026-9A1E-DCB0B627E319}" dt="2024-07-02T06:15:08.713" v="399"/>
          <ac:spMkLst>
            <pc:docMk/>
            <pc:sldMk cId="2395875036" sldId="270"/>
            <ac:spMk id="46" creationId="{03E36BAB-3BB1-196C-B062-CFC88A98584D}"/>
          </ac:spMkLst>
        </pc:spChg>
        <pc:grpChg chg="add mod">
          <ac:chgData name="Ito, Shigeaki" userId="9738649d-cd64-434d-883a-bc64ce9afd08" providerId="ADAL" clId="{3C05D16F-B2F9-4026-9A1E-DCB0B627E319}" dt="2024-07-02T06:15:08.713" v="399"/>
          <ac:grpSpMkLst>
            <pc:docMk/>
            <pc:sldMk cId="2395875036" sldId="270"/>
            <ac:grpSpMk id="9" creationId="{D10A64B2-2822-CE19-84DF-8CDFA617822B}"/>
          </ac:grpSpMkLst>
        </pc:grpChg>
        <pc:grpChg chg="add mod">
          <ac:chgData name="Ito, Shigeaki" userId="9738649d-cd64-434d-883a-bc64ce9afd08" providerId="ADAL" clId="{3C05D16F-B2F9-4026-9A1E-DCB0B627E319}" dt="2024-07-02T06:15:08.713" v="399"/>
          <ac:grpSpMkLst>
            <pc:docMk/>
            <pc:sldMk cId="2395875036" sldId="270"/>
            <ac:grpSpMk id="37" creationId="{D6760167-A47B-B893-EF2D-B51AD40A9CE9}"/>
          </ac:grpSpMkLst>
        </pc:grpChg>
        <pc:grpChg chg="add mod">
          <ac:chgData name="Ito, Shigeaki" userId="9738649d-cd64-434d-883a-bc64ce9afd08" providerId="ADAL" clId="{3C05D16F-B2F9-4026-9A1E-DCB0B627E319}" dt="2024-07-02T06:15:08.713" v="399"/>
          <ac:grpSpMkLst>
            <pc:docMk/>
            <pc:sldMk cId="2395875036" sldId="270"/>
            <ac:grpSpMk id="40" creationId="{6E872ECC-9F02-8C93-733E-D7075ECA5310}"/>
          </ac:grpSpMkLst>
        </pc:grpChg>
        <pc:picChg chg="add mod">
          <ac:chgData name="Ito, Shigeaki" userId="9738649d-cd64-434d-883a-bc64ce9afd08" providerId="ADAL" clId="{3C05D16F-B2F9-4026-9A1E-DCB0B627E319}" dt="2024-11-06T04:03:11.459" v="1103" actId="1076"/>
          <ac:picMkLst>
            <pc:docMk/>
            <pc:sldMk cId="2395875036" sldId="270"/>
            <ac:picMk id="4" creationId="{463188BD-8918-8CD9-1454-4537390385D8}"/>
          </ac:picMkLst>
        </pc:picChg>
        <pc:picChg chg="add mod">
          <ac:chgData name="Ito, Shigeaki" userId="9738649d-cd64-434d-883a-bc64ce9afd08" providerId="ADAL" clId="{3C05D16F-B2F9-4026-9A1E-DCB0B627E319}" dt="2024-07-02T06:15:08.713" v="399"/>
          <ac:picMkLst>
            <pc:docMk/>
            <pc:sldMk cId="2395875036" sldId="270"/>
            <ac:picMk id="36" creationId="{7826E874-39AD-2F0D-6B1D-A8084718708B}"/>
          </ac:picMkLst>
        </pc:picChg>
        <pc:picChg chg="add del mod">
          <ac:chgData name="Ito, Shigeaki" userId="9738649d-cd64-434d-883a-bc64ce9afd08" providerId="ADAL" clId="{3C05D16F-B2F9-4026-9A1E-DCB0B627E319}" dt="2024-07-18T00:16:21.076" v="720" actId="478"/>
          <ac:picMkLst>
            <pc:docMk/>
            <pc:sldMk cId="2395875036" sldId="270"/>
            <ac:picMk id="47" creationId="{67D91B87-B1C4-F991-C407-A5C5EC98558F}"/>
          </ac:picMkLst>
        </pc:picChg>
        <pc:cxnChg chg="add mod">
          <ac:chgData name="Ito, Shigeaki" userId="9738649d-cd64-434d-883a-bc64ce9afd08" providerId="ADAL" clId="{3C05D16F-B2F9-4026-9A1E-DCB0B627E319}" dt="2024-07-02T06:15:08.713" v="399"/>
          <ac:cxnSpMkLst>
            <pc:docMk/>
            <pc:sldMk cId="2395875036" sldId="270"/>
            <ac:cxnSpMk id="7" creationId="{ACD3CF83-9D79-7FF3-C626-671434D14467}"/>
          </ac:cxnSpMkLst>
        </pc:cxnChg>
      </pc:sldChg>
      <pc:sldChg chg="addSp delSp modSp new mod">
        <pc:chgData name="Ito, Shigeaki" userId="9738649d-cd64-434d-883a-bc64ce9afd08" providerId="ADAL" clId="{3C05D16F-B2F9-4026-9A1E-DCB0B627E319}" dt="2024-11-06T04:00:35.690" v="1020"/>
        <pc:sldMkLst>
          <pc:docMk/>
          <pc:sldMk cId="3356382790" sldId="271"/>
        </pc:sldMkLst>
        <pc:spChg chg="add mod">
          <ac:chgData name="Ito, Shigeaki" userId="9738649d-cd64-434d-883a-bc64ce9afd08" providerId="ADAL" clId="{3C05D16F-B2F9-4026-9A1E-DCB0B627E319}" dt="2024-11-06T04:00:35.690" v="1020"/>
          <ac:spMkLst>
            <pc:docMk/>
            <pc:sldMk cId="3356382790" sldId="271"/>
            <ac:spMk id="2" creationId="{1E649B4C-3D98-56EE-6BE1-FD3CB5A06C1E}"/>
          </ac:spMkLst>
        </pc:spChg>
        <pc:spChg chg="del">
          <ac:chgData name="Ito, Shigeaki" userId="9738649d-cd64-434d-883a-bc64ce9afd08" providerId="ADAL" clId="{3C05D16F-B2F9-4026-9A1E-DCB0B627E319}" dt="2024-07-02T06:23:22.202" v="405" actId="478"/>
          <ac:spMkLst>
            <pc:docMk/>
            <pc:sldMk cId="3356382790" sldId="271"/>
            <ac:spMk id="2" creationId="{8AE74B78-5004-BF97-9B9F-C88536DCAD7E}"/>
          </ac:spMkLst>
        </pc:spChg>
        <pc:spChg chg="del">
          <ac:chgData name="Ito, Shigeaki" userId="9738649d-cd64-434d-883a-bc64ce9afd08" providerId="ADAL" clId="{3C05D16F-B2F9-4026-9A1E-DCB0B627E319}" dt="2024-07-02T06:23:22.202" v="405" actId="478"/>
          <ac:spMkLst>
            <pc:docMk/>
            <pc:sldMk cId="3356382790" sldId="271"/>
            <ac:spMk id="3" creationId="{65552A90-D740-29DA-3A60-2A9F264D136B}"/>
          </ac:spMkLst>
        </pc:spChg>
        <pc:picChg chg="add mod modCrop">
          <ac:chgData name="Ito, Shigeaki" userId="9738649d-cd64-434d-883a-bc64ce9afd08" providerId="ADAL" clId="{3C05D16F-B2F9-4026-9A1E-DCB0B627E319}" dt="2024-07-18T00:16:47.371" v="725" actId="14100"/>
          <ac:picMkLst>
            <pc:docMk/>
            <pc:sldMk cId="3356382790" sldId="271"/>
            <ac:picMk id="4" creationId="{72CC1FF3-17AF-E496-771E-8A122999C367}"/>
          </ac:picMkLst>
        </pc:picChg>
        <pc:picChg chg="add del mod">
          <ac:chgData name="Ito, Shigeaki" userId="9738649d-cd64-434d-883a-bc64ce9afd08" providerId="ADAL" clId="{3C05D16F-B2F9-4026-9A1E-DCB0B627E319}" dt="2024-07-02T06:23:46.023" v="417" actId="21"/>
          <ac:picMkLst>
            <pc:docMk/>
            <pc:sldMk cId="3356382790" sldId="271"/>
            <ac:picMk id="5" creationId="{4F52C503-7BC0-0347-3FE3-45EC4E72F7E2}"/>
          </ac:picMkLst>
        </pc:picChg>
      </pc:sldChg>
      <pc:sldChg chg="addSp delSp modSp new mod">
        <pc:chgData name="Ito, Shigeaki" userId="9738649d-cd64-434d-883a-bc64ce9afd08" providerId="ADAL" clId="{3C05D16F-B2F9-4026-9A1E-DCB0B627E319}" dt="2024-07-02T06:24:25.885" v="426" actId="1076"/>
        <pc:sldMkLst>
          <pc:docMk/>
          <pc:sldMk cId="1988480062" sldId="272"/>
        </pc:sldMkLst>
        <pc:spChg chg="del">
          <ac:chgData name="Ito, Shigeaki" userId="9738649d-cd64-434d-883a-bc64ce9afd08" providerId="ADAL" clId="{3C05D16F-B2F9-4026-9A1E-DCB0B627E319}" dt="2024-07-02T06:23:50.042" v="419" actId="478"/>
          <ac:spMkLst>
            <pc:docMk/>
            <pc:sldMk cId="1988480062" sldId="272"/>
            <ac:spMk id="2" creationId="{FEAB99A0-C6A0-DBBD-743C-F8861CCABFFB}"/>
          </ac:spMkLst>
        </pc:spChg>
        <pc:spChg chg="del">
          <ac:chgData name="Ito, Shigeaki" userId="9738649d-cd64-434d-883a-bc64ce9afd08" providerId="ADAL" clId="{3C05D16F-B2F9-4026-9A1E-DCB0B627E319}" dt="2024-07-02T06:23:50.042" v="419" actId="478"/>
          <ac:spMkLst>
            <pc:docMk/>
            <pc:sldMk cId="1988480062" sldId="272"/>
            <ac:spMk id="3" creationId="{749813EA-CFDE-9FF1-76BC-299724A60FC4}"/>
          </ac:spMkLst>
        </pc:spChg>
        <pc:picChg chg="add mod modCrop">
          <ac:chgData name="Ito, Shigeaki" userId="9738649d-cd64-434d-883a-bc64ce9afd08" providerId="ADAL" clId="{3C05D16F-B2F9-4026-9A1E-DCB0B627E319}" dt="2024-07-02T06:24:25.885" v="426" actId="1076"/>
          <ac:picMkLst>
            <pc:docMk/>
            <pc:sldMk cId="1988480062" sldId="272"/>
            <ac:picMk id="5" creationId="{4F52C503-7BC0-0347-3FE3-45EC4E72F7E2}"/>
          </ac:picMkLst>
        </pc:picChg>
      </pc:sldChg>
      <pc:sldChg chg="addSp delSp modSp new mod">
        <pc:chgData name="Ito, Shigeaki" userId="9738649d-cd64-434d-883a-bc64ce9afd08" providerId="ADAL" clId="{3C05D16F-B2F9-4026-9A1E-DCB0B627E319}" dt="2024-11-06T04:03:32.882" v="1111" actId="6549"/>
        <pc:sldMkLst>
          <pc:docMk/>
          <pc:sldMk cId="1175636843" sldId="273"/>
        </pc:sldMkLst>
        <pc:spChg chg="add mod">
          <ac:chgData name="Ito, Shigeaki" userId="9738649d-cd64-434d-883a-bc64ce9afd08" providerId="ADAL" clId="{3C05D16F-B2F9-4026-9A1E-DCB0B627E319}" dt="2024-11-06T04:03:32.882" v="1111" actId="6549"/>
          <ac:spMkLst>
            <pc:docMk/>
            <pc:sldMk cId="1175636843" sldId="273"/>
            <ac:spMk id="2" creationId="{ECBEFE4F-FBF1-FD8D-4746-01774E9AA765}"/>
          </ac:spMkLst>
        </pc:spChg>
        <pc:spChg chg="del">
          <ac:chgData name="Ito, Shigeaki" userId="9738649d-cd64-434d-883a-bc64ce9afd08" providerId="ADAL" clId="{3C05D16F-B2F9-4026-9A1E-DCB0B627E319}" dt="2024-07-18T00:19:58.138" v="761" actId="478"/>
          <ac:spMkLst>
            <pc:docMk/>
            <pc:sldMk cId="1175636843" sldId="273"/>
            <ac:spMk id="2" creationId="{FDA37335-D45B-5F18-8D14-F6DF78883FC8}"/>
          </ac:spMkLst>
        </pc:spChg>
        <pc:spChg chg="del">
          <ac:chgData name="Ito, Shigeaki" userId="9738649d-cd64-434d-883a-bc64ce9afd08" providerId="ADAL" clId="{3C05D16F-B2F9-4026-9A1E-DCB0B627E319}" dt="2024-07-18T00:19:59.259" v="762" actId="478"/>
          <ac:spMkLst>
            <pc:docMk/>
            <pc:sldMk cId="1175636843" sldId="273"/>
            <ac:spMk id="3" creationId="{C1590BB7-CDF9-C26E-7CEC-DF7CF05F406D}"/>
          </ac:spMkLst>
        </pc:spChg>
        <pc:spChg chg="add mod">
          <ac:chgData name="Ito, Shigeaki" userId="9738649d-cd64-434d-883a-bc64ce9afd08" providerId="ADAL" clId="{3C05D16F-B2F9-4026-9A1E-DCB0B627E319}" dt="2024-07-02T06:27:05.574" v="453"/>
          <ac:spMkLst>
            <pc:docMk/>
            <pc:sldMk cId="1175636843" sldId="273"/>
            <ac:spMk id="4" creationId="{B33BFA4D-C743-D24D-6260-A6508C91A19D}"/>
          </ac:spMkLst>
        </pc:spChg>
        <pc:spChg chg="mod">
          <ac:chgData name="Ito, Shigeaki" userId="9738649d-cd64-434d-883a-bc64ce9afd08" providerId="ADAL" clId="{3C05D16F-B2F9-4026-9A1E-DCB0B627E319}" dt="2024-07-02T06:27:05.574" v="453"/>
          <ac:spMkLst>
            <pc:docMk/>
            <pc:sldMk cId="1175636843" sldId="273"/>
            <ac:spMk id="7" creationId="{943473A7-9176-F023-4901-1CE2816B7172}"/>
          </ac:spMkLst>
        </pc:spChg>
        <pc:spChg chg="mod">
          <ac:chgData name="Ito, Shigeaki" userId="9738649d-cd64-434d-883a-bc64ce9afd08" providerId="ADAL" clId="{3C05D16F-B2F9-4026-9A1E-DCB0B627E319}" dt="2024-07-02T06:27:05.574" v="453"/>
          <ac:spMkLst>
            <pc:docMk/>
            <pc:sldMk cId="1175636843" sldId="273"/>
            <ac:spMk id="8" creationId="{8A36C710-01B8-EF32-1BE6-814198B8B5B3}"/>
          </ac:spMkLst>
        </pc:spChg>
        <pc:spChg chg="mod">
          <ac:chgData name="Ito, Shigeaki" userId="9738649d-cd64-434d-883a-bc64ce9afd08" providerId="ADAL" clId="{3C05D16F-B2F9-4026-9A1E-DCB0B627E319}" dt="2024-07-02T06:27:05.574" v="453"/>
          <ac:spMkLst>
            <pc:docMk/>
            <pc:sldMk cId="1175636843" sldId="273"/>
            <ac:spMk id="9" creationId="{4AAB407E-BF76-17CC-FE6B-0F018315CA61}"/>
          </ac:spMkLst>
        </pc:spChg>
        <pc:spChg chg="mod">
          <ac:chgData name="Ito, Shigeaki" userId="9738649d-cd64-434d-883a-bc64ce9afd08" providerId="ADAL" clId="{3C05D16F-B2F9-4026-9A1E-DCB0B627E319}" dt="2024-07-02T06:27:05.574" v="453"/>
          <ac:spMkLst>
            <pc:docMk/>
            <pc:sldMk cId="1175636843" sldId="273"/>
            <ac:spMk id="10" creationId="{1937985B-5EED-5B1A-5F36-565457D565CF}"/>
          </ac:spMkLst>
        </pc:spChg>
        <pc:spChg chg="add mod">
          <ac:chgData name="Ito, Shigeaki" userId="9738649d-cd64-434d-883a-bc64ce9afd08" providerId="ADAL" clId="{3C05D16F-B2F9-4026-9A1E-DCB0B627E319}" dt="2024-07-02T06:27:05.574" v="453"/>
          <ac:spMkLst>
            <pc:docMk/>
            <pc:sldMk cId="1175636843" sldId="273"/>
            <ac:spMk id="11" creationId="{C2877284-D1AC-B59A-326B-546733CA20D3}"/>
          </ac:spMkLst>
        </pc:spChg>
        <pc:spChg chg="add mod">
          <ac:chgData name="Ito, Shigeaki" userId="9738649d-cd64-434d-883a-bc64ce9afd08" providerId="ADAL" clId="{3C05D16F-B2F9-4026-9A1E-DCB0B627E319}" dt="2024-07-02T06:27:05.574" v="453"/>
          <ac:spMkLst>
            <pc:docMk/>
            <pc:sldMk cId="1175636843" sldId="273"/>
            <ac:spMk id="12" creationId="{F11348D9-EE72-BE42-091D-B63564FE8B83}"/>
          </ac:spMkLst>
        </pc:spChg>
        <pc:grpChg chg="add mod">
          <ac:chgData name="Ito, Shigeaki" userId="9738649d-cd64-434d-883a-bc64ce9afd08" providerId="ADAL" clId="{3C05D16F-B2F9-4026-9A1E-DCB0B627E319}" dt="2024-07-02T06:27:05.574" v="453"/>
          <ac:grpSpMkLst>
            <pc:docMk/>
            <pc:sldMk cId="1175636843" sldId="273"/>
            <ac:grpSpMk id="6" creationId="{EA030D88-042B-C87C-4DC2-56BE80A3D3E2}"/>
          </ac:grpSpMkLst>
        </pc:grpChg>
        <pc:picChg chg="add mod">
          <ac:chgData name="Ito, Shigeaki" userId="9738649d-cd64-434d-883a-bc64ce9afd08" providerId="ADAL" clId="{3C05D16F-B2F9-4026-9A1E-DCB0B627E319}" dt="2024-11-06T04:02:25.075" v="1095" actId="1076"/>
          <ac:picMkLst>
            <pc:docMk/>
            <pc:sldMk cId="1175636843" sldId="273"/>
            <ac:picMk id="4" creationId="{989B3D62-2BA9-A92B-FC24-31A82C4F7007}"/>
          </ac:picMkLst>
        </pc:picChg>
        <pc:picChg chg="add mod">
          <ac:chgData name="Ito, Shigeaki" userId="9738649d-cd64-434d-883a-bc64ce9afd08" providerId="ADAL" clId="{3C05D16F-B2F9-4026-9A1E-DCB0B627E319}" dt="2024-07-02T06:27:05.574" v="453"/>
          <ac:picMkLst>
            <pc:docMk/>
            <pc:sldMk cId="1175636843" sldId="273"/>
            <ac:picMk id="5" creationId="{A1266619-4D51-FA00-FE2A-EABE1F5FA94C}"/>
          </ac:picMkLst>
        </pc:picChg>
        <pc:picChg chg="add del">
          <ac:chgData name="Ito, Shigeaki" userId="9738649d-cd64-434d-883a-bc64ce9afd08" providerId="ADAL" clId="{3C05D16F-B2F9-4026-9A1E-DCB0B627E319}" dt="2024-07-18T00:27:03.818" v="876" actId="478"/>
          <ac:picMkLst>
            <pc:docMk/>
            <pc:sldMk cId="1175636843" sldId="273"/>
            <ac:picMk id="13" creationId="{9D717A5D-8D19-02F1-0F45-CC60D1BE33A7}"/>
          </ac:picMkLst>
        </pc:picChg>
      </pc:sldChg>
      <pc:sldChg chg="addSp delSp modSp new mod">
        <pc:chgData name="Ito, Shigeaki" userId="9738649d-cd64-434d-883a-bc64ce9afd08" providerId="ADAL" clId="{3C05D16F-B2F9-4026-9A1E-DCB0B627E319}" dt="2024-11-06T04:03:24.878" v="1109" actId="20577"/>
        <pc:sldMkLst>
          <pc:docMk/>
          <pc:sldMk cId="445525319" sldId="274"/>
        </pc:sldMkLst>
        <pc:spChg chg="del">
          <ac:chgData name="Ito, Shigeaki" userId="9738649d-cd64-434d-883a-bc64ce9afd08" providerId="ADAL" clId="{3C05D16F-B2F9-4026-9A1E-DCB0B627E319}" dt="2024-07-18T00:27:54.314" v="891" actId="478"/>
          <ac:spMkLst>
            <pc:docMk/>
            <pc:sldMk cId="445525319" sldId="274"/>
            <ac:spMk id="2" creationId="{52AEC472-7D17-AA75-5DD3-600425270BF1}"/>
          </ac:spMkLst>
        </pc:spChg>
        <pc:spChg chg="add mod">
          <ac:chgData name="Ito, Shigeaki" userId="9738649d-cd64-434d-883a-bc64ce9afd08" providerId="ADAL" clId="{3C05D16F-B2F9-4026-9A1E-DCB0B627E319}" dt="2024-11-06T04:03:24.878" v="1109" actId="20577"/>
          <ac:spMkLst>
            <pc:docMk/>
            <pc:sldMk cId="445525319" sldId="274"/>
            <ac:spMk id="2" creationId="{99A3429B-F091-29D7-C530-C831362E4E69}"/>
          </ac:spMkLst>
        </pc:spChg>
        <pc:spChg chg="del">
          <ac:chgData name="Ito, Shigeaki" userId="9738649d-cd64-434d-883a-bc64ce9afd08" providerId="ADAL" clId="{3C05D16F-B2F9-4026-9A1E-DCB0B627E319}" dt="2024-07-18T00:27:54.314" v="891" actId="478"/>
          <ac:spMkLst>
            <pc:docMk/>
            <pc:sldMk cId="445525319" sldId="274"/>
            <ac:spMk id="3" creationId="{E7DEB071-2146-29DF-D397-84C3FA15E7FA}"/>
          </ac:spMkLst>
        </pc:spChg>
        <pc:spChg chg="add mod">
          <ac:chgData name="Ito, Shigeaki" userId="9738649d-cd64-434d-883a-bc64ce9afd08" providerId="ADAL" clId="{3C05D16F-B2F9-4026-9A1E-DCB0B627E319}" dt="2024-07-02T06:38:19.916" v="470"/>
          <ac:spMkLst>
            <pc:docMk/>
            <pc:sldMk cId="445525319" sldId="274"/>
            <ac:spMk id="4" creationId="{291C9100-EC8C-FB69-96A9-FF3D35D3ACAE}"/>
          </ac:spMkLst>
        </pc:spChg>
        <pc:spChg chg="mod">
          <ac:chgData name="Ito, Shigeaki" userId="9738649d-cd64-434d-883a-bc64ce9afd08" providerId="ADAL" clId="{3C05D16F-B2F9-4026-9A1E-DCB0B627E319}" dt="2024-07-02T06:38:19.916" v="470"/>
          <ac:spMkLst>
            <pc:docMk/>
            <pc:sldMk cId="445525319" sldId="274"/>
            <ac:spMk id="7" creationId="{39E5ACF0-135A-3B73-4DE6-D1E4F218D13E}"/>
          </ac:spMkLst>
        </pc:spChg>
        <pc:spChg chg="mod">
          <ac:chgData name="Ito, Shigeaki" userId="9738649d-cd64-434d-883a-bc64ce9afd08" providerId="ADAL" clId="{3C05D16F-B2F9-4026-9A1E-DCB0B627E319}" dt="2024-07-02T06:38:19.916" v="470"/>
          <ac:spMkLst>
            <pc:docMk/>
            <pc:sldMk cId="445525319" sldId="274"/>
            <ac:spMk id="8" creationId="{2C07B51D-4459-1CFD-7FB5-A0C28D8143E4}"/>
          </ac:spMkLst>
        </pc:spChg>
        <pc:spChg chg="mod">
          <ac:chgData name="Ito, Shigeaki" userId="9738649d-cd64-434d-883a-bc64ce9afd08" providerId="ADAL" clId="{3C05D16F-B2F9-4026-9A1E-DCB0B627E319}" dt="2024-07-02T06:38:19.916" v="470"/>
          <ac:spMkLst>
            <pc:docMk/>
            <pc:sldMk cId="445525319" sldId="274"/>
            <ac:spMk id="9" creationId="{4F7B7348-1F96-0C33-7523-67C20CBFCF79}"/>
          </ac:spMkLst>
        </pc:spChg>
        <pc:spChg chg="mod">
          <ac:chgData name="Ito, Shigeaki" userId="9738649d-cd64-434d-883a-bc64ce9afd08" providerId="ADAL" clId="{3C05D16F-B2F9-4026-9A1E-DCB0B627E319}" dt="2024-07-02T06:38:19.916" v="470"/>
          <ac:spMkLst>
            <pc:docMk/>
            <pc:sldMk cId="445525319" sldId="274"/>
            <ac:spMk id="10" creationId="{1012A96A-EED1-C74D-62F3-4693390F5864}"/>
          </ac:spMkLst>
        </pc:spChg>
        <pc:spChg chg="add mod">
          <ac:chgData name="Ito, Shigeaki" userId="9738649d-cd64-434d-883a-bc64ce9afd08" providerId="ADAL" clId="{3C05D16F-B2F9-4026-9A1E-DCB0B627E319}" dt="2024-07-02T06:38:19.916" v="470"/>
          <ac:spMkLst>
            <pc:docMk/>
            <pc:sldMk cId="445525319" sldId="274"/>
            <ac:spMk id="11" creationId="{E3907BF2-C3BD-A237-D8AE-5A743B67D157}"/>
          </ac:spMkLst>
        </pc:spChg>
        <pc:spChg chg="add mod">
          <ac:chgData name="Ito, Shigeaki" userId="9738649d-cd64-434d-883a-bc64ce9afd08" providerId="ADAL" clId="{3C05D16F-B2F9-4026-9A1E-DCB0B627E319}" dt="2024-07-02T06:38:19.916" v="470"/>
          <ac:spMkLst>
            <pc:docMk/>
            <pc:sldMk cId="445525319" sldId="274"/>
            <ac:spMk id="12" creationId="{6BCF6AB8-F551-9274-16CD-A7913AA8ACD0}"/>
          </ac:spMkLst>
        </pc:spChg>
        <pc:grpChg chg="add mod">
          <ac:chgData name="Ito, Shigeaki" userId="9738649d-cd64-434d-883a-bc64ce9afd08" providerId="ADAL" clId="{3C05D16F-B2F9-4026-9A1E-DCB0B627E319}" dt="2024-07-02T06:38:19.916" v="470"/>
          <ac:grpSpMkLst>
            <pc:docMk/>
            <pc:sldMk cId="445525319" sldId="274"/>
            <ac:grpSpMk id="6" creationId="{A27DDFEF-5D30-75AE-90DA-77FA7F704EFC}"/>
          </ac:grpSpMkLst>
        </pc:grpChg>
        <pc:picChg chg="add mod">
          <ac:chgData name="Ito, Shigeaki" userId="9738649d-cd64-434d-883a-bc64ce9afd08" providerId="ADAL" clId="{3C05D16F-B2F9-4026-9A1E-DCB0B627E319}" dt="2024-07-18T00:27:58.850" v="893" actId="1076"/>
          <ac:picMkLst>
            <pc:docMk/>
            <pc:sldMk cId="445525319" sldId="274"/>
            <ac:picMk id="4" creationId="{CA19E729-DE7C-AE90-D1EA-6C0CF4131CAB}"/>
          </ac:picMkLst>
        </pc:picChg>
        <pc:picChg chg="add mod">
          <ac:chgData name="Ito, Shigeaki" userId="9738649d-cd64-434d-883a-bc64ce9afd08" providerId="ADAL" clId="{3C05D16F-B2F9-4026-9A1E-DCB0B627E319}" dt="2024-07-02T06:38:19.916" v="470"/>
          <ac:picMkLst>
            <pc:docMk/>
            <pc:sldMk cId="445525319" sldId="274"/>
            <ac:picMk id="5" creationId="{444C2D9D-A5BB-2B47-4449-5771C5B78F22}"/>
          </ac:picMkLst>
        </pc:picChg>
        <pc:picChg chg="add del">
          <ac:chgData name="Ito, Shigeaki" userId="9738649d-cd64-434d-883a-bc64ce9afd08" providerId="ADAL" clId="{3C05D16F-B2F9-4026-9A1E-DCB0B627E319}" dt="2024-07-18T00:27:51.612" v="890" actId="478"/>
          <ac:picMkLst>
            <pc:docMk/>
            <pc:sldMk cId="445525319" sldId="274"/>
            <ac:picMk id="13" creationId="{520B81E7-A17C-C70B-E78C-F72AE0B1CEBF}"/>
          </ac:picMkLst>
        </pc:picChg>
      </pc:sldChg>
      <pc:sldChg chg="addSp delSp modSp new mod">
        <pc:chgData name="Ito, Shigeaki" userId="9738649d-cd64-434d-883a-bc64ce9afd08" providerId="ADAL" clId="{3C05D16F-B2F9-4026-9A1E-DCB0B627E319}" dt="2024-11-06T04:04:26.978" v="1153" actId="20577"/>
        <pc:sldMkLst>
          <pc:docMk/>
          <pc:sldMk cId="2127591803" sldId="275"/>
        </pc:sldMkLst>
        <pc:spChg chg="del">
          <ac:chgData name="Ito, Shigeaki" userId="9738649d-cd64-434d-883a-bc64ce9afd08" providerId="ADAL" clId="{3C05D16F-B2F9-4026-9A1E-DCB0B627E319}" dt="2024-07-18T00:21:31.618" v="790" actId="478"/>
          <ac:spMkLst>
            <pc:docMk/>
            <pc:sldMk cId="2127591803" sldId="275"/>
            <ac:spMk id="2" creationId="{5DA049C0-FB9C-8D3A-FD4C-D794D598DDCE}"/>
          </ac:spMkLst>
        </pc:spChg>
        <pc:spChg chg="add mod">
          <ac:chgData name="Ito, Shigeaki" userId="9738649d-cd64-434d-883a-bc64ce9afd08" providerId="ADAL" clId="{3C05D16F-B2F9-4026-9A1E-DCB0B627E319}" dt="2024-11-06T04:04:26.978" v="1153" actId="20577"/>
          <ac:spMkLst>
            <pc:docMk/>
            <pc:sldMk cId="2127591803" sldId="275"/>
            <ac:spMk id="2" creationId="{DF2E6CBC-E7AB-F669-4164-D46BCFB982B5}"/>
          </ac:spMkLst>
        </pc:spChg>
        <pc:spChg chg="add mod">
          <ac:chgData name="Ito, Shigeaki" userId="9738649d-cd64-434d-883a-bc64ce9afd08" providerId="ADAL" clId="{3C05D16F-B2F9-4026-9A1E-DCB0B627E319}" dt="2024-11-06T04:02:01.069" v="1091"/>
          <ac:spMkLst>
            <pc:docMk/>
            <pc:sldMk cId="2127591803" sldId="275"/>
            <ac:spMk id="3" creationId="{009A998A-AA48-BF97-625E-8DC83EDDB862}"/>
          </ac:spMkLst>
        </pc:spChg>
        <pc:spChg chg="del">
          <ac:chgData name="Ito, Shigeaki" userId="9738649d-cd64-434d-883a-bc64ce9afd08" providerId="ADAL" clId="{3C05D16F-B2F9-4026-9A1E-DCB0B627E319}" dt="2024-07-18T00:21:31.618" v="790" actId="478"/>
          <ac:spMkLst>
            <pc:docMk/>
            <pc:sldMk cId="2127591803" sldId="275"/>
            <ac:spMk id="3" creationId="{ED3D6E16-4F3A-1DBA-B892-C5F6FFB6403E}"/>
          </ac:spMkLst>
        </pc:spChg>
        <pc:spChg chg="add mod">
          <ac:chgData name="Ito, Shigeaki" userId="9738649d-cd64-434d-883a-bc64ce9afd08" providerId="ADAL" clId="{3C05D16F-B2F9-4026-9A1E-DCB0B627E319}" dt="2024-07-02T06:39:36.105" v="484"/>
          <ac:spMkLst>
            <pc:docMk/>
            <pc:sldMk cId="2127591803" sldId="275"/>
            <ac:spMk id="4" creationId="{C757F42A-B10E-49F5-EF48-23E622BDB591}"/>
          </ac:spMkLst>
        </pc:spChg>
        <pc:spChg chg="mod">
          <ac:chgData name="Ito, Shigeaki" userId="9738649d-cd64-434d-883a-bc64ce9afd08" providerId="ADAL" clId="{3C05D16F-B2F9-4026-9A1E-DCB0B627E319}" dt="2024-07-02T06:39:36.105" v="484"/>
          <ac:spMkLst>
            <pc:docMk/>
            <pc:sldMk cId="2127591803" sldId="275"/>
            <ac:spMk id="7" creationId="{97F32824-6EFE-1A41-6152-F1FA18B1A1B7}"/>
          </ac:spMkLst>
        </pc:spChg>
        <pc:spChg chg="mod">
          <ac:chgData name="Ito, Shigeaki" userId="9738649d-cd64-434d-883a-bc64ce9afd08" providerId="ADAL" clId="{3C05D16F-B2F9-4026-9A1E-DCB0B627E319}" dt="2024-07-02T06:39:36.105" v="484"/>
          <ac:spMkLst>
            <pc:docMk/>
            <pc:sldMk cId="2127591803" sldId="275"/>
            <ac:spMk id="8" creationId="{465F42B2-F690-9727-A4A9-C8ED10F3CAFC}"/>
          </ac:spMkLst>
        </pc:spChg>
        <pc:spChg chg="mod">
          <ac:chgData name="Ito, Shigeaki" userId="9738649d-cd64-434d-883a-bc64ce9afd08" providerId="ADAL" clId="{3C05D16F-B2F9-4026-9A1E-DCB0B627E319}" dt="2024-07-02T06:39:36.105" v="484"/>
          <ac:spMkLst>
            <pc:docMk/>
            <pc:sldMk cId="2127591803" sldId="275"/>
            <ac:spMk id="9" creationId="{209EE34C-0C1F-F311-F8CD-397E80FF6983}"/>
          </ac:spMkLst>
        </pc:spChg>
        <pc:spChg chg="mod">
          <ac:chgData name="Ito, Shigeaki" userId="9738649d-cd64-434d-883a-bc64ce9afd08" providerId="ADAL" clId="{3C05D16F-B2F9-4026-9A1E-DCB0B627E319}" dt="2024-07-02T06:39:36.105" v="484"/>
          <ac:spMkLst>
            <pc:docMk/>
            <pc:sldMk cId="2127591803" sldId="275"/>
            <ac:spMk id="10" creationId="{2D7D893C-280D-2138-1EF2-5F6BF708812E}"/>
          </ac:spMkLst>
        </pc:spChg>
        <pc:spChg chg="add mod">
          <ac:chgData name="Ito, Shigeaki" userId="9738649d-cd64-434d-883a-bc64ce9afd08" providerId="ADAL" clId="{3C05D16F-B2F9-4026-9A1E-DCB0B627E319}" dt="2024-07-02T06:39:36.105" v="484"/>
          <ac:spMkLst>
            <pc:docMk/>
            <pc:sldMk cId="2127591803" sldId="275"/>
            <ac:spMk id="11" creationId="{460CD96A-EC21-948D-B9CE-3457424C530A}"/>
          </ac:spMkLst>
        </pc:spChg>
        <pc:spChg chg="add mod">
          <ac:chgData name="Ito, Shigeaki" userId="9738649d-cd64-434d-883a-bc64ce9afd08" providerId="ADAL" clId="{3C05D16F-B2F9-4026-9A1E-DCB0B627E319}" dt="2024-07-02T06:39:36.105" v="484"/>
          <ac:spMkLst>
            <pc:docMk/>
            <pc:sldMk cId="2127591803" sldId="275"/>
            <ac:spMk id="12" creationId="{349AC02A-ACA7-FDAB-B4DC-170EE4E678B3}"/>
          </ac:spMkLst>
        </pc:spChg>
        <pc:grpChg chg="add mod">
          <ac:chgData name="Ito, Shigeaki" userId="9738649d-cd64-434d-883a-bc64ce9afd08" providerId="ADAL" clId="{3C05D16F-B2F9-4026-9A1E-DCB0B627E319}" dt="2024-07-02T06:39:36.105" v="484"/>
          <ac:grpSpMkLst>
            <pc:docMk/>
            <pc:sldMk cId="2127591803" sldId="275"/>
            <ac:grpSpMk id="6" creationId="{38C11DB5-F01B-773C-1F1F-EF42384BB02F}"/>
          </ac:grpSpMkLst>
        </pc:grpChg>
        <pc:picChg chg="add mod">
          <ac:chgData name="Ito, Shigeaki" userId="9738649d-cd64-434d-883a-bc64ce9afd08" providerId="ADAL" clId="{3C05D16F-B2F9-4026-9A1E-DCB0B627E319}" dt="2024-11-06T04:02:29.902" v="1096" actId="1076"/>
          <ac:picMkLst>
            <pc:docMk/>
            <pc:sldMk cId="2127591803" sldId="275"/>
            <ac:picMk id="4" creationId="{CF506E21-3FF0-EAB4-5442-C0CE4FADD9C2}"/>
          </ac:picMkLst>
        </pc:picChg>
        <pc:picChg chg="add mod">
          <ac:chgData name="Ito, Shigeaki" userId="9738649d-cd64-434d-883a-bc64ce9afd08" providerId="ADAL" clId="{3C05D16F-B2F9-4026-9A1E-DCB0B627E319}" dt="2024-07-02T06:39:36.105" v="484"/>
          <ac:picMkLst>
            <pc:docMk/>
            <pc:sldMk cId="2127591803" sldId="275"/>
            <ac:picMk id="5" creationId="{7D93AD14-4662-C4A4-D197-5BEC9B8C4B2D}"/>
          </ac:picMkLst>
        </pc:picChg>
        <pc:picChg chg="add del">
          <ac:chgData name="Ito, Shigeaki" userId="9738649d-cd64-434d-883a-bc64ce9afd08" providerId="ADAL" clId="{3C05D16F-B2F9-4026-9A1E-DCB0B627E319}" dt="2024-07-18T00:21:28.368" v="789" actId="478"/>
          <ac:picMkLst>
            <pc:docMk/>
            <pc:sldMk cId="2127591803" sldId="275"/>
            <ac:picMk id="13" creationId="{1617BB6A-8922-9C89-A0D8-B60FC5B1718F}"/>
          </ac:picMkLst>
        </pc:picChg>
      </pc:sldChg>
      <pc:sldChg chg="addSp delSp modSp new mod">
        <pc:chgData name="Ito, Shigeaki" userId="9738649d-cd64-434d-883a-bc64ce9afd08" providerId="ADAL" clId="{3C05D16F-B2F9-4026-9A1E-DCB0B627E319}" dt="2024-11-06T04:05:53.555" v="1188" actId="20577"/>
        <pc:sldMkLst>
          <pc:docMk/>
          <pc:sldMk cId="2416885041" sldId="276"/>
        </pc:sldMkLst>
        <pc:spChg chg="add del">
          <ac:chgData name="Ito, Shigeaki" userId="9738649d-cd64-434d-883a-bc64ce9afd08" providerId="ADAL" clId="{3C05D16F-B2F9-4026-9A1E-DCB0B627E319}" dt="2024-07-18T00:23:52.401" v="831" actId="478"/>
          <ac:spMkLst>
            <pc:docMk/>
            <pc:sldMk cId="2416885041" sldId="276"/>
            <ac:spMk id="2" creationId="{6AD5227E-39A9-36F7-C4B2-7E557C439187}"/>
          </ac:spMkLst>
        </pc:spChg>
        <pc:spChg chg="add mod">
          <ac:chgData name="Ito, Shigeaki" userId="9738649d-cd64-434d-883a-bc64ce9afd08" providerId="ADAL" clId="{3C05D16F-B2F9-4026-9A1E-DCB0B627E319}" dt="2024-11-06T04:05:53.555" v="1188" actId="20577"/>
          <ac:spMkLst>
            <pc:docMk/>
            <pc:sldMk cId="2416885041" sldId="276"/>
            <ac:spMk id="2" creationId="{F3D549ED-0277-9EBC-3BAA-D54D6868C31F}"/>
          </ac:spMkLst>
        </pc:spChg>
        <pc:spChg chg="add del">
          <ac:chgData name="Ito, Shigeaki" userId="9738649d-cd64-434d-883a-bc64ce9afd08" providerId="ADAL" clId="{3C05D16F-B2F9-4026-9A1E-DCB0B627E319}" dt="2024-07-18T00:23:52.401" v="831" actId="478"/>
          <ac:spMkLst>
            <pc:docMk/>
            <pc:sldMk cId="2416885041" sldId="276"/>
            <ac:spMk id="3" creationId="{45DEEA44-F8ED-FBB9-165A-24B998791E91}"/>
          </ac:spMkLst>
        </pc:spChg>
        <pc:spChg chg="add mod">
          <ac:chgData name="Ito, Shigeaki" userId="9738649d-cd64-434d-883a-bc64ce9afd08" providerId="ADAL" clId="{3C05D16F-B2F9-4026-9A1E-DCB0B627E319}" dt="2024-07-02T06:41:04.810" v="500"/>
          <ac:spMkLst>
            <pc:docMk/>
            <pc:sldMk cId="2416885041" sldId="276"/>
            <ac:spMk id="4" creationId="{3DAFB93D-073E-A312-E745-7CE99F4D089F}"/>
          </ac:spMkLst>
        </pc:spChg>
        <pc:spChg chg="mod">
          <ac:chgData name="Ito, Shigeaki" userId="9738649d-cd64-434d-883a-bc64ce9afd08" providerId="ADAL" clId="{3C05D16F-B2F9-4026-9A1E-DCB0B627E319}" dt="2024-07-02T06:41:04.810" v="500"/>
          <ac:spMkLst>
            <pc:docMk/>
            <pc:sldMk cId="2416885041" sldId="276"/>
            <ac:spMk id="7" creationId="{832DDB35-AAAF-F7A8-5770-933D51AD66A1}"/>
          </ac:spMkLst>
        </pc:spChg>
        <pc:spChg chg="mod">
          <ac:chgData name="Ito, Shigeaki" userId="9738649d-cd64-434d-883a-bc64ce9afd08" providerId="ADAL" clId="{3C05D16F-B2F9-4026-9A1E-DCB0B627E319}" dt="2024-07-02T06:41:04.810" v="500"/>
          <ac:spMkLst>
            <pc:docMk/>
            <pc:sldMk cId="2416885041" sldId="276"/>
            <ac:spMk id="8" creationId="{52B138A6-5C87-8D08-8CF5-1C39AA09FA72}"/>
          </ac:spMkLst>
        </pc:spChg>
        <pc:spChg chg="mod">
          <ac:chgData name="Ito, Shigeaki" userId="9738649d-cd64-434d-883a-bc64ce9afd08" providerId="ADAL" clId="{3C05D16F-B2F9-4026-9A1E-DCB0B627E319}" dt="2024-07-02T06:41:04.810" v="500"/>
          <ac:spMkLst>
            <pc:docMk/>
            <pc:sldMk cId="2416885041" sldId="276"/>
            <ac:spMk id="9" creationId="{5F16AF5A-BC02-559A-8CE5-DBF83889EA15}"/>
          </ac:spMkLst>
        </pc:spChg>
        <pc:spChg chg="mod">
          <ac:chgData name="Ito, Shigeaki" userId="9738649d-cd64-434d-883a-bc64ce9afd08" providerId="ADAL" clId="{3C05D16F-B2F9-4026-9A1E-DCB0B627E319}" dt="2024-07-02T06:41:04.810" v="500"/>
          <ac:spMkLst>
            <pc:docMk/>
            <pc:sldMk cId="2416885041" sldId="276"/>
            <ac:spMk id="10" creationId="{A970508E-99DF-F119-8105-E7383C7609D5}"/>
          </ac:spMkLst>
        </pc:spChg>
        <pc:spChg chg="add mod">
          <ac:chgData name="Ito, Shigeaki" userId="9738649d-cd64-434d-883a-bc64ce9afd08" providerId="ADAL" clId="{3C05D16F-B2F9-4026-9A1E-DCB0B627E319}" dt="2024-07-02T06:41:04.810" v="500"/>
          <ac:spMkLst>
            <pc:docMk/>
            <pc:sldMk cId="2416885041" sldId="276"/>
            <ac:spMk id="11" creationId="{3351AFE1-0936-E179-B996-0928A127C041}"/>
          </ac:spMkLst>
        </pc:spChg>
        <pc:spChg chg="add mod">
          <ac:chgData name="Ito, Shigeaki" userId="9738649d-cd64-434d-883a-bc64ce9afd08" providerId="ADAL" clId="{3C05D16F-B2F9-4026-9A1E-DCB0B627E319}" dt="2024-07-02T06:41:04.810" v="500"/>
          <ac:spMkLst>
            <pc:docMk/>
            <pc:sldMk cId="2416885041" sldId="276"/>
            <ac:spMk id="12" creationId="{92B6E3D2-7033-8106-4842-2AC81C1E7D93}"/>
          </ac:spMkLst>
        </pc:spChg>
        <pc:grpChg chg="add mod">
          <ac:chgData name="Ito, Shigeaki" userId="9738649d-cd64-434d-883a-bc64ce9afd08" providerId="ADAL" clId="{3C05D16F-B2F9-4026-9A1E-DCB0B627E319}" dt="2024-07-02T06:41:04.810" v="500"/>
          <ac:grpSpMkLst>
            <pc:docMk/>
            <pc:sldMk cId="2416885041" sldId="276"/>
            <ac:grpSpMk id="6" creationId="{74F62CCD-E0AF-2E70-347E-F273AC39E6ED}"/>
          </ac:grpSpMkLst>
        </pc:grpChg>
        <pc:picChg chg="add del mod">
          <ac:chgData name="Ito, Shigeaki" userId="9738649d-cd64-434d-883a-bc64ce9afd08" providerId="ADAL" clId="{3C05D16F-B2F9-4026-9A1E-DCB0B627E319}" dt="2024-07-18T00:23:45.611" v="828" actId="1076"/>
          <ac:picMkLst>
            <pc:docMk/>
            <pc:sldMk cId="2416885041" sldId="276"/>
            <ac:picMk id="4" creationId="{2A2B3CD8-86A7-F17C-7F4E-B2541AD0FDFA}"/>
          </ac:picMkLst>
        </pc:picChg>
        <pc:picChg chg="add mod">
          <ac:chgData name="Ito, Shigeaki" userId="9738649d-cd64-434d-883a-bc64ce9afd08" providerId="ADAL" clId="{3C05D16F-B2F9-4026-9A1E-DCB0B627E319}" dt="2024-11-06T04:01:39.149" v="1088" actId="1076"/>
          <ac:picMkLst>
            <pc:docMk/>
            <pc:sldMk cId="2416885041" sldId="276"/>
            <ac:picMk id="5" creationId="{779DEDEA-7BEB-9356-629E-5B99BCC04561}"/>
          </ac:picMkLst>
        </pc:picChg>
        <pc:picChg chg="add mod">
          <ac:chgData name="Ito, Shigeaki" userId="9738649d-cd64-434d-883a-bc64ce9afd08" providerId="ADAL" clId="{3C05D16F-B2F9-4026-9A1E-DCB0B627E319}" dt="2024-07-02T06:41:04.810" v="500"/>
          <ac:picMkLst>
            <pc:docMk/>
            <pc:sldMk cId="2416885041" sldId="276"/>
            <ac:picMk id="5" creationId="{873B50D2-711E-FCF4-9961-C1BA0C58CBA5}"/>
          </ac:picMkLst>
        </pc:picChg>
        <pc:picChg chg="add del">
          <ac:chgData name="Ito, Shigeaki" userId="9738649d-cd64-434d-883a-bc64ce9afd08" providerId="ADAL" clId="{3C05D16F-B2F9-4026-9A1E-DCB0B627E319}" dt="2024-07-18T00:24:38.667" v="839" actId="478"/>
          <ac:picMkLst>
            <pc:docMk/>
            <pc:sldMk cId="2416885041" sldId="276"/>
            <ac:picMk id="13" creationId="{198696E0-8CF3-0D72-3FAA-544A87CCD95A}"/>
          </ac:picMkLst>
        </pc:picChg>
      </pc:sldChg>
      <pc:sldChg chg="addSp delSp modSp new mod">
        <pc:chgData name="Ito, Shigeaki" userId="9738649d-cd64-434d-883a-bc64ce9afd08" providerId="ADAL" clId="{3C05D16F-B2F9-4026-9A1E-DCB0B627E319}" dt="2024-11-06T04:06:54.419" v="1304" actId="20577"/>
        <pc:sldMkLst>
          <pc:docMk/>
          <pc:sldMk cId="2236928888" sldId="277"/>
        </pc:sldMkLst>
        <pc:spChg chg="del">
          <ac:chgData name="Ito, Shigeaki" userId="9738649d-cd64-434d-883a-bc64ce9afd08" providerId="ADAL" clId="{3C05D16F-B2F9-4026-9A1E-DCB0B627E319}" dt="2024-11-06T04:01:25.804" v="1086" actId="478"/>
          <ac:spMkLst>
            <pc:docMk/>
            <pc:sldMk cId="2236928888" sldId="277"/>
            <ac:spMk id="2" creationId="{2C11E0B9-A70C-D7FF-6997-90E6CB53E50F}"/>
          </ac:spMkLst>
        </pc:spChg>
        <pc:spChg chg="del">
          <ac:chgData name="Ito, Shigeaki" userId="9738649d-cd64-434d-883a-bc64ce9afd08" providerId="ADAL" clId="{3C05D16F-B2F9-4026-9A1E-DCB0B627E319}" dt="2024-11-06T04:01:23.431" v="1085" actId="478"/>
          <ac:spMkLst>
            <pc:docMk/>
            <pc:sldMk cId="2236928888" sldId="277"/>
            <ac:spMk id="3" creationId="{B10797BB-FA79-0AEF-E9C3-9573ED9E4C60}"/>
          </ac:spMkLst>
        </pc:spChg>
        <pc:spChg chg="add mod">
          <ac:chgData name="Ito, Shigeaki" userId="9738649d-cd64-434d-883a-bc64ce9afd08" providerId="ADAL" clId="{3C05D16F-B2F9-4026-9A1E-DCB0B627E319}" dt="2024-07-02T06:42:23.902" v="534"/>
          <ac:spMkLst>
            <pc:docMk/>
            <pc:sldMk cId="2236928888" sldId="277"/>
            <ac:spMk id="4" creationId="{FA86539E-B855-E6B0-4B98-46FDA5497210}"/>
          </ac:spMkLst>
        </pc:spChg>
        <pc:spChg chg="add mod">
          <ac:chgData name="Ito, Shigeaki" userId="9738649d-cd64-434d-883a-bc64ce9afd08" providerId="ADAL" clId="{3C05D16F-B2F9-4026-9A1E-DCB0B627E319}" dt="2024-11-06T04:06:54.419" v="1304" actId="20577"/>
          <ac:spMkLst>
            <pc:docMk/>
            <pc:sldMk cId="2236928888" sldId="277"/>
            <ac:spMk id="5" creationId="{98AA6993-C957-0CFC-2C2A-35CA6EFF8DA6}"/>
          </ac:spMkLst>
        </pc:spChg>
        <pc:spChg chg="mod">
          <ac:chgData name="Ito, Shigeaki" userId="9738649d-cd64-434d-883a-bc64ce9afd08" providerId="ADAL" clId="{3C05D16F-B2F9-4026-9A1E-DCB0B627E319}" dt="2024-07-02T06:42:23.902" v="534"/>
          <ac:spMkLst>
            <pc:docMk/>
            <pc:sldMk cId="2236928888" sldId="277"/>
            <ac:spMk id="7" creationId="{DD46D1A2-65E2-C36C-FAF5-91CC404A283E}"/>
          </ac:spMkLst>
        </pc:spChg>
        <pc:spChg chg="mod">
          <ac:chgData name="Ito, Shigeaki" userId="9738649d-cd64-434d-883a-bc64ce9afd08" providerId="ADAL" clId="{3C05D16F-B2F9-4026-9A1E-DCB0B627E319}" dt="2024-07-02T06:42:23.902" v="534"/>
          <ac:spMkLst>
            <pc:docMk/>
            <pc:sldMk cId="2236928888" sldId="277"/>
            <ac:spMk id="8" creationId="{9D702F85-9B0A-ACF9-9562-E5CEDA350C9F}"/>
          </ac:spMkLst>
        </pc:spChg>
        <pc:spChg chg="mod">
          <ac:chgData name="Ito, Shigeaki" userId="9738649d-cd64-434d-883a-bc64ce9afd08" providerId="ADAL" clId="{3C05D16F-B2F9-4026-9A1E-DCB0B627E319}" dt="2024-07-02T06:42:23.902" v="534"/>
          <ac:spMkLst>
            <pc:docMk/>
            <pc:sldMk cId="2236928888" sldId="277"/>
            <ac:spMk id="9" creationId="{DDCBAD92-DF35-AB57-96B5-1A8F6F0E0F7E}"/>
          </ac:spMkLst>
        </pc:spChg>
        <pc:spChg chg="mod">
          <ac:chgData name="Ito, Shigeaki" userId="9738649d-cd64-434d-883a-bc64ce9afd08" providerId="ADAL" clId="{3C05D16F-B2F9-4026-9A1E-DCB0B627E319}" dt="2024-07-02T06:42:23.902" v="534"/>
          <ac:spMkLst>
            <pc:docMk/>
            <pc:sldMk cId="2236928888" sldId="277"/>
            <ac:spMk id="10" creationId="{1C1CB2D0-4595-01D9-0105-ECB08FA09EB7}"/>
          </ac:spMkLst>
        </pc:spChg>
        <pc:spChg chg="add mod">
          <ac:chgData name="Ito, Shigeaki" userId="9738649d-cd64-434d-883a-bc64ce9afd08" providerId="ADAL" clId="{3C05D16F-B2F9-4026-9A1E-DCB0B627E319}" dt="2024-07-02T06:42:23.902" v="534"/>
          <ac:spMkLst>
            <pc:docMk/>
            <pc:sldMk cId="2236928888" sldId="277"/>
            <ac:spMk id="11" creationId="{09C600F6-DDD0-3153-23E4-D0ECCD861BAC}"/>
          </ac:spMkLst>
        </pc:spChg>
        <pc:spChg chg="add mod">
          <ac:chgData name="Ito, Shigeaki" userId="9738649d-cd64-434d-883a-bc64ce9afd08" providerId="ADAL" clId="{3C05D16F-B2F9-4026-9A1E-DCB0B627E319}" dt="2024-07-02T06:42:23.902" v="534"/>
          <ac:spMkLst>
            <pc:docMk/>
            <pc:sldMk cId="2236928888" sldId="277"/>
            <ac:spMk id="12" creationId="{62AA081C-C3D9-B80B-E02E-7DD582E32011}"/>
          </ac:spMkLst>
        </pc:spChg>
        <pc:grpChg chg="add mod">
          <ac:chgData name="Ito, Shigeaki" userId="9738649d-cd64-434d-883a-bc64ce9afd08" providerId="ADAL" clId="{3C05D16F-B2F9-4026-9A1E-DCB0B627E319}" dt="2024-07-02T06:42:23.902" v="534"/>
          <ac:grpSpMkLst>
            <pc:docMk/>
            <pc:sldMk cId="2236928888" sldId="277"/>
            <ac:grpSpMk id="6" creationId="{4EFC1F18-48DD-FF8F-DA98-71FC7C7D840E}"/>
          </ac:grpSpMkLst>
        </pc:grpChg>
        <pc:picChg chg="add mod">
          <ac:chgData name="Ito, Shigeaki" userId="9738649d-cd64-434d-883a-bc64ce9afd08" providerId="ADAL" clId="{3C05D16F-B2F9-4026-9A1E-DCB0B627E319}" dt="2024-11-06T04:02:37.873" v="1097" actId="14100"/>
          <ac:picMkLst>
            <pc:docMk/>
            <pc:sldMk cId="2236928888" sldId="277"/>
            <ac:picMk id="4" creationId="{FB5D34A4-3B19-AA43-8A76-3B6A023F60B9}"/>
          </ac:picMkLst>
        </pc:picChg>
        <pc:picChg chg="add mod">
          <ac:chgData name="Ito, Shigeaki" userId="9738649d-cd64-434d-883a-bc64ce9afd08" providerId="ADAL" clId="{3C05D16F-B2F9-4026-9A1E-DCB0B627E319}" dt="2024-07-02T06:42:23.902" v="534"/>
          <ac:picMkLst>
            <pc:docMk/>
            <pc:sldMk cId="2236928888" sldId="277"/>
            <ac:picMk id="5" creationId="{68C1B219-0834-B7A8-2C70-BA3AC1EC4030}"/>
          </ac:picMkLst>
        </pc:picChg>
        <pc:picChg chg="add del">
          <ac:chgData name="Ito, Shigeaki" userId="9738649d-cd64-434d-883a-bc64ce9afd08" providerId="ADAL" clId="{3C05D16F-B2F9-4026-9A1E-DCB0B627E319}" dt="2024-07-18T00:25:57.890" v="859" actId="478"/>
          <ac:picMkLst>
            <pc:docMk/>
            <pc:sldMk cId="2236928888" sldId="277"/>
            <ac:picMk id="13" creationId="{15D745D4-A456-8F9B-7176-F5745D50342B}"/>
          </ac:picMkLst>
        </pc:picChg>
      </pc:sldChg>
      <pc:sldChg chg="addSp delSp modSp new del mod">
        <pc:chgData name="Ito, Shigeaki" userId="9738649d-cd64-434d-883a-bc64ce9afd08" providerId="ADAL" clId="{3C05D16F-B2F9-4026-9A1E-DCB0B627E319}" dt="2024-07-18T00:28:10.409" v="894" actId="47"/>
        <pc:sldMkLst>
          <pc:docMk/>
          <pc:sldMk cId="4062495031" sldId="278"/>
        </pc:sldMkLst>
        <pc:spChg chg="del">
          <ac:chgData name="Ito, Shigeaki" userId="9738649d-cd64-434d-883a-bc64ce9afd08" providerId="ADAL" clId="{3C05D16F-B2F9-4026-9A1E-DCB0B627E319}" dt="2024-07-17T12:40:53.408" v="555" actId="478"/>
          <ac:spMkLst>
            <pc:docMk/>
            <pc:sldMk cId="4062495031" sldId="278"/>
            <ac:spMk id="2" creationId="{E009F529-3EAC-9436-DDB4-FBF913E8A288}"/>
          </ac:spMkLst>
        </pc:spChg>
        <pc:spChg chg="del">
          <ac:chgData name="Ito, Shigeaki" userId="9738649d-cd64-434d-883a-bc64ce9afd08" providerId="ADAL" clId="{3C05D16F-B2F9-4026-9A1E-DCB0B627E319}" dt="2024-07-17T12:40:53.408" v="555" actId="478"/>
          <ac:spMkLst>
            <pc:docMk/>
            <pc:sldMk cId="4062495031" sldId="278"/>
            <ac:spMk id="3" creationId="{DF4AB791-BD81-83D8-D58D-5F878BFBE938}"/>
          </ac:spMkLst>
        </pc:spChg>
        <pc:spChg chg="add mod ord">
          <ac:chgData name="Ito, Shigeaki" userId="9738649d-cd64-434d-883a-bc64ce9afd08" providerId="ADAL" clId="{3C05D16F-B2F9-4026-9A1E-DCB0B627E319}" dt="2024-07-17T12:40:32.615" v="548" actId="167"/>
          <ac:spMkLst>
            <pc:docMk/>
            <pc:sldMk cId="4062495031" sldId="278"/>
            <ac:spMk id="6" creationId="{AF1F5B12-FF37-5A43-32AE-F0A1DCBFE653}"/>
          </ac:spMkLst>
        </pc:spChg>
        <pc:spChg chg="add 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7" creationId="{F205F5D9-20E0-F213-20BC-B526C216AC1E}"/>
          </ac:spMkLst>
        </pc:spChg>
        <pc:spChg chg="add 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8" creationId="{9DFA9C2B-B814-A367-9211-E238B3D0FB52}"/>
          </ac:spMkLst>
        </pc:spChg>
        <pc:spChg chg="add 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10" creationId="{C37F29A7-366A-EB15-E3BB-D644F4B46C37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12" creationId="{9D4BA1B5-153F-8909-881F-EA5348C10615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13" creationId="{AA0CEAC0-36BE-DB52-A491-61473C137623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14" creationId="{E20FFFD2-2970-70C7-064E-D443FB1B4A03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15" creationId="{FA8E5D46-3DB0-A955-AA73-47B9F1500261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16" creationId="{09A0A956-E0B4-CAF8-BD11-3812B0C06949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17" creationId="{E76B9E65-DD41-78AF-A6BA-30F59CC078C2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19" creationId="{8EB733AB-0610-067A-742C-7643983607E0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20" creationId="{67684651-7465-28A4-5693-9D24F7C0E735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21" creationId="{146B2833-F3C6-B3CF-1EE8-D77D2D6CBA7A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22" creationId="{B82F2EC1-5E66-E36B-21F9-69E142D9BC6A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23" creationId="{FF2969DA-BF30-B96E-EBDB-C122B0CCE760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24" creationId="{6F355CF3-A1B9-4D56-EF96-AABE13F8B709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25" creationId="{28B65F9A-18B3-9113-F778-48C242293FB0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26" creationId="{B0BA6525-7185-F006-5A93-4F08246AD6EB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27" creationId="{63D37DCD-A0B6-B05B-5FFC-965EC3B6EB83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28" creationId="{8F6E3E12-0D65-0A96-3107-8024080C2236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29" creationId="{6C93D565-B6F7-7136-FC6B-E3D139A386A7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30" creationId="{387F9C9C-49D8-2620-83E2-7E305CC4EB86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31" creationId="{D945A6CC-1578-E2B8-BB9C-72234DA4F31C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32" creationId="{1850F05C-69A7-BB69-84DE-79618D142C02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33" creationId="{997EDB47-0A55-1E12-9BDE-BE82A9C3F52F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34" creationId="{95ED4E74-AC46-A1D8-896F-84E3E24B3F5C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35" creationId="{1C7BD483-1554-E49D-B3EB-B5F4CB0B53C1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36" creationId="{13CB633D-9F3C-D2CB-9589-BBD8AB8B6986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37" creationId="{CA96CC2C-0E61-C99C-05B3-5F9A145B2CCA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38" creationId="{72EF46C6-3FF6-3D9B-AACF-B60A8D7E4DA6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39" creationId="{710C48BF-4DA6-A45E-7321-7E99F56828E4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40" creationId="{2EFCBD97-FBFF-C4F7-4FB3-FBC5DC0BC081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41" creationId="{9F42ADE7-B60B-B80B-8AFC-F9C9BE330BCA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42" creationId="{08FD8860-3E25-3627-4ECA-6E3B9148E301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43" creationId="{2C0AD102-81EA-2D2D-F809-FEF613867FDD}"/>
          </ac:spMkLst>
        </pc:spChg>
        <pc:spChg chg="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44" creationId="{86CB45F1-3DB1-46B4-9CA0-C27123197ECF}"/>
          </ac:spMkLst>
        </pc:spChg>
        <pc:spChg chg="add 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45" creationId="{497E964E-175E-F334-AF91-1F50FDA9EFD3}"/>
          </ac:spMkLst>
        </pc:spChg>
        <pc:spChg chg="add mod">
          <ac:chgData name="Ito, Shigeaki" userId="9738649d-cd64-434d-883a-bc64ce9afd08" providerId="ADAL" clId="{3C05D16F-B2F9-4026-9A1E-DCB0B627E319}" dt="2024-07-17T12:39:39.003" v="538"/>
          <ac:spMkLst>
            <pc:docMk/>
            <pc:sldMk cId="4062495031" sldId="278"/>
            <ac:spMk id="46" creationId="{5CAC1974-5348-3BC1-87FC-DCD74A4CA555}"/>
          </ac:spMkLst>
        </pc:spChg>
        <pc:grpChg chg="add mod">
          <ac:chgData name="Ito, Shigeaki" userId="9738649d-cd64-434d-883a-bc64ce9afd08" providerId="ADAL" clId="{3C05D16F-B2F9-4026-9A1E-DCB0B627E319}" dt="2024-07-17T12:39:39.003" v="538"/>
          <ac:grpSpMkLst>
            <pc:docMk/>
            <pc:sldMk cId="4062495031" sldId="278"/>
            <ac:grpSpMk id="11" creationId="{3879BC31-AA49-35BA-8D7B-C61DA5D5F6B5}"/>
          </ac:grpSpMkLst>
        </pc:grpChg>
        <pc:grpChg chg="add mod">
          <ac:chgData name="Ito, Shigeaki" userId="9738649d-cd64-434d-883a-bc64ce9afd08" providerId="ADAL" clId="{3C05D16F-B2F9-4026-9A1E-DCB0B627E319}" dt="2024-07-17T12:39:39.003" v="538"/>
          <ac:grpSpMkLst>
            <pc:docMk/>
            <pc:sldMk cId="4062495031" sldId="278"/>
            <ac:grpSpMk id="18" creationId="{80B739FD-7ACC-E93C-C7B7-8B330DE6983B}"/>
          </ac:grpSpMkLst>
        </pc:grpChg>
        <pc:picChg chg="add mod ord modCrop">
          <ac:chgData name="Ito, Shigeaki" userId="9738649d-cd64-434d-883a-bc64ce9afd08" providerId="ADAL" clId="{3C05D16F-B2F9-4026-9A1E-DCB0B627E319}" dt="2024-07-17T12:40:45.693" v="554" actId="1038"/>
          <ac:picMkLst>
            <pc:docMk/>
            <pc:sldMk cId="4062495031" sldId="278"/>
            <ac:picMk id="5" creationId="{EA86132D-E035-0155-8842-C22DF9DED4FA}"/>
          </ac:picMkLst>
        </pc:picChg>
        <pc:cxnChg chg="add mod">
          <ac:chgData name="Ito, Shigeaki" userId="9738649d-cd64-434d-883a-bc64ce9afd08" providerId="ADAL" clId="{3C05D16F-B2F9-4026-9A1E-DCB0B627E319}" dt="2024-07-17T12:39:39.003" v="538"/>
          <ac:cxnSpMkLst>
            <pc:docMk/>
            <pc:sldMk cId="4062495031" sldId="278"/>
            <ac:cxnSpMk id="9" creationId="{248E9ADF-B5BE-7E32-D7E5-57665EC77638}"/>
          </ac:cxnSpMkLst>
        </pc:cxnChg>
      </pc:sldChg>
      <pc:sldChg chg="addSp delSp modSp new del mod">
        <pc:chgData name="Ito, Shigeaki" userId="9738649d-cd64-434d-883a-bc64ce9afd08" providerId="ADAL" clId="{3C05D16F-B2F9-4026-9A1E-DCB0B627E319}" dt="2024-07-18T00:28:10.409" v="894" actId="47"/>
        <pc:sldMkLst>
          <pc:docMk/>
          <pc:sldMk cId="4030564328" sldId="279"/>
        </pc:sldMkLst>
        <pc:spChg chg="del">
          <ac:chgData name="Ito, Shigeaki" userId="9738649d-cd64-434d-883a-bc64ce9afd08" providerId="ADAL" clId="{3C05D16F-B2F9-4026-9A1E-DCB0B627E319}" dt="2024-07-17T12:41:48.005" v="557" actId="478"/>
          <ac:spMkLst>
            <pc:docMk/>
            <pc:sldMk cId="4030564328" sldId="279"/>
            <ac:spMk id="2" creationId="{A94DDB7D-A42A-A01C-DB98-A455C1C33C4C}"/>
          </ac:spMkLst>
        </pc:spChg>
        <pc:spChg chg="del">
          <ac:chgData name="Ito, Shigeaki" userId="9738649d-cd64-434d-883a-bc64ce9afd08" providerId="ADAL" clId="{3C05D16F-B2F9-4026-9A1E-DCB0B627E319}" dt="2024-07-17T12:41:48.005" v="557" actId="478"/>
          <ac:spMkLst>
            <pc:docMk/>
            <pc:sldMk cId="4030564328" sldId="279"/>
            <ac:spMk id="3" creationId="{9B8596B1-B6CA-446E-07B3-E01DB0FF695A}"/>
          </ac:spMkLst>
        </pc:spChg>
        <pc:spChg chg="add mod ord">
          <ac:chgData name="Ito, Shigeaki" userId="9738649d-cd64-434d-883a-bc64ce9afd08" providerId="ADAL" clId="{3C05D16F-B2F9-4026-9A1E-DCB0B627E319}" dt="2024-07-17T12:44:49.925" v="628" actId="1036"/>
          <ac:spMkLst>
            <pc:docMk/>
            <pc:sldMk cId="4030564328" sldId="279"/>
            <ac:spMk id="6" creationId="{226063DC-8B0A-7B82-010E-66203985211E}"/>
          </ac:spMkLst>
        </pc:spChg>
        <pc:spChg chg="add mod">
          <ac:chgData name="Ito, Shigeaki" userId="9738649d-cd64-434d-883a-bc64ce9afd08" providerId="ADAL" clId="{3C05D16F-B2F9-4026-9A1E-DCB0B627E319}" dt="2024-07-17T12:44:43.844" v="621" actId="1037"/>
          <ac:spMkLst>
            <pc:docMk/>
            <pc:sldMk cId="4030564328" sldId="279"/>
            <ac:spMk id="7" creationId="{E90148D5-42F3-31C8-D9CF-5A5855167CBB}"/>
          </ac:spMkLst>
        </pc:spChg>
        <pc:spChg chg="add mod">
          <ac:chgData name="Ito, Shigeaki" userId="9738649d-cd64-434d-883a-bc64ce9afd08" providerId="ADAL" clId="{3C05D16F-B2F9-4026-9A1E-DCB0B627E319}" dt="2024-07-17T12:44:43.844" v="621" actId="1037"/>
          <ac:spMkLst>
            <pc:docMk/>
            <pc:sldMk cId="4030564328" sldId="279"/>
            <ac:spMk id="8" creationId="{841084B5-6BDF-F7EF-E01C-9765F145F046}"/>
          </ac:spMkLst>
        </pc:spChg>
        <pc:spChg chg="mod">
          <ac:chgData name="Ito, Shigeaki" userId="9738649d-cd64-434d-883a-bc64ce9afd08" providerId="ADAL" clId="{3C05D16F-B2F9-4026-9A1E-DCB0B627E319}" dt="2024-07-17T12:43:49.300" v="582"/>
          <ac:spMkLst>
            <pc:docMk/>
            <pc:sldMk cId="4030564328" sldId="279"/>
            <ac:spMk id="12" creationId="{9B3336DC-1856-02D7-D8F3-06C9DC405B8E}"/>
          </ac:spMkLst>
        </pc:spChg>
        <pc:spChg chg="mod">
          <ac:chgData name="Ito, Shigeaki" userId="9738649d-cd64-434d-883a-bc64ce9afd08" providerId="ADAL" clId="{3C05D16F-B2F9-4026-9A1E-DCB0B627E319}" dt="2024-07-17T12:43:49.300" v="582"/>
          <ac:spMkLst>
            <pc:docMk/>
            <pc:sldMk cId="4030564328" sldId="279"/>
            <ac:spMk id="13" creationId="{13EBFE66-5800-3EAE-056B-C101B769A32C}"/>
          </ac:spMkLst>
        </pc:spChg>
        <pc:spChg chg="mod">
          <ac:chgData name="Ito, Shigeaki" userId="9738649d-cd64-434d-883a-bc64ce9afd08" providerId="ADAL" clId="{3C05D16F-B2F9-4026-9A1E-DCB0B627E319}" dt="2024-07-17T12:43:49.300" v="582"/>
          <ac:spMkLst>
            <pc:docMk/>
            <pc:sldMk cId="4030564328" sldId="279"/>
            <ac:spMk id="14" creationId="{86B3AA8E-3A17-A78A-6D66-5B73A676D77E}"/>
          </ac:spMkLst>
        </pc:spChg>
        <pc:spChg chg="mod">
          <ac:chgData name="Ito, Shigeaki" userId="9738649d-cd64-434d-883a-bc64ce9afd08" providerId="ADAL" clId="{3C05D16F-B2F9-4026-9A1E-DCB0B627E319}" dt="2024-07-17T12:43:49.300" v="582"/>
          <ac:spMkLst>
            <pc:docMk/>
            <pc:sldMk cId="4030564328" sldId="279"/>
            <ac:spMk id="15" creationId="{E9CC4C0F-69E4-8C0A-4388-CB46101426FB}"/>
          </ac:spMkLst>
        </pc:spChg>
        <pc:grpChg chg="add mod">
          <ac:chgData name="Ito, Shigeaki" userId="9738649d-cd64-434d-883a-bc64ce9afd08" providerId="ADAL" clId="{3C05D16F-B2F9-4026-9A1E-DCB0B627E319}" dt="2024-07-17T12:43:53.253" v="593" actId="1038"/>
          <ac:grpSpMkLst>
            <pc:docMk/>
            <pc:sldMk cId="4030564328" sldId="279"/>
            <ac:grpSpMk id="11" creationId="{5F516325-02A8-3517-02E0-EA3F72A66AA1}"/>
          </ac:grpSpMkLst>
        </pc:grpChg>
        <pc:picChg chg="add del mod modCrop">
          <ac:chgData name="Ito, Shigeaki" userId="9738649d-cd64-434d-883a-bc64ce9afd08" providerId="ADAL" clId="{3C05D16F-B2F9-4026-9A1E-DCB0B627E319}" dt="2024-07-17T12:42:44.127" v="566" actId="478"/>
          <ac:picMkLst>
            <pc:docMk/>
            <pc:sldMk cId="4030564328" sldId="279"/>
            <ac:picMk id="5" creationId="{E0C1AD6A-4B84-2048-CBC9-39D353D3C2F1}"/>
          </ac:picMkLst>
        </pc:picChg>
        <pc:picChg chg="add mod modCrop">
          <ac:chgData name="Ito, Shigeaki" userId="9738649d-cd64-434d-883a-bc64ce9afd08" providerId="ADAL" clId="{3C05D16F-B2F9-4026-9A1E-DCB0B627E319}" dt="2024-07-17T12:44:29.187" v="608" actId="1037"/>
          <ac:picMkLst>
            <pc:docMk/>
            <pc:sldMk cId="4030564328" sldId="279"/>
            <ac:picMk id="10" creationId="{CF2F2380-535F-0DF4-31CA-11F3058D1314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B2CF1-C210-4ACF-B53C-B50575D10038}" type="datetimeFigureOut">
              <a:rPr kumimoji="1" lang="ja-JP" altLang="en-US" smtClean="0"/>
              <a:t>2025/3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E2F9E-6411-4E35-93F1-681E100079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11520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B2CF1-C210-4ACF-B53C-B50575D10038}" type="datetimeFigureOut">
              <a:rPr kumimoji="1" lang="ja-JP" altLang="en-US" smtClean="0"/>
              <a:t>2025/3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E2F9E-6411-4E35-93F1-681E100079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37416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B2CF1-C210-4ACF-B53C-B50575D10038}" type="datetimeFigureOut">
              <a:rPr kumimoji="1" lang="ja-JP" altLang="en-US" smtClean="0"/>
              <a:t>2025/3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E2F9E-6411-4E35-93F1-681E100079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23355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B2CF1-C210-4ACF-B53C-B50575D10038}" type="datetimeFigureOut">
              <a:rPr kumimoji="1" lang="ja-JP" altLang="en-US" smtClean="0"/>
              <a:t>2025/3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E2F9E-6411-4E35-93F1-681E100079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85325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B2CF1-C210-4ACF-B53C-B50575D10038}" type="datetimeFigureOut">
              <a:rPr kumimoji="1" lang="ja-JP" altLang="en-US" smtClean="0"/>
              <a:t>2025/3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E2F9E-6411-4E35-93F1-681E100079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5070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B2CF1-C210-4ACF-B53C-B50575D10038}" type="datetimeFigureOut">
              <a:rPr kumimoji="1" lang="ja-JP" altLang="en-US" smtClean="0"/>
              <a:t>2025/3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E2F9E-6411-4E35-93F1-681E100079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71568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B2CF1-C210-4ACF-B53C-B50575D10038}" type="datetimeFigureOut">
              <a:rPr kumimoji="1" lang="ja-JP" altLang="en-US" smtClean="0"/>
              <a:t>2025/3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E2F9E-6411-4E35-93F1-681E100079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79432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B2CF1-C210-4ACF-B53C-B50575D10038}" type="datetimeFigureOut">
              <a:rPr kumimoji="1" lang="ja-JP" altLang="en-US" smtClean="0"/>
              <a:t>2025/3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E2F9E-6411-4E35-93F1-681E100079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049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B2CF1-C210-4ACF-B53C-B50575D10038}" type="datetimeFigureOut">
              <a:rPr kumimoji="1" lang="ja-JP" altLang="en-US" smtClean="0"/>
              <a:t>2025/3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E2F9E-6411-4E35-93F1-681E100079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78986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B2CF1-C210-4ACF-B53C-B50575D10038}" type="datetimeFigureOut">
              <a:rPr kumimoji="1" lang="ja-JP" altLang="en-US" smtClean="0"/>
              <a:t>2025/3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E2F9E-6411-4E35-93F1-681E100079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37716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4B2CF1-C210-4ACF-B53C-B50575D10038}" type="datetimeFigureOut">
              <a:rPr kumimoji="1" lang="ja-JP" altLang="en-US" smtClean="0"/>
              <a:t>2025/3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9E2F9E-6411-4E35-93F1-681E100079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51436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14B2CF1-C210-4ACF-B53C-B50575D10038}" type="datetimeFigureOut">
              <a:rPr kumimoji="1" lang="ja-JP" altLang="en-US" smtClean="0"/>
              <a:t>2025/3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49E2F9E-6411-4E35-93F1-681E100079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74872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EE75A2B5-1030-685C-B756-6D6CB6B8FB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85718"/>
            <a:ext cx="6858000" cy="6705764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E2B719C-043D-7FD5-77B1-7369FD9E3881}"/>
              </a:ext>
            </a:extLst>
          </p:cNvPr>
          <p:cNvSpPr txBox="1"/>
          <p:nvPr/>
        </p:nvSpPr>
        <p:spPr>
          <a:xfrm>
            <a:off x="363071" y="7718612"/>
            <a:ext cx="478715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 Resampled MIE1 data</a:t>
            </a:r>
          </a:p>
          <a:p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ox plots of the resampled MIE1 (Reactive Oxygen Species) data for each donor (vertical) and each WCS exposure repetition (horizontal). 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594807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FB5D34A4-3B19-AA43-8A76-3B6A023F60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92" y="1019174"/>
            <a:ext cx="6715486" cy="6148107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8AA6993-C957-0CFC-2C2A-35CA6EFF8DA6}"/>
              </a:ext>
            </a:extLst>
          </p:cNvPr>
          <p:cNvSpPr txBox="1"/>
          <p:nvPr/>
        </p:nvSpPr>
        <p:spPr>
          <a:xfrm>
            <a:off x="430306" y="7167281"/>
            <a:ext cx="478715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0 Resampled KE4 data</a:t>
            </a:r>
          </a:p>
          <a:p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nsity plots of KE4 results using the combined all-donor resampled data at each dose and exposure repetition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692888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72CC1FF3-17AF-E496-771E-8A122999C36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53063"/>
          <a:stretch/>
        </p:blipFill>
        <p:spPr>
          <a:xfrm>
            <a:off x="67234" y="196836"/>
            <a:ext cx="6795463" cy="6755293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E649B4C-3D98-56EE-6BE1-FD3CB5A06C1E}"/>
              </a:ext>
            </a:extLst>
          </p:cNvPr>
          <p:cNvSpPr txBox="1"/>
          <p:nvPr/>
        </p:nvSpPr>
        <p:spPr>
          <a:xfrm>
            <a:off x="363071" y="7718612"/>
            <a:ext cx="478715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1 Resampled AO data</a:t>
            </a:r>
          </a:p>
          <a:p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ox plots of the resampled </a:t>
            </a:r>
            <a:r>
              <a:rPr lang="en-US" altLang="ja-JP" sz="14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O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Mucus hypersecretion) data for each donor (vertical) and each WCS exposure repetition (horizontal). 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638279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4F52C503-7BC0-0347-3FE3-45EC4E72F7E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9798"/>
          <a:stretch/>
        </p:blipFill>
        <p:spPr>
          <a:xfrm>
            <a:off x="275676" y="717609"/>
            <a:ext cx="5482881" cy="509605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6DFE213-595E-E6CB-5490-6AD89E41DE09}"/>
              </a:ext>
            </a:extLst>
          </p:cNvPr>
          <p:cNvSpPr txBox="1"/>
          <p:nvPr/>
        </p:nvSpPr>
        <p:spPr>
          <a:xfrm>
            <a:off x="430306" y="7167281"/>
            <a:ext cx="478715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2 Resampled AO data</a:t>
            </a:r>
          </a:p>
          <a:p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nsity plots of </a:t>
            </a:r>
            <a:r>
              <a:rPr lang="en-US" altLang="ja-JP" sz="14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O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results using the combined all-donor resampled data at each dose and exposure repetition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848006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20F38734-A5F5-6D48-B210-A1C624191E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3412" y="1093694"/>
            <a:ext cx="6261847" cy="6261847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F06E692-A412-DBD5-9E83-991481D2E2BB}"/>
              </a:ext>
            </a:extLst>
          </p:cNvPr>
          <p:cNvSpPr txBox="1"/>
          <p:nvPr/>
        </p:nvSpPr>
        <p:spPr>
          <a:xfrm>
            <a:off x="430306" y="7624481"/>
            <a:ext cx="478715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3 Correlation between in vitro data (i.e., response amplitude) and predicted activation probability.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orrelation coefficient (R</a:t>
            </a:r>
            <a:r>
              <a:rPr kumimoji="1"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dicates the goodness of fit between the model prediction and actual observation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72170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989B3D62-2BA9-A92B-FC24-31A82C4F70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40809"/>
            <a:ext cx="6858000" cy="6276264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CBEFE4F-FBF1-FD8D-4746-01774E9AA765}"/>
              </a:ext>
            </a:extLst>
          </p:cNvPr>
          <p:cNvSpPr txBox="1"/>
          <p:nvPr/>
        </p:nvSpPr>
        <p:spPr>
          <a:xfrm>
            <a:off x="389965" y="7328647"/>
            <a:ext cx="478715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 Resampled MIE1 data</a:t>
            </a:r>
          </a:p>
          <a:p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nsity plots of MIE1 results using the combined all-donor resampled data at each dose and exposure repetition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56368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図 45">
            <a:extLst>
              <a:ext uri="{FF2B5EF4-FFF2-40B4-BE49-F238E27FC236}">
                <a16:creationId xmlns:a16="http://schemas.microsoft.com/office/drawing/2014/main" id="{5BB09E00-A550-D1B8-30CA-10877410F4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69177"/>
            <a:ext cx="6858000" cy="6705764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CDFC7BB-D190-EBF2-BDD8-02D6C54BE48A}"/>
              </a:ext>
            </a:extLst>
          </p:cNvPr>
          <p:cNvSpPr txBox="1"/>
          <p:nvPr/>
        </p:nvSpPr>
        <p:spPr>
          <a:xfrm>
            <a:off x="363071" y="7382436"/>
            <a:ext cx="478715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 Resampled MIE2 data</a:t>
            </a:r>
          </a:p>
          <a:p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ox plots of the resampled MIE2 (Glutathion</a:t>
            </a:r>
            <a:r>
              <a:rPr lang="en-US" altLang="ja-JP" sz="14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 depletion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 data for each donor (vertical) and each WCS exposure repetition (horizontal). 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74046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CA19E729-DE7C-AE90-D1EA-6C0CF4131C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15074"/>
            <a:ext cx="6858000" cy="6273946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9A3429B-F091-29D7-C530-C831362E4E69}"/>
              </a:ext>
            </a:extLst>
          </p:cNvPr>
          <p:cNvSpPr txBox="1"/>
          <p:nvPr/>
        </p:nvSpPr>
        <p:spPr>
          <a:xfrm>
            <a:off x="389965" y="7189020"/>
            <a:ext cx="478715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 Resampled MIE2 data</a:t>
            </a:r>
          </a:p>
          <a:p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nsity plots of MIE1 results using the combined all-donor resampled data at each dose and exposure repetition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55253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6636267D-412B-8324-DCF8-C832684F35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24354"/>
            <a:ext cx="6858000" cy="6705764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AC7ADA7-354B-7D51-C803-DD9F789D7F54}"/>
              </a:ext>
            </a:extLst>
          </p:cNvPr>
          <p:cNvSpPr txBox="1"/>
          <p:nvPr/>
        </p:nvSpPr>
        <p:spPr>
          <a:xfrm>
            <a:off x="363071" y="7230118"/>
            <a:ext cx="478715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 Resampled KE1 data</a:t>
            </a:r>
          </a:p>
          <a:p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ox plots of the resampled KE1 (EGFR activation) data for each donor (vertical) and each WCS exposure repetition (horizontal). 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34789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CF506E21-3FF0-EAB4-5442-C0CE4FADD9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54256"/>
            <a:ext cx="6858000" cy="6276264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F2E6CBC-E7AB-F669-4164-D46BCFB982B5}"/>
              </a:ext>
            </a:extLst>
          </p:cNvPr>
          <p:cNvSpPr txBox="1"/>
          <p:nvPr/>
        </p:nvSpPr>
        <p:spPr>
          <a:xfrm>
            <a:off x="389965" y="7230520"/>
            <a:ext cx="478715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 Resampled KE11 data</a:t>
            </a:r>
          </a:p>
          <a:p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nsity plots of KE1 results using the combined all-donor resampled data at each dose and exposure repetition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759180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図 44">
            <a:extLst>
              <a:ext uri="{FF2B5EF4-FFF2-40B4-BE49-F238E27FC236}">
                <a16:creationId xmlns:a16="http://schemas.microsoft.com/office/drawing/2014/main" id="{772BF419-68BF-CF2A-8207-CD18B38198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28568"/>
            <a:ext cx="6858000" cy="6705764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00EDC83-8240-6272-7B86-A2D60EB9FD3C}"/>
              </a:ext>
            </a:extLst>
          </p:cNvPr>
          <p:cNvSpPr txBox="1"/>
          <p:nvPr/>
        </p:nvSpPr>
        <p:spPr>
          <a:xfrm>
            <a:off x="363071" y="7334332"/>
            <a:ext cx="478715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7 Resampled KE3 data</a:t>
            </a:r>
          </a:p>
          <a:p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ox plots of the resampled KE3 (intracellular mucin production) data for each donor (vertical) and each WCS exposure repetition (horizontal). 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566608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779DEDEA-7BEB-9356-629E-5B99BCC045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64630"/>
            <a:ext cx="6858000" cy="6273946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3D549ED-0277-9EBC-3BAA-D54D6868C31F}"/>
              </a:ext>
            </a:extLst>
          </p:cNvPr>
          <p:cNvSpPr txBox="1"/>
          <p:nvPr/>
        </p:nvSpPr>
        <p:spPr>
          <a:xfrm>
            <a:off x="389965" y="7238576"/>
            <a:ext cx="478715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8 Resampled KE3 data</a:t>
            </a:r>
          </a:p>
          <a:p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nsity plots of KE3 results using the combined all-donor resampled data at each dose and exposure repetition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688504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463188BD-8918-8CD9-1454-4537390385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97964"/>
            <a:ext cx="6858000" cy="6708166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8C45FDA-5FE9-5E5C-3A0F-921FE9EC3A2B}"/>
              </a:ext>
            </a:extLst>
          </p:cNvPr>
          <p:cNvSpPr txBox="1"/>
          <p:nvPr/>
        </p:nvSpPr>
        <p:spPr>
          <a:xfrm>
            <a:off x="363071" y="7406130"/>
            <a:ext cx="478715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9 Resampled KE4 data</a:t>
            </a:r>
          </a:p>
          <a:p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ox plots of the resampled KE4 (Goblet cell meta/hyperplasia) data for each donor (vertical) and each WCS exposure repetition (horizontal). 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58750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?mso-contentType ?>
<spe:Receivers xmlns:spe="http://schemas.microsoft.com/sharepoint/events">
  <Receiver>
    <Name>Document ID Generator</Name>
    <Synchronization>Synchronous</Synchronization>
    <Type>10001</Type>
    <SequenceNumber>1000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2</Type>
    <SequenceNumber>1001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4</Type>
    <SequenceNumber>1002</SequenceNumber>
    <Url/>
    <Assembly>Microsoft.Office.DocumentManagement, Version=16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6</Type>
    <SequenceNumber>1003</SequenceNumber>
    <Url/>
    <Assembly>Microsoft.Office.DocumentManagement, Version=16.0.0.0, Culture=neutral, PublicKeyToken=71e9bce111e9429c</Assembly>
    <Class>Microsoft.Office.DocumentManagement.Internal.DocIdHandler</Class>
    <Data/>
    <Filter/>
  </Receiver>
</spe:Receiver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398BA57FD6505B47A44500DC1496B414" ma:contentTypeVersion="30" ma:contentTypeDescription="新しいドキュメントを作成します。" ma:contentTypeScope="" ma:versionID="c3cee1625e33d5b2619babc0506498cf">
  <xsd:schema xmlns:xsd="http://www.w3.org/2001/XMLSchema" xmlns:xs="http://www.w3.org/2001/XMLSchema" xmlns:p="http://schemas.microsoft.com/office/2006/metadata/properties" xmlns:ns2="c6d5703c-c057-4ed0-b4dd-802d19e4db58" xmlns:ns3="7dc4a216-e2a0-4ad6-a279-b8d2b2a31381" targetNamespace="http://schemas.microsoft.com/office/2006/metadata/properties" ma:root="true" ma:fieldsID="a9414c4ec7a6b9ebc55fdf144c75189d" ns2:_="" ns3:_="">
    <xsd:import namespace="c6d5703c-c057-4ed0-b4dd-802d19e4db58"/>
    <xsd:import namespace="7dc4a216-e2a0-4ad6-a279-b8d2b2a31381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OCR" minOccurs="0"/>
                <xsd:element ref="ns2:MediaLengthInSeconds" minOccurs="0"/>
                <xsd:element ref="ns2:MediaServiceLocation" minOccurs="0"/>
                <xsd:element ref="ns2:_Flow_SignoffStatus" minOccurs="0"/>
                <xsd:element ref="ns2:_x30ea__x30f3__x30af__x5148_" minOccurs="0"/>
                <xsd:element ref="ns2:lcf76f155ced4ddcb4097134ff3c332f" minOccurs="0"/>
                <xsd:element ref="ns3:TaxCatchAll" minOccurs="0"/>
                <xsd:element ref="ns2:_x753b__x50cf_" minOccurs="0"/>
                <xsd:element ref="ns2:MediaServiceObjectDetectorVersions" minOccurs="0"/>
                <xsd:element ref="ns2:Thumbnail" minOccurs="0"/>
                <xsd:element ref="ns2:MediaServiceSearchProperties" minOccurs="0"/>
                <xsd:element ref="ns3:_dlc_DocId" minOccurs="0"/>
                <xsd:element ref="ns3:_dlc_DocIdUrl" minOccurs="0"/>
                <xsd:element ref="ns3:_dlc_DocIdPersistId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6d5703c-c057-4ed0-b4dd-802d19e4db5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4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5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8" nillable="true" ma:displayName="Tags" ma:internalName="MediaServiceAutoTags" ma:readOnly="true">
      <xsd:simpleType>
        <xsd:restriction base="dms:Text"/>
      </xsd:simpleType>
    </xsd:element>
    <xsd:element name="MediaServiceGenerationTime" ma:index="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0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1" nillable="true" ma:displayName="MediaServiceDateTaken" ma:hidden="true" ma:internalName="MediaServiceDateTaken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13" nillable="true" ma:displayName="MediaLengthInSeconds" ma:description="" ma:internalName="MediaLengthInSeconds" ma:readOnly="true">
      <xsd:simpleType>
        <xsd:restriction base="dms:Unknown"/>
      </xsd:simpleType>
    </xsd:element>
    <xsd:element name="MediaServiceLocation" ma:index="14" nillable="true" ma:displayName="Location" ma:internalName="MediaServiceLocation" ma:readOnly="true">
      <xsd:simpleType>
        <xsd:restriction base="dms:Text"/>
      </xsd:simpleType>
    </xsd:element>
    <xsd:element name="_Flow_SignoffStatus" ma:index="15" nillable="true" ma:displayName="承認の状態" ma:internalName="_x627f__x8a8d__x306e__x72b6__x614b_" ma:readOnly="false">
      <xsd:simpleType>
        <xsd:restriction base="dms:Text"/>
      </xsd:simpleType>
    </xsd:element>
    <xsd:element name="_x30ea__x30f3__x30af__x5148_" ma:index="16" nillable="true" ma:displayName="リンク先" ma:format="Hyperlink" ma:internalName="_x30ea__x30f3__x30af__x5148_" ma:readOnly="false">
      <xsd:complexType>
        <xsd:complexContent>
          <xsd:extension base="dms:URL">
            <xsd:sequence>
              <xsd:element name="Url" type="dms:ValidUrl" minOccurs="0" nillable="true"/>
              <xsd:element name="Description" type="xsd:string" nillable="true"/>
            </xsd:sequence>
          </xsd:extension>
        </xsd:complexContent>
      </xsd:complexType>
    </xsd:element>
    <xsd:element name="lcf76f155ced4ddcb4097134ff3c332f" ma:index="22" nillable="true" ma:taxonomy="true" ma:internalName="lcf76f155ced4ddcb4097134ff3c332f" ma:taxonomyFieldName="MediaServiceImageTags" ma:displayName="画像タグ" ma:readOnly="false" ma:fieldId="{5cf76f15-5ced-4ddc-b409-7134ff3c332f}" ma:taxonomyMulti="true" ma:sspId="c3dfe741-475c-44cf-bcd4-46bfd3fd069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_x753b__x50cf_" ma:index="24" nillable="true" ma:displayName="画像" ma:format="Thumbnail" ma:internalName="_x753b__x50cf_">
      <xsd:simpleType>
        <xsd:restriction base="dms:Unknown"/>
      </xsd:simpleType>
    </xsd:element>
    <xsd:element name="MediaServiceObjectDetectorVersions" ma:index="25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Thumbnail" ma:index="26" nillable="true" ma:displayName="Thumbnail" ma:format="Dropdown" ma:internalName="Thumbnail">
      <xsd:simpleType>
        <xsd:restriction base="dms:Text">
          <xsd:maxLength value="255"/>
        </xsd:restriction>
      </xsd:simpleType>
    </xsd:element>
    <xsd:element name="MediaServiceSearchProperties" ma:index="27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dc4a216-e2a0-4ad6-a279-b8d2b2a31381" elementFormDefault="qualified">
    <xsd:import namespace="http://schemas.microsoft.com/office/2006/documentManagement/types"/>
    <xsd:import namespace="http://schemas.microsoft.com/office/infopath/2007/PartnerControls"/>
    <xsd:element name="TaxCatchAll" ma:index="23" nillable="true" ma:displayName="Taxonomy Catch All Column" ma:hidden="true" ma:list="{3c8caa68-1861-4169-bfa1-4e47408c27ba}" ma:internalName="TaxCatchAll" ma:showField="CatchAllData" ma:web="7dc4a216-e2a0-4ad6-a279-b8d2b2a31381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_dlc_DocId" ma:index="28" nillable="true" ma:displayName="ドキュメント ID 値" ma:description="このアイテムに割り当てられているドキュメント ID の値です。" ma:indexed="true" ma:internalName="_dlc_DocId" ma:readOnly="true">
      <xsd:simpleType>
        <xsd:restriction base="dms:Text"/>
      </xsd:simpleType>
    </xsd:element>
    <xsd:element name="_dlc_DocIdUrl" ma:index="29" nillable="true" ma:displayName="ドキュメントID:" ma:description="このドキュメントへの常時接続リンクです。" ma:hidden="true" ma:internalName="_dlc_DocIdUrl" ma:readOnly="true">
      <xsd:complexType>
        <xsd:complexContent>
          <xsd:extension base="dms:URL">
            <xsd:sequence>
              <xsd:element name="Url" type="dms:ValidUrl" minOccurs="0" nillable="true"/>
              <xsd:element name="Description" type="xsd:string" nillable="true"/>
            </xsd:sequence>
          </xsd:extension>
        </xsd:complexContent>
      </xsd:complexType>
    </xsd:element>
    <xsd:element name="_dlc_DocIdPersistId" ma:index="30" nillable="true" ma:displayName="ID を保持" ma:description="追加時に ID を保持します。" ma:hidden="true" ma:internalName="_dlc_DocIdPersistId" ma:readOnly="true">
      <xsd:simpleType>
        <xsd:restriction base="dms:Boolean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17" ma:displayName="コンテンツ タイプ"/>
        <xsd:element ref="dc:title" minOccurs="0" maxOccurs="1" ma:index="3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808C3741-9EA5-4D43-9DD7-F62642B3E3FA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448A256A-D416-47E6-A0A5-D15AEF57A070}">
  <ds:schemaRefs>
    <ds:schemaRef ds:uri="http://schemas.microsoft.com/sharepoint/events"/>
  </ds:schemaRefs>
</ds:datastoreItem>
</file>

<file path=customXml/itemProps3.xml><?xml version="1.0" encoding="utf-8"?>
<ds:datastoreItem xmlns:ds="http://schemas.openxmlformats.org/officeDocument/2006/customXml" ds:itemID="{494064E9-1048-49CA-9C2D-CD60188A891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6d5703c-c057-4ed0-b4dd-802d19e4db58"/>
    <ds:schemaRef ds:uri="7dc4a216-e2a0-4ad6-a279-b8d2b2a3138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Metadata/LabelInfo.xml><?xml version="1.0" encoding="utf-8"?>
<clbl:labelList xmlns:clbl="http://schemas.microsoft.com/office/2020/mipLabelMetadata">
  <clbl:label id="{b020b37f-db72-473e-ae54-fb16df408069}" enabled="1" method="Standard" siteId="{705d07a3-2eea-4f3b-ab59-65ca29abeb26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14</TotalTime>
  <Words>375</Words>
  <Application>Microsoft Office PowerPoint</Application>
  <PresentationFormat>A4 210 x 297 mm</PresentationFormat>
  <Paragraphs>26</Paragraphs>
  <Slides>1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3</vt:i4>
      </vt:variant>
    </vt:vector>
  </HeadingPairs>
  <TitlesOfParts>
    <vt:vector size="18" baseType="lpstr">
      <vt:lpstr>Aptos</vt:lpstr>
      <vt:lpstr>Aptos Display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to, Shigeaki</dc:creator>
  <cp:lastModifiedBy>Ito, Shigeaki</cp:lastModifiedBy>
  <cp:revision>2</cp:revision>
  <dcterms:created xsi:type="dcterms:W3CDTF">2024-07-01T12:22:07Z</dcterms:created>
  <dcterms:modified xsi:type="dcterms:W3CDTF">2025-03-13T04:37:56Z</dcterms:modified>
</cp:coreProperties>
</file>